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8" r:id="rId2"/>
    <p:sldId id="291" r:id="rId3"/>
    <p:sldId id="298" r:id="rId4"/>
    <p:sldId id="292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FA1546C-AAE4-4B89-86A7-C130A0B04C58}" v="358" dt="2022-06-22T20:10:48.95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665" autoAdjust="0"/>
    <p:restoredTop sz="93758" autoAdjust="0"/>
  </p:normalViewPr>
  <p:slideViewPr>
    <p:cSldViewPr snapToGrid="0">
      <p:cViewPr varScale="1">
        <p:scale>
          <a:sx n="67" d="100"/>
          <a:sy n="67" d="100"/>
        </p:scale>
        <p:origin x="339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ang, Shengming - ARS" userId="37bd5b25-7571-49cb-bfc8-588a18706c35" providerId="ADAL" clId="{88AF4670-4310-4D7F-B3CE-836077527F5B}"/>
    <pc:docChg chg="delSld">
      <pc:chgData name="Yang, Shengming - ARS" userId="37bd5b25-7571-49cb-bfc8-588a18706c35" providerId="ADAL" clId="{88AF4670-4310-4D7F-B3CE-836077527F5B}" dt="2022-06-23T00:29:52.703" v="0" actId="47"/>
      <pc:docMkLst>
        <pc:docMk/>
      </pc:docMkLst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1525299809" sldId="275"/>
        </pc:sldMkLst>
      </pc:sldChg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2200906561" sldId="290"/>
        </pc:sldMkLst>
      </pc:sldChg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2589227480" sldId="293"/>
        </pc:sldMkLst>
      </pc:sldChg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3317137651" sldId="294"/>
        </pc:sldMkLst>
      </pc:sldChg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2983717248" sldId="295"/>
        </pc:sldMkLst>
      </pc:sldChg>
      <pc:sldChg chg="del">
        <pc:chgData name="Yang, Shengming - ARS" userId="37bd5b25-7571-49cb-bfc8-588a18706c35" providerId="ADAL" clId="{88AF4670-4310-4D7F-B3CE-836077527F5B}" dt="2022-06-23T00:29:52.703" v="0" actId="47"/>
        <pc:sldMkLst>
          <pc:docMk/>
          <pc:sldMk cId="2009276644" sldId="296"/>
        </pc:sldMkLst>
      </pc:sldChg>
    </pc:docChg>
  </pc:docChgLst>
  <pc:docChgLst>
    <pc:chgData name="Yang, Shengming - ARS" userId="37bd5b25-7571-49cb-bfc8-588a18706c35" providerId="ADAL" clId="{D37E7023-24B4-488B-82AC-5E5A99F64B29}"/>
    <pc:docChg chg="undo custSel delSld modSld">
      <pc:chgData name="Yang, Shengming - ARS" userId="37bd5b25-7571-49cb-bfc8-588a18706c35" providerId="ADAL" clId="{D37E7023-24B4-488B-82AC-5E5A99F64B29}" dt="2022-01-27T19:58:26.674" v="612" actId="20577"/>
      <pc:docMkLst>
        <pc:docMk/>
      </pc:docMkLst>
      <pc:sldChg chg="addSp delSp modSp mod modNotesTx">
        <pc:chgData name="Yang, Shengming - ARS" userId="37bd5b25-7571-49cb-bfc8-588a18706c35" providerId="ADAL" clId="{D37E7023-24B4-488B-82AC-5E5A99F64B29}" dt="2022-01-27T19:49:24.237" v="452" actId="1076"/>
        <pc:sldMkLst>
          <pc:docMk/>
          <pc:sldMk cId="1525299809" sldId="275"/>
        </pc:sldMkLst>
        <pc:spChg chg="add mod">
          <ac:chgData name="Yang, Shengming - ARS" userId="37bd5b25-7571-49cb-bfc8-588a18706c35" providerId="ADAL" clId="{D37E7023-24B4-488B-82AC-5E5A99F64B29}" dt="2022-01-27T16:37:54.496" v="428" actId="164"/>
          <ac:spMkLst>
            <pc:docMk/>
            <pc:sldMk cId="1525299809" sldId="275"/>
            <ac:spMk id="3" creationId="{E888CEB0-32B8-4D3E-AF97-26E24DBED6A2}"/>
          </ac:spMkLst>
        </pc:spChg>
        <pc:spChg chg="add del">
          <ac:chgData name="Yang, Shengming - ARS" userId="37bd5b25-7571-49cb-bfc8-588a18706c35" providerId="ADAL" clId="{D37E7023-24B4-488B-82AC-5E5A99F64B29}" dt="2022-01-27T16:35:46.953" v="390" actId="478"/>
          <ac:spMkLst>
            <pc:docMk/>
            <pc:sldMk cId="1525299809" sldId="275"/>
            <ac:spMk id="4" creationId="{73808741-A5B7-4321-AEF7-F5F6C39B6CDB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7" creationId="{59EC5E2F-A06C-44C2-9BC7-5083B8DB0158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12" creationId="{521E7359-7336-437C-8A90-B14583285988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13" creationId="{50A0EE90-3932-4530-A2F6-B29B53FA3754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17" creationId="{EF72585C-D2AF-45D3-97AC-199E08312281}"/>
          </ac:spMkLst>
        </pc:spChg>
        <pc:spChg chg="del mod">
          <ac:chgData name="Yang, Shengming - ARS" userId="37bd5b25-7571-49cb-bfc8-588a18706c35" providerId="ADAL" clId="{D37E7023-24B4-488B-82AC-5E5A99F64B29}" dt="2022-01-27T16:18:50.331" v="13" actId="478"/>
          <ac:spMkLst>
            <pc:docMk/>
            <pc:sldMk cId="1525299809" sldId="275"/>
            <ac:spMk id="22" creationId="{4D948ADA-E9AF-42DA-8B05-03DACB9C498C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23" creationId="{EE0E463B-8D9C-4CD8-A0EC-C0A58991BB7D}"/>
          </ac:spMkLst>
        </pc:spChg>
        <pc:spChg chg="del mod">
          <ac:chgData name="Yang, Shengming - ARS" userId="37bd5b25-7571-49cb-bfc8-588a18706c35" providerId="ADAL" clId="{D37E7023-24B4-488B-82AC-5E5A99F64B29}" dt="2022-01-27T16:18:50.331" v="13" actId="478"/>
          <ac:spMkLst>
            <pc:docMk/>
            <pc:sldMk cId="1525299809" sldId="275"/>
            <ac:spMk id="24" creationId="{4162F7BC-929B-45B6-BA7F-921891A36F89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26" creationId="{B9CCD95B-3889-4379-A2D1-2FC056F98C66}"/>
          </ac:spMkLst>
        </pc:spChg>
        <pc:spChg chg="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27" creationId="{A025DAFC-93D1-4F78-945F-66FA9798F458}"/>
          </ac:spMkLst>
        </pc:spChg>
        <pc:spChg chg="add 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29" creationId="{715CB5B5-537D-4983-A660-F90C40946944}"/>
          </ac:spMkLst>
        </pc:spChg>
        <pc:spChg chg="add 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30" creationId="{C224467D-B63C-431B-940C-424E4BB0DB94}"/>
          </ac:spMkLst>
        </pc:spChg>
        <pc:spChg chg="add 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31" creationId="{94E1D290-E962-4DC5-9BCF-50A122D814DD}"/>
          </ac:spMkLst>
        </pc:spChg>
        <pc:spChg chg="add mod">
          <ac:chgData name="Yang, Shengming - ARS" userId="37bd5b25-7571-49cb-bfc8-588a18706c35" providerId="ADAL" clId="{D37E7023-24B4-488B-82AC-5E5A99F64B29}" dt="2022-01-27T19:49:24.237" v="452" actId="1076"/>
          <ac:spMkLst>
            <pc:docMk/>
            <pc:sldMk cId="1525299809" sldId="275"/>
            <ac:spMk id="32" creationId="{1B62C987-43F5-4DE2-8AF8-592FEF0B282D}"/>
          </ac:spMkLst>
        </pc:spChg>
        <pc:grpChg chg="add mod">
          <ac:chgData name="Yang, Shengming - ARS" userId="37bd5b25-7571-49cb-bfc8-588a18706c35" providerId="ADAL" clId="{D37E7023-24B4-488B-82AC-5E5A99F64B29}" dt="2022-01-27T19:49:24.237" v="452" actId="1076"/>
          <ac:grpSpMkLst>
            <pc:docMk/>
            <pc:sldMk cId="1525299809" sldId="275"/>
            <ac:grpSpMk id="10" creationId="{9EB0F5CE-09DF-447B-B0F0-E641528ECE92}"/>
          </ac:grpSpMkLst>
        </pc:grp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5" creationId="{47886F41-8483-490F-AFEC-C9F34925FEB4}"/>
          </ac:picMkLst>
        </pc:pic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9" creationId="{8A5CA8A6-E525-4485-ADF9-36221A12B462}"/>
          </ac:picMkLst>
        </pc:pic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15" creationId="{59E8A476-E459-49E7-BC90-C0244CB29CE8}"/>
          </ac:picMkLst>
        </pc:pic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18" creationId="{DC957572-5F76-4953-A205-6FFE95C92F40}"/>
          </ac:picMkLst>
        </pc:pic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19" creationId="{596237EC-86BA-4274-95FA-01770DA46B69}"/>
          </ac:picMkLst>
        </pc:picChg>
        <pc:picChg chg="del mod">
          <ac:chgData name="Yang, Shengming - ARS" userId="37bd5b25-7571-49cb-bfc8-588a18706c35" providerId="ADAL" clId="{D37E7023-24B4-488B-82AC-5E5A99F64B29}" dt="2022-01-27T16:18:46.066" v="12" actId="478"/>
          <ac:picMkLst>
            <pc:docMk/>
            <pc:sldMk cId="1525299809" sldId="275"/>
            <ac:picMk id="20" creationId="{82B004C6-1B02-4AAE-9F53-D06DA1D4183C}"/>
          </ac:picMkLst>
        </pc:picChg>
        <pc:picChg chg="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21" creationId="{678FCA89-43B8-45BE-8851-22EE7A6E7A89}"/>
          </ac:picMkLst>
        </pc:picChg>
        <pc:picChg chg="add mod">
          <ac:chgData name="Yang, Shengming - ARS" userId="37bd5b25-7571-49cb-bfc8-588a18706c35" providerId="ADAL" clId="{D37E7023-24B4-488B-82AC-5E5A99F64B29}" dt="2022-01-27T19:49:24.237" v="452" actId="1076"/>
          <ac:picMkLst>
            <pc:docMk/>
            <pc:sldMk cId="1525299809" sldId="275"/>
            <ac:picMk id="28" creationId="{5B78FAF8-81AD-4BE8-8D4D-D67EB64B4388}"/>
          </ac:picMkLst>
        </pc:picChg>
        <pc:cxnChg chg="add mod">
          <ac:chgData name="Yang, Shengming - ARS" userId="37bd5b25-7571-49cb-bfc8-588a18706c35" providerId="ADAL" clId="{D37E7023-24B4-488B-82AC-5E5A99F64B29}" dt="2022-01-27T16:37:54.496" v="428" actId="164"/>
          <ac:cxnSpMkLst>
            <pc:docMk/>
            <pc:sldMk cId="1525299809" sldId="275"/>
            <ac:cxnSpMk id="8" creationId="{D0FAFBD5-ACC8-4431-8A0C-DF282A6B392A}"/>
          </ac:cxnSpMkLst>
        </pc:cxnChg>
      </pc:sldChg>
      <pc:sldChg chg="del">
        <pc:chgData name="Yang, Shengming - ARS" userId="37bd5b25-7571-49cb-bfc8-588a18706c35" providerId="ADAL" clId="{D37E7023-24B4-488B-82AC-5E5A99F64B29}" dt="2022-01-27T16:41:11.055" v="449" actId="47"/>
        <pc:sldMkLst>
          <pc:docMk/>
          <pc:sldMk cId="1104748975" sldId="281"/>
        </pc:sldMkLst>
      </pc:sldChg>
      <pc:sldChg chg="addSp modSp mod modNotesTx">
        <pc:chgData name="Yang, Shengming - ARS" userId="37bd5b25-7571-49cb-bfc8-588a18706c35" providerId="ADAL" clId="{D37E7023-24B4-488B-82AC-5E5A99F64B29}" dt="2022-01-27T19:58:26.674" v="612" actId="20577"/>
        <pc:sldMkLst>
          <pc:docMk/>
          <pc:sldMk cId="2625937353" sldId="284"/>
        </pc:sldMkLst>
        <pc:spChg chg="add mod">
          <ac:chgData name="Yang, Shengming - ARS" userId="37bd5b25-7571-49cb-bfc8-588a18706c35" providerId="ADAL" clId="{D37E7023-24B4-488B-82AC-5E5A99F64B29}" dt="2022-01-27T19:56:07.538" v="568" actId="1036"/>
          <ac:spMkLst>
            <pc:docMk/>
            <pc:sldMk cId="2625937353" sldId="284"/>
            <ac:spMk id="4" creationId="{215B0B4D-DB32-4008-B80D-26D338070DDC}"/>
          </ac:spMkLst>
        </pc:spChg>
        <pc:spChg chg="mod">
          <ac:chgData name="Yang, Shengming - ARS" userId="37bd5b25-7571-49cb-bfc8-588a18706c35" providerId="ADAL" clId="{D37E7023-24B4-488B-82AC-5E5A99F64B29}" dt="2022-01-27T19:50:06.590" v="453" actId="14100"/>
          <ac:spMkLst>
            <pc:docMk/>
            <pc:sldMk cId="2625937353" sldId="284"/>
            <ac:spMk id="29" creationId="{C0EAD2EE-9202-427B-889B-A230C6AD52EE}"/>
          </ac:spMkLst>
        </pc:spChg>
        <pc:spChg chg="mod">
          <ac:chgData name="Yang, Shengming - ARS" userId="37bd5b25-7571-49cb-bfc8-588a18706c35" providerId="ADAL" clId="{D37E7023-24B4-488B-82AC-5E5A99F64B29}" dt="2022-01-27T19:55:58.109" v="556" actId="1035"/>
          <ac:spMkLst>
            <pc:docMk/>
            <pc:sldMk cId="2625937353" sldId="284"/>
            <ac:spMk id="45" creationId="{561A173B-C821-49F3-875D-7AFC1E02CE2F}"/>
          </ac:spMkLst>
        </pc:spChg>
        <pc:spChg chg="mod">
          <ac:chgData name="Yang, Shengming - ARS" userId="37bd5b25-7571-49cb-bfc8-588a18706c35" providerId="ADAL" clId="{D37E7023-24B4-488B-82AC-5E5A99F64B29}" dt="2022-01-27T19:55:58.109" v="556" actId="1035"/>
          <ac:spMkLst>
            <pc:docMk/>
            <pc:sldMk cId="2625937353" sldId="284"/>
            <ac:spMk id="46" creationId="{1C334073-8210-401F-ABDE-84BF451B23A4}"/>
          </ac:spMkLst>
        </pc:spChg>
        <pc:spChg chg="mod">
          <ac:chgData name="Yang, Shengming - ARS" userId="37bd5b25-7571-49cb-bfc8-588a18706c35" providerId="ADAL" clId="{D37E7023-24B4-488B-82AC-5E5A99F64B29}" dt="2022-01-27T19:55:58.109" v="556" actId="1035"/>
          <ac:spMkLst>
            <pc:docMk/>
            <pc:sldMk cId="2625937353" sldId="284"/>
            <ac:spMk id="47" creationId="{D320BB33-AD7F-4672-849A-58E930A112F8}"/>
          </ac:spMkLst>
        </pc:spChg>
        <pc:spChg chg="mod">
          <ac:chgData name="Yang, Shengming - ARS" userId="37bd5b25-7571-49cb-bfc8-588a18706c35" providerId="ADAL" clId="{D37E7023-24B4-488B-82AC-5E5A99F64B29}" dt="2022-01-27T19:55:58.109" v="556" actId="1035"/>
          <ac:spMkLst>
            <pc:docMk/>
            <pc:sldMk cId="2625937353" sldId="284"/>
            <ac:spMk id="48" creationId="{FAD047C0-A68E-42D3-ABA2-034D858DAD9A}"/>
          </ac:spMkLst>
        </pc:spChg>
        <pc:spChg chg="add mod">
          <ac:chgData name="Yang, Shengming - ARS" userId="37bd5b25-7571-49cb-bfc8-588a18706c35" providerId="ADAL" clId="{D37E7023-24B4-488B-82AC-5E5A99F64B29}" dt="2022-01-27T19:57:28.850" v="596" actId="1076"/>
          <ac:spMkLst>
            <pc:docMk/>
            <pc:sldMk cId="2625937353" sldId="284"/>
            <ac:spMk id="51" creationId="{AC4DD17F-CEB8-44C0-AA25-BDE0B8D786EB}"/>
          </ac:spMkLst>
        </pc:spChg>
        <pc:spChg chg="add mod">
          <ac:chgData name="Yang, Shengming - ARS" userId="37bd5b25-7571-49cb-bfc8-588a18706c35" providerId="ADAL" clId="{D37E7023-24B4-488B-82AC-5E5A99F64B29}" dt="2022-01-27T19:57:49.072" v="603" actId="113"/>
          <ac:spMkLst>
            <pc:docMk/>
            <pc:sldMk cId="2625937353" sldId="284"/>
            <ac:spMk id="52" creationId="{963E53D2-EA4C-48D0-898F-B1CA99C7AFD8}"/>
          </ac:spMkLst>
        </pc:spChg>
        <pc:spChg chg="add mod">
          <ac:chgData name="Yang, Shengming - ARS" userId="37bd5b25-7571-49cb-bfc8-588a18706c35" providerId="ADAL" clId="{D37E7023-24B4-488B-82AC-5E5A99F64B29}" dt="2022-01-27T19:57:58.033" v="606" actId="20577"/>
          <ac:spMkLst>
            <pc:docMk/>
            <pc:sldMk cId="2625937353" sldId="284"/>
            <ac:spMk id="53" creationId="{6D0568C5-093C-4831-8518-1D6A40EF0B8B}"/>
          </ac:spMkLst>
        </pc:spChg>
        <pc:spChg chg="add mod">
          <ac:chgData name="Yang, Shengming - ARS" userId="37bd5b25-7571-49cb-bfc8-588a18706c35" providerId="ADAL" clId="{D37E7023-24B4-488B-82AC-5E5A99F64B29}" dt="2022-01-27T19:58:14.368" v="609" actId="20577"/>
          <ac:spMkLst>
            <pc:docMk/>
            <pc:sldMk cId="2625937353" sldId="284"/>
            <ac:spMk id="54" creationId="{4FD89DBB-46A0-4095-8335-45FC145DE04E}"/>
          </ac:spMkLst>
        </pc:spChg>
        <pc:spChg chg="add mod">
          <ac:chgData name="Yang, Shengming - ARS" userId="37bd5b25-7571-49cb-bfc8-588a18706c35" providerId="ADAL" clId="{D37E7023-24B4-488B-82AC-5E5A99F64B29}" dt="2022-01-27T19:58:26.674" v="612" actId="20577"/>
          <ac:spMkLst>
            <pc:docMk/>
            <pc:sldMk cId="2625937353" sldId="284"/>
            <ac:spMk id="55" creationId="{A6D270E6-0520-4418-8296-0E03A15207C8}"/>
          </ac:spMkLst>
        </pc:spChg>
        <pc:picChg chg="mod">
          <ac:chgData name="Yang, Shengming - ARS" userId="37bd5b25-7571-49cb-bfc8-588a18706c35" providerId="ADAL" clId="{D37E7023-24B4-488B-82AC-5E5A99F64B29}" dt="2022-01-27T19:55:58.109" v="556" actId="1035"/>
          <ac:picMkLst>
            <pc:docMk/>
            <pc:sldMk cId="2625937353" sldId="284"/>
            <ac:picMk id="2" creationId="{7556588D-D216-4384-B5CD-01DA16987B6F}"/>
          </ac:picMkLst>
        </pc:picChg>
        <pc:picChg chg="mod">
          <ac:chgData name="Yang, Shengming - ARS" userId="37bd5b25-7571-49cb-bfc8-588a18706c35" providerId="ADAL" clId="{D37E7023-24B4-488B-82AC-5E5A99F64B29}" dt="2022-01-27T19:55:58.109" v="556" actId="1035"/>
          <ac:picMkLst>
            <pc:docMk/>
            <pc:sldMk cId="2625937353" sldId="284"/>
            <ac:picMk id="35" creationId="{745C001A-D968-411D-967A-269A9A402FD0}"/>
          </ac:picMkLst>
        </pc:picChg>
        <pc:picChg chg="mod">
          <ac:chgData name="Yang, Shengming - ARS" userId="37bd5b25-7571-49cb-bfc8-588a18706c35" providerId="ADAL" clId="{D37E7023-24B4-488B-82AC-5E5A99F64B29}" dt="2022-01-27T19:55:58.109" v="556" actId="1035"/>
          <ac:picMkLst>
            <pc:docMk/>
            <pc:sldMk cId="2625937353" sldId="284"/>
            <ac:picMk id="37" creationId="{C2B3FB3C-31C6-4288-924D-874795D58FEB}"/>
          </ac:picMkLst>
        </pc:picChg>
        <pc:picChg chg="mod">
          <ac:chgData name="Yang, Shengming - ARS" userId="37bd5b25-7571-49cb-bfc8-588a18706c35" providerId="ADAL" clId="{D37E7023-24B4-488B-82AC-5E5A99F64B29}" dt="2022-01-27T19:55:58.109" v="556" actId="1035"/>
          <ac:picMkLst>
            <pc:docMk/>
            <pc:sldMk cId="2625937353" sldId="284"/>
            <ac:picMk id="38" creationId="{B7A19B21-874C-4169-B186-FCABA8034826}"/>
          </ac:picMkLst>
        </pc:picChg>
        <pc:cxnChg chg="add mod">
          <ac:chgData name="Yang, Shengming - ARS" userId="37bd5b25-7571-49cb-bfc8-588a18706c35" providerId="ADAL" clId="{D37E7023-24B4-488B-82AC-5E5A99F64B29}" dt="2022-01-27T19:56:15.212" v="577" actId="1035"/>
          <ac:cxnSpMkLst>
            <pc:docMk/>
            <pc:sldMk cId="2625937353" sldId="284"/>
            <ac:cxnSpMk id="7" creationId="{B1A2A7DD-56EE-46A1-AF79-4F81A8F667E2}"/>
          </ac:cxnSpMkLst>
        </pc:cxnChg>
        <pc:cxnChg chg="add mod">
          <ac:chgData name="Yang, Shengming - ARS" userId="37bd5b25-7571-49cb-bfc8-588a18706c35" providerId="ADAL" clId="{D37E7023-24B4-488B-82AC-5E5A99F64B29}" dt="2022-01-27T19:56:46.085" v="586" actId="1038"/>
          <ac:cxnSpMkLst>
            <pc:docMk/>
            <pc:sldMk cId="2625937353" sldId="284"/>
            <ac:cxnSpMk id="9" creationId="{37F714AF-2B51-4404-97B1-0F18158EF1AF}"/>
          </ac:cxnSpMkLst>
        </pc:cxnChg>
        <pc:cxnChg chg="add mod">
          <ac:chgData name="Yang, Shengming - ARS" userId="37bd5b25-7571-49cb-bfc8-588a18706c35" providerId="ADAL" clId="{D37E7023-24B4-488B-82AC-5E5A99F64B29}" dt="2022-01-27T19:57:05.257" v="592" actId="1038"/>
          <ac:cxnSpMkLst>
            <pc:docMk/>
            <pc:sldMk cId="2625937353" sldId="284"/>
            <ac:cxnSpMk id="49" creationId="{69131EF0-17FC-423F-B4DE-37C47DC1FC58}"/>
          </ac:cxnSpMkLst>
        </pc:cxnChg>
        <pc:cxnChg chg="add mod">
          <ac:chgData name="Yang, Shengming - ARS" userId="37bd5b25-7571-49cb-bfc8-588a18706c35" providerId="ADAL" clId="{D37E7023-24B4-488B-82AC-5E5A99F64B29}" dt="2022-01-27T19:56:53.530" v="589" actId="1076"/>
          <ac:cxnSpMkLst>
            <pc:docMk/>
            <pc:sldMk cId="2625937353" sldId="284"/>
            <ac:cxnSpMk id="50" creationId="{DD9D9641-10E3-4914-92C5-30DBAD145F35}"/>
          </ac:cxnSpMkLst>
        </pc:cxnChg>
      </pc:sldChg>
      <pc:sldChg chg="modSp mod">
        <pc:chgData name="Yang, Shengming - ARS" userId="37bd5b25-7571-49cb-bfc8-588a18706c35" providerId="ADAL" clId="{D37E7023-24B4-488B-82AC-5E5A99F64B29}" dt="2022-01-27T17:21:40.823" v="451" actId="1076"/>
        <pc:sldMkLst>
          <pc:docMk/>
          <pc:sldMk cId="2301416017" sldId="285"/>
        </pc:sldMkLst>
        <pc:picChg chg="mod">
          <ac:chgData name="Yang, Shengming - ARS" userId="37bd5b25-7571-49cb-bfc8-588a18706c35" providerId="ADAL" clId="{D37E7023-24B4-488B-82AC-5E5A99F64B29}" dt="2022-01-27T17:21:40.823" v="451" actId="1076"/>
          <ac:picMkLst>
            <pc:docMk/>
            <pc:sldMk cId="2301416017" sldId="285"/>
            <ac:picMk id="5" creationId="{3381DD81-F4CB-4116-AB31-33C2B9C41158}"/>
          </ac:picMkLst>
        </pc:picChg>
        <pc:picChg chg="mod">
          <ac:chgData name="Yang, Shengming - ARS" userId="37bd5b25-7571-49cb-bfc8-588a18706c35" providerId="ADAL" clId="{D37E7023-24B4-488B-82AC-5E5A99F64B29}" dt="2022-01-27T17:21:31.023" v="450" actId="1076"/>
          <ac:picMkLst>
            <pc:docMk/>
            <pc:sldMk cId="2301416017" sldId="285"/>
            <ac:picMk id="10" creationId="{05A166F1-4B35-440B-8A66-9471844B2815}"/>
          </ac:picMkLst>
        </pc:picChg>
      </pc:sldChg>
    </pc:docChg>
  </pc:docChgLst>
  <pc:docChgLst>
    <pc:chgData name="Yang, Shengming - ARS" userId="37bd5b25-7571-49cb-bfc8-588a18706c35" providerId="ADAL" clId="{CFBAF56D-42EE-45FC-B2D3-E2B27F95FCE9}"/>
    <pc:docChg chg="undo redo custSel addSld delSld modSld sldOrd">
      <pc:chgData name="Yang, Shengming - ARS" userId="37bd5b25-7571-49cb-bfc8-588a18706c35" providerId="ADAL" clId="{CFBAF56D-42EE-45FC-B2D3-E2B27F95FCE9}" dt="2022-04-07T20:53:22.620" v="772" actId="20577"/>
      <pc:docMkLst>
        <pc:docMk/>
      </pc:docMkLst>
      <pc:sldChg chg="addSp delSp modSp mod">
        <pc:chgData name="Yang, Shengming - ARS" userId="37bd5b25-7571-49cb-bfc8-588a18706c35" providerId="ADAL" clId="{CFBAF56D-42EE-45FC-B2D3-E2B27F95FCE9}" dt="2022-03-25T14:19:59.859" v="740" actId="2"/>
        <pc:sldMkLst>
          <pc:docMk/>
          <pc:sldMk cId="1525299809" sldId="275"/>
        </pc:sldMkLst>
        <pc:spChg chg="mod topLvl">
          <ac:chgData name="Yang, Shengming - ARS" userId="37bd5b25-7571-49cb-bfc8-588a18706c35" providerId="ADAL" clId="{CFBAF56D-42EE-45FC-B2D3-E2B27F95FCE9}" dt="2022-03-15T21:53:01.558" v="289" actId="2085"/>
          <ac:spMkLst>
            <pc:docMk/>
            <pc:sldMk cId="1525299809" sldId="275"/>
            <ac:spMk id="3" creationId="{E888CEB0-32B8-4D3E-AF97-26E24DBED6A2}"/>
          </ac:spMkLst>
        </pc:spChg>
        <pc:spChg chg="mod">
          <ac:chgData name="Yang, Shengming - ARS" userId="37bd5b25-7571-49cb-bfc8-588a18706c35" providerId="ADAL" clId="{CFBAF56D-42EE-45FC-B2D3-E2B27F95FCE9}" dt="2022-03-25T14:19:59.859" v="740" actId="2"/>
          <ac:spMkLst>
            <pc:docMk/>
            <pc:sldMk cId="1525299809" sldId="275"/>
            <ac:spMk id="7" creationId="{59EC5E2F-A06C-44C2-9BC7-5083B8DB0158}"/>
          </ac:spMkLst>
        </pc:spChg>
        <pc:spChg chg="mod">
          <ac:chgData name="Yang, Shengming - ARS" userId="37bd5b25-7571-49cb-bfc8-588a18706c35" providerId="ADAL" clId="{CFBAF56D-42EE-45FC-B2D3-E2B27F95FCE9}" dt="2022-03-16T13:42:54.155" v="726" actId="1036"/>
          <ac:spMkLst>
            <pc:docMk/>
            <pc:sldMk cId="1525299809" sldId="275"/>
            <ac:spMk id="12" creationId="{521E7359-7336-437C-8A90-B14583285988}"/>
          </ac:spMkLst>
        </pc:spChg>
        <pc:spChg chg="mod">
          <ac:chgData name="Yang, Shengming - ARS" userId="37bd5b25-7571-49cb-bfc8-588a18706c35" providerId="ADAL" clId="{CFBAF56D-42EE-45FC-B2D3-E2B27F95FCE9}" dt="2022-03-16T13:42:54.155" v="726" actId="1036"/>
          <ac:spMkLst>
            <pc:docMk/>
            <pc:sldMk cId="1525299809" sldId="275"/>
            <ac:spMk id="13" creationId="{50A0EE90-3932-4530-A2F6-B29B53FA3754}"/>
          </ac:spMkLst>
        </pc:spChg>
        <pc:spChg chg="add mod">
          <ac:chgData name="Yang, Shengming - ARS" userId="37bd5b25-7571-49cb-bfc8-588a18706c35" providerId="ADAL" clId="{CFBAF56D-42EE-45FC-B2D3-E2B27F95FCE9}" dt="2022-03-23T13:48:24.537" v="738" actId="20577"/>
          <ac:spMkLst>
            <pc:docMk/>
            <pc:sldMk cId="1525299809" sldId="275"/>
            <ac:spMk id="16" creationId="{BE33CB12-E43F-460B-B174-5121A51D68C8}"/>
          </ac:spMkLst>
        </pc:spChg>
        <pc:spChg chg="mod">
          <ac:chgData name="Yang, Shengming - ARS" userId="37bd5b25-7571-49cb-bfc8-588a18706c35" providerId="ADAL" clId="{CFBAF56D-42EE-45FC-B2D3-E2B27F95FCE9}" dt="2022-03-16T13:42:54.155" v="726" actId="1036"/>
          <ac:spMkLst>
            <pc:docMk/>
            <pc:sldMk cId="1525299809" sldId="275"/>
            <ac:spMk id="17" creationId="{EF72585C-D2AF-45D3-97AC-199E08312281}"/>
          </ac:spMkLst>
        </pc:spChg>
        <pc:spChg chg="mod">
          <ac:chgData name="Yang, Shengming - ARS" userId="37bd5b25-7571-49cb-bfc8-588a18706c35" providerId="ADAL" clId="{CFBAF56D-42EE-45FC-B2D3-E2B27F95FCE9}" dt="2022-03-16T13:42:54.155" v="726" actId="1036"/>
          <ac:spMkLst>
            <pc:docMk/>
            <pc:sldMk cId="1525299809" sldId="275"/>
            <ac:spMk id="23" creationId="{EE0E463B-8D9C-4CD8-A0EC-C0A58991BB7D}"/>
          </ac:spMkLst>
        </pc:spChg>
        <pc:spChg chg="mod">
          <ac:chgData name="Yang, Shengming - ARS" userId="37bd5b25-7571-49cb-bfc8-588a18706c35" providerId="ADAL" clId="{CFBAF56D-42EE-45FC-B2D3-E2B27F95FCE9}" dt="2022-03-21T17:14:07.323" v="732" actId="20577"/>
          <ac:spMkLst>
            <pc:docMk/>
            <pc:sldMk cId="1525299809" sldId="275"/>
            <ac:spMk id="25" creationId="{A876130B-ED92-4416-90CA-563FA5FCBC5F}"/>
          </ac:spMkLst>
        </pc:spChg>
        <pc:spChg chg="del">
          <ac:chgData name="Yang, Shengming - ARS" userId="37bd5b25-7571-49cb-bfc8-588a18706c35" providerId="ADAL" clId="{CFBAF56D-42EE-45FC-B2D3-E2B27F95FCE9}" dt="2022-03-15T21:53:09.132" v="291" actId="478"/>
          <ac:spMkLst>
            <pc:docMk/>
            <pc:sldMk cId="1525299809" sldId="275"/>
            <ac:spMk id="26" creationId="{B9CCD95B-3889-4379-A2D1-2FC056F98C66}"/>
          </ac:spMkLst>
        </pc:spChg>
        <pc:spChg chg="del">
          <ac:chgData name="Yang, Shengming - ARS" userId="37bd5b25-7571-49cb-bfc8-588a18706c35" providerId="ADAL" clId="{CFBAF56D-42EE-45FC-B2D3-E2B27F95FCE9}" dt="2022-03-15T21:53:09.132" v="291" actId="478"/>
          <ac:spMkLst>
            <pc:docMk/>
            <pc:sldMk cId="1525299809" sldId="275"/>
            <ac:spMk id="27" creationId="{A025DAFC-93D1-4F78-945F-66FA9798F458}"/>
          </ac:spMkLst>
        </pc:spChg>
        <pc:spChg chg="del">
          <ac:chgData name="Yang, Shengming - ARS" userId="37bd5b25-7571-49cb-bfc8-588a18706c35" providerId="ADAL" clId="{CFBAF56D-42EE-45FC-B2D3-E2B27F95FCE9}" dt="2022-03-15T21:53:09.132" v="291" actId="478"/>
          <ac:spMkLst>
            <pc:docMk/>
            <pc:sldMk cId="1525299809" sldId="275"/>
            <ac:spMk id="29" creationId="{715CB5B5-537D-4983-A660-F90C40946944}"/>
          </ac:spMkLst>
        </pc:spChg>
        <pc:spChg chg="del">
          <ac:chgData name="Yang, Shengming - ARS" userId="37bd5b25-7571-49cb-bfc8-588a18706c35" providerId="ADAL" clId="{CFBAF56D-42EE-45FC-B2D3-E2B27F95FCE9}" dt="2022-03-15T21:53:09.132" v="291" actId="478"/>
          <ac:spMkLst>
            <pc:docMk/>
            <pc:sldMk cId="1525299809" sldId="275"/>
            <ac:spMk id="30" creationId="{C224467D-B63C-431B-940C-424E4BB0DB94}"/>
          </ac:spMkLst>
        </pc:spChg>
        <pc:spChg chg="del">
          <ac:chgData name="Yang, Shengming - ARS" userId="37bd5b25-7571-49cb-bfc8-588a18706c35" providerId="ADAL" clId="{CFBAF56D-42EE-45FC-B2D3-E2B27F95FCE9}" dt="2022-03-15T21:53:06.315" v="290" actId="478"/>
          <ac:spMkLst>
            <pc:docMk/>
            <pc:sldMk cId="1525299809" sldId="275"/>
            <ac:spMk id="31" creationId="{94E1D290-E962-4DC5-9BCF-50A122D814DD}"/>
          </ac:spMkLst>
        </pc:spChg>
        <pc:spChg chg="del">
          <ac:chgData name="Yang, Shengming - ARS" userId="37bd5b25-7571-49cb-bfc8-588a18706c35" providerId="ADAL" clId="{CFBAF56D-42EE-45FC-B2D3-E2B27F95FCE9}" dt="2022-03-15T21:53:11.581" v="292" actId="478"/>
          <ac:spMkLst>
            <pc:docMk/>
            <pc:sldMk cId="1525299809" sldId="275"/>
            <ac:spMk id="32" creationId="{1B62C987-43F5-4DE2-8AF8-592FEF0B282D}"/>
          </ac:spMkLst>
        </pc:spChg>
        <pc:grpChg chg="del">
          <ac:chgData name="Yang, Shengming - ARS" userId="37bd5b25-7571-49cb-bfc8-588a18706c35" providerId="ADAL" clId="{CFBAF56D-42EE-45FC-B2D3-E2B27F95FCE9}" dt="2022-03-15T21:52:53.862" v="288" actId="165"/>
          <ac:grpSpMkLst>
            <pc:docMk/>
            <pc:sldMk cId="1525299809" sldId="275"/>
            <ac:grpSpMk id="10" creationId="{9EB0F5CE-09DF-447B-B0F0-E641528ECE92}"/>
          </ac:grpSpMkLst>
        </pc:grpChg>
        <pc:picChg chg="mod">
          <ac:chgData name="Yang, Shengming - ARS" userId="37bd5b25-7571-49cb-bfc8-588a18706c35" providerId="ADAL" clId="{CFBAF56D-42EE-45FC-B2D3-E2B27F95FCE9}" dt="2022-03-16T13:42:54.155" v="726" actId="1036"/>
          <ac:picMkLst>
            <pc:docMk/>
            <pc:sldMk cId="1525299809" sldId="275"/>
            <ac:picMk id="5" creationId="{47886F41-8483-490F-AFEC-C9F34925FEB4}"/>
          </ac:picMkLst>
        </pc:picChg>
        <pc:picChg chg="mod">
          <ac:chgData name="Yang, Shengming - ARS" userId="37bd5b25-7571-49cb-bfc8-588a18706c35" providerId="ADAL" clId="{CFBAF56D-42EE-45FC-B2D3-E2B27F95FCE9}" dt="2022-03-16T13:42:54.155" v="726" actId="1036"/>
          <ac:picMkLst>
            <pc:docMk/>
            <pc:sldMk cId="1525299809" sldId="275"/>
            <ac:picMk id="9" creationId="{8A5CA8A6-E525-4485-ADF9-36221A12B462}"/>
          </ac:picMkLst>
        </pc:picChg>
        <pc:picChg chg="add mod modCrop">
          <ac:chgData name="Yang, Shengming - ARS" userId="37bd5b25-7571-49cb-bfc8-588a18706c35" providerId="ADAL" clId="{CFBAF56D-42EE-45FC-B2D3-E2B27F95FCE9}" dt="2022-03-23T13:48:16.513" v="737" actId="732"/>
          <ac:picMkLst>
            <pc:docMk/>
            <pc:sldMk cId="1525299809" sldId="275"/>
            <ac:picMk id="14" creationId="{648E8385-883F-477A-8035-6D3EB79651B0}"/>
          </ac:picMkLst>
        </pc:picChg>
        <pc:picChg chg="mod">
          <ac:chgData name="Yang, Shengming - ARS" userId="37bd5b25-7571-49cb-bfc8-588a18706c35" providerId="ADAL" clId="{CFBAF56D-42EE-45FC-B2D3-E2B27F95FCE9}" dt="2022-03-16T13:42:54.155" v="726" actId="1036"/>
          <ac:picMkLst>
            <pc:docMk/>
            <pc:sldMk cId="1525299809" sldId="275"/>
            <ac:picMk id="15" creationId="{59E8A476-E459-49E7-BC90-C0244CB29CE8}"/>
          </ac:picMkLst>
        </pc:picChg>
        <pc:picChg chg="del">
          <ac:chgData name="Yang, Shengming - ARS" userId="37bd5b25-7571-49cb-bfc8-588a18706c35" providerId="ADAL" clId="{CFBAF56D-42EE-45FC-B2D3-E2B27F95FCE9}" dt="2022-03-15T21:53:09.132" v="291" actId="478"/>
          <ac:picMkLst>
            <pc:docMk/>
            <pc:sldMk cId="1525299809" sldId="275"/>
            <ac:picMk id="18" creationId="{DC957572-5F76-4953-A205-6FFE95C92F40}"/>
          </ac:picMkLst>
        </pc:picChg>
        <pc:picChg chg="mod">
          <ac:chgData name="Yang, Shengming - ARS" userId="37bd5b25-7571-49cb-bfc8-588a18706c35" providerId="ADAL" clId="{CFBAF56D-42EE-45FC-B2D3-E2B27F95FCE9}" dt="2022-03-16T13:42:54.155" v="726" actId="1036"/>
          <ac:picMkLst>
            <pc:docMk/>
            <pc:sldMk cId="1525299809" sldId="275"/>
            <ac:picMk id="19" creationId="{596237EC-86BA-4274-95FA-01770DA46B69}"/>
          </ac:picMkLst>
        </pc:picChg>
        <pc:picChg chg="mod">
          <ac:chgData name="Yang, Shengming - ARS" userId="37bd5b25-7571-49cb-bfc8-588a18706c35" providerId="ADAL" clId="{CFBAF56D-42EE-45FC-B2D3-E2B27F95FCE9}" dt="2022-03-16T13:42:54.155" v="726" actId="1036"/>
          <ac:picMkLst>
            <pc:docMk/>
            <pc:sldMk cId="1525299809" sldId="275"/>
            <ac:picMk id="21" creationId="{678FCA89-43B8-45BE-8851-22EE7A6E7A89}"/>
          </ac:picMkLst>
        </pc:picChg>
        <pc:picChg chg="del">
          <ac:chgData name="Yang, Shengming - ARS" userId="37bd5b25-7571-49cb-bfc8-588a18706c35" providerId="ADAL" clId="{CFBAF56D-42EE-45FC-B2D3-E2B27F95FCE9}" dt="2022-03-15T21:53:09.132" v="291" actId="478"/>
          <ac:picMkLst>
            <pc:docMk/>
            <pc:sldMk cId="1525299809" sldId="275"/>
            <ac:picMk id="28" creationId="{5B78FAF8-81AD-4BE8-8D4D-D67EB64B4388}"/>
          </ac:picMkLst>
        </pc:picChg>
        <pc:cxnChg chg="del mod topLvl">
          <ac:chgData name="Yang, Shengming - ARS" userId="37bd5b25-7571-49cb-bfc8-588a18706c35" providerId="ADAL" clId="{CFBAF56D-42EE-45FC-B2D3-E2B27F95FCE9}" dt="2022-03-15T21:53:09.132" v="291" actId="478"/>
          <ac:cxnSpMkLst>
            <pc:docMk/>
            <pc:sldMk cId="1525299809" sldId="275"/>
            <ac:cxnSpMk id="8" creationId="{D0FAFBD5-ACC8-4431-8A0C-DF282A6B392A}"/>
          </ac:cxnSpMkLst>
        </pc:cxnChg>
      </pc:sldChg>
      <pc:sldChg chg="del">
        <pc:chgData name="Yang, Shengming - ARS" userId="37bd5b25-7571-49cb-bfc8-588a18706c35" providerId="ADAL" clId="{CFBAF56D-42EE-45FC-B2D3-E2B27F95FCE9}" dt="2022-03-15T21:36:28.910" v="10" actId="47"/>
        <pc:sldMkLst>
          <pc:docMk/>
          <pc:sldMk cId="1327558011" sldId="276"/>
        </pc:sldMkLst>
      </pc:sldChg>
      <pc:sldChg chg="del">
        <pc:chgData name="Yang, Shengming - ARS" userId="37bd5b25-7571-49cb-bfc8-588a18706c35" providerId="ADAL" clId="{CFBAF56D-42EE-45FC-B2D3-E2B27F95FCE9}" dt="2022-03-15T21:36:11.492" v="1" actId="47"/>
        <pc:sldMkLst>
          <pc:docMk/>
          <pc:sldMk cId="2338164932" sldId="277"/>
        </pc:sldMkLst>
      </pc:sldChg>
      <pc:sldChg chg="addSp delSp modSp mod">
        <pc:chgData name="Yang, Shengming - ARS" userId="37bd5b25-7571-49cb-bfc8-588a18706c35" providerId="ADAL" clId="{CFBAF56D-42EE-45FC-B2D3-E2B27F95FCE9}" dt="2022-04-07T20:53:22.620" v="772" actId="20577"/>
        <pc:sldMkLst>
          <pc:docMk/>
          <pc:sldMk cId="887383785" sldId="278"/>
        </pc:sldMkLst>
        <pc:spChg chg="mod">
          <ac:chgData name="Yang, Shengming - ARS" userId="37bd5b25-7571-49cb-bfc8-588a18706c35" providerId="ADAL" clId="{CFBAF56D-42EE-45FC-B2D3-E2B27F95FCE9}" dt="2022-03-15T22:14:13.884" v="648" actId="1076"/>
          <ac:spMkLst>
            <pc:docMk/>
            <pc:sldMk cId="887383785" sldId="278"/>
            <ac:spMk id="5" creationId="{22CABD5C-E7F8-4D30-AF77-D1DF38BD1326}"/>
          </ac:spMkLst>
        </pc:spChg>
        <pc:graphicFrameChg chg="del">
          <ac:chgData name="Yang, Shengming - ARS" userId="37bd5b25-7571-49cb-bfc8-588a18706c35" providerId="ADAL" clId="{CFBAF56D-42EE-45FC-B2D3-E2B27F95FCE9}" dt="2022-03-15T22:13:03.403" v="606" actId="478"/>
          <ac:graphicFrameMkLst>
            <pc:docMk/>
            <pc:sldMk cId="887383785" sldId="278"/>
            <ac:graphicFrameMk id="4" creationId="{12240337-9653-4844-83C7-8964481C8519}"/>
          </ac:graphicFrameMkLst>
        </pc:graphicFrameChg>
        <pc:graphicFrameChg chg="mod modGraphic">
          <ac:chgData name="Yang, Shengming - ARS" userId="37bd5b25-7571-49cb-bfc8-588a18706c35" providerId="ADAL" clId="{CFBAF56D-42EE-45FC-B2D3-E2B27F95FCE9}" dt="2022-04-07T20:53:22.620" v="772" actId="20577"/>
          <ac:graphicFrameMkLst>
            <pc:docMk/>
            <pc:sldMk cId="887383785" sldId="278"/>
            <ac:graphicFrameMk id="4" creationId="{DBB4A3FC-3A9C-4B93-8C50-F59C3749F655}"/>
          </ac:graphicFrameMkLst>
        </pc:graphicFrameChg>
        <pc:graphicFrameChg chg="add mod">
          <ac:chgData name="Yang, Shengming - ARS" userId="37bd5b25-7571-49cb-bfc8-588a18706c35" providerId="ADAL" clId="{CFBAF56D-42EE-45FC-B2D3-E2B27F95FCE9}" dt="2022-03-15T22:14:21.376" v="649" actId="1076"/>
          <ac:graphicFrameMkLst>
            <pc:docMk/>
            <pc:sldMk cId="887383785" sldId="278"/>
            <ac:graphicFrameMk id="6" creationId="{53E596D7-AB3A-4633-8D47-4B095118AE5E}"/>
          </ac:graphicFrameMkLst>
        </pc:graphicFrameChg>
      </pc:sldChg>
      <pc:sldChg chg="addSp delSp modSp del mod">
        <pc:chgData name="Yang, Shengming - ARS" userId="37bd5b25-7571-49cb-bfc8-588a18706c35" providerId="ADAL" clId="{CFBAF56D-42EE-45FC-B2D3-E2B27F95FCE9}" dt="2022-03-21T17:14:03.759" v="731" actId="47"/>
        <pc:sldMkLst>
          <pc:docMk/>
          <pc:sldMk cId="3951076637" sldId="279"/>
        </pc:sldMkLst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15" creationId="{D3EADF99-D3F4-4360-853D-D06FCEDA03CE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16" creationId="{352EC3DD-7CEF-4206-BF5A-966861912469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17" creationId="{D51BFC4C-8A6D-40BF-A4FB-52A4DEE21EAD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18" creationId="{FC57FAAF-3766-4C61-98FA-519B69B19936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19" creationId="{12B2004B-F8E0-4949-8272-DD86AEF89358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20" creationId="{6F788AA2-2D99-40F7-A468-41E369576A23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21" creationId="{AE68A47A-820E-4487-8E02-493EC88C0053}"/>
          </ac:spMkLst>
        </pc:spChg>
        <pc:spChg chg="add mod">
          <ac:chgData name="Yang, Shengming - ARS" userId="37bd5b25-7571-49cb-bfc8-588a18706c35" providerId="ADAL" clId="{CFBAF56D-42EE-45FC-B2D3-E2B27F95FCE9}" dt="2022-03-15T22:00:27.639" v="466" actId="164"/>
          <ac:spMkLst>
            <pc:docMk/>
            <pc:sldMk cId="3951076637" sldId="279"/>
            <ac:spMk id="22" creationId="{622500C9-023B-43D2-998A-99B6477578F9}"/>
          </ac:spMkLst>
        </pc:spChg>
        <pc:spChg chg="mod">
          <ac:chgData name="Yang, Shengming - ARS" userId="37bd5b25-7571-49cb-bfc8-588a18706c35" providerId="ADAL" clId="{CFBAF56D-42EE-45FC-B2D3-E2B27F95FCE9}" dt="2022-03-15T21:42:09.480" v="138" actId="2085"/>
          <ac:spMkLst>
            <pc:docMk/>
            <pc:sldMk cId="3951076637" sldId="279"/>
            <ac:spMk id="31" creationId="{8C88D3CF-522A-4F82-9D1E-F2BA0C73E44A}"/>
          </ac:spMkLst>
        </pc:spChg>
        <pc:spChg chg="mod">
          <ac:chgData name="Yang, Shengming - ARS" userId="37bd5b25-7571-49cb-bfc8-588a18706c35" providerId="ADAL" clId="{CFBAF56D-42EE-45FC-B2D3-E2B27F95FCE9}" dt="2022-03-15T21:59:13.744" v="451" actId="1076"/>
          <ac:spMkLst>
            <pc:docMk/>
            <pc:sldMk cId="3951076637" sldId="279"/>
            <ac:spMk id="33" creationId="{A3CCCF6D-3F3C-4533-B4BB-23BC1ECC5268}"/>
          </ac:spMkLst>
        </pc:spChg>
        <pc:grpChg chg="add mod">
          <ac:chgData name="Yang, Shengming - ARS" userId="37bd5b25-7571-49cb-bfc8-588a18706c35" providerId="ADAL" clId="{CFBAF56D-42EE-45FC-B2D3-E2B27F95FCE9}" dt="2022-03-15T22:00:31.156" v="467" actId="1076"/>
          <ac:grpSpMkLst>
            <pc:docMk/>
            <pc:sldMk cId="3951076637" sldId="279"/>
            <ac:grpSpMk id="3" creationId="{AD6E6085-5043-41B1-A474-E37EB35B2950}"/>
          </ac:grpSpMkLst>
        </pc:grpChg>
        <pc:grpChg chg="mod">
          <ac:chgData name="Yang, Shengming - ARS" userId="37bd5b25-7571-49cb-bfc8-588a18706c35" providerId="ADAL" clId="{CFBAF56D-42EE-45FC-B2D3-E2B27F95FCE9}" dt="2022-03-15T22:00:27.639" v="466" actId="164"/>
          <ac:grpSpMkLst>
            <pc:docMk/>
            <pc:sldMk cId="3951076637" sldId="279"/>
            <ac:grpSpMk id="30" creationId="{50962A51-58E8-4470-B29C-EE836E9FB46F}"/>
          </ac:grpSpMkLst>
        </pc:grpChg>
        <pc:graphicFrameChg chg="del mod">
          <ac:chgData name="Yang, Shengming - ARS" userId="37bd5b25-7571-49cb-bfc8-588a18706c35" providerId="ADAL" clId="{CFBAF56D-42EE-45FC-B2D3-E2B27F95FCE9}" dt="2022-03-15T21:48:18.504" v="239" actId="478"/>
          <ac:graphicFrameMkLst>
            <pc:docMk/>
            <pc:sldMk cId="3951076637" sldId="279"/>
            <ac:graphicFrameMk id="36" creationId="{6F1D622B-363F-4DE5-B31A-0E65AA636F7D}"/>
          </ac:graphicFrameMkLst>
        </pc:graphicFrameChg>
      </pc:sldChg>
      <pc:sldChg chg="del">
        <pc:chgData name="Yang, Shengming - ARS" userId="37bd5b25-7571-49cb-bfc8-588a18706c35" providerId="ADAL" clId="{CFBAF56D-42EE-45FC-B2D3-E2B27F95FCE9}" dt="2022-03-15T21:36:23.487" v="6" actId="47"/>
        <pc:sldMkLst>
          <pc:docMk/>
          <pc:sldMk cId="2943728638" sldId="280"/>
        </pc:sldMkLst>
      </pc:sldChg>
      <pc:sldChg chg="del">
        <pc:chgData name="Yang, Shengming - ARS" userId="37bd5b25-7571-49cb-bfc8-588a18706c35" providerId="ADAL" clId="{CFBAF56D-42EE-45FC-B2D3-E2B27F95FCE9}" dt="2022-03-15T21:36:26.488" v="8" actId="47"/>
        <pc:sldMkLst>
          <pc:docMk/>
          <pc:sldMk cId="1705255663" sldId="282"/>
        </pc:sldMkLst>
      </pc:sldChg>
      <pc:sldChg chg="del">
        <pc:chgData name="Yang, Shengming - ARS" userId="37bd5b25-7571-49cb-bfc8-588a18706c35" providerId="ADAL" clId="{CFBAF56D-42EE-45FC-B2D3-E2B27F95FCE9}" dt="2022-03-15T21:36:30.309" v="11" actId="47"/>
        <pc:sldMkLst>
          <pc:docMk/>
          <pc:sldMk cId="3161562260" sldId="283"/>
        </pc:sldMkLst>
      </pc:sldChg>
      <pc:sldChg chg="add del">
        <pc:chgData name="Yang, Shengming - ARS" userId="37bd5b25-7571-49cb-bfc8-588a18706c35" providerId="ADAL" clId="{CFBAF56D-42EE-45FC-B2D3-E2B27F95FCE9}" dt="2022-03-15T21:50:57.476" v="251" actId="47"/>
        <pc:sldMkLst>
          <pc:docMk/>
          <pc:sldMk cId="2625937353" sldId="284"/>
        </pc:sldMkLst>
      </pc:sldChg>
      <pc:sldChg chg="del">
        <pc:chgData name="Yang, Shengming - ARS" userId="37bd5b25-7571-49cb-bfc8-588a18706c35" providerId="ADAL" clId="{CFBAF56D-42EE-45FC-B2D3-E2B27F95FCE9}" dt="2022-03-15T21:36:27.993" v="9" actId="47"/>
        <pc:sldMkLst>
          <pc:docMk/>
          <pc:sldMk cId="2301416017" sldId="285"/>
        </pc:sldMkLst>
      </pc:sldChg>
      <pc:sldChg chg="del">
        <pc:chgData name="Yang, Shengming - ARS" userId="37bd5b25-7571-49cb-bfc8-588a18706c35" providerId="ADAL" clId="{CFBAF56D-42EE-45FC-B2D3-E2B27F95FCE9}" dt="2022-03-15T21:36:32.540" v="13" actId="47"/>
        <pc:sldMkLst>
          <pc:docMk/>
          <pc:sldMk cId="2028917921" sldId="286"/>
        </pc:sldMkLst>
      </pc:sldChg>
      <pc:sldChg chg="del">
        <pc:chgData name="Yang, Shengming - ARS" userId="37bd5b25-7571-49cb-bfc8-588a18706c35" providerId="ADAL" clId="{CFBAF56D-42EE-45FC-B2D3-E2B27F95FCE9}" dt="2022-03-15T21:36:10.239" v="0" actId="47"/>
        <pc:sldMkLst>
          <pc:docMk/>
          <pc:sldMk cId="1658013936" sldId="287"/>
        </pc:sldMkLst>
      </pc:sldChg>
      <pc:sldChg chg="del">
        <pc:chgData name="Yang, Shengming - ARS" userId="37bd5b25-7571-49cb-bfc8-588a18706c35" providerId="ADAL" clId="{CFBAF56D-42EE-45FC-B2D3-E2B27F95FCE9}" dt="2022-03-15T21:36:21.848" v="5" actId="47"/>
        <pc:sldMkLst>
          <pc:docMk/>
          <pc:sldMk cId="4208113970" sldId="288"/>
        </pc:sldMkLst>
      </pc:sldChg>
      <pc:sldChg chg="del">
        <pc:chgData name="Yang, Shengming - ARS" userId="37bd5b25-7571-49cb-bfc8-588a18706c35" providerId="ADAL" clId="{CFBAF56D-42EE-45FC-B2D3-E2B27F95FCE9}" dt="2022-03-15T21:36:31.222" v="12" actId="47"/>
        <pc:sldMkLst>
          <pc:docMk/>
          <pc:sldMk cId="3220999384" sldId="289"/>
        </pc:sldMkLst>
      </pc:sldChg>
      <pc:sldChg chg="addSp modSp mod ord">
        <pc:chgData name="Yang, Shengming - ARS" userId="37bd5b25-7571-49cb-bfc8-588a18706c35" providerId="ADAL" clId="{CFBAF56D-42EE-45FC-B2D3-E2B27F95FCE9}" dt="2022-03-15T22:00:08.082" v="465" actId="14100"/>
        <pc:sldMkLst>
          <pc:docMk/>
          <pc:sldMk cId="2200906561" sldId="290"/>
        </pc:sldMkLst>
        <pc:spChg chg="add mod">
          <ac:chgData name="Yang, Shengming - ARS" userId="37bd5b25-7571-49cb-bfc8-588a18706c35" providerId="ADAL" clId="{CFBAF56D-42EE-45FC-B2D3-E2B27F95FCE9}" dt="2022-03-15T22:00:08.082" v="465" actId="14100"/>
          <ac:spMkLst>
            <pc:docMk/>
            <pc:sldMk cId="2200906561" sldId="290"/>
            <ac:spMk id="31" creationId="{EDC0EEEA-8676-4C02-819C-7BEE3980EFF6}"/>
          </ac:spMkLst>
        </pc:spChg>
        <pc:spChg chg="add mod">
          <ac:chgData name="Yang, Shengming - ARS" userId="37bd5b25-7571-49cb-bfc8-588a18706c35" providerId="ADAL" clId="{CFBAF56D-42EE-45FC-B2D3-E2B27F95FCE9}" dt="2022-03-15T22:00:02.692" v="464" actId="403"/>
          <ac:spMkLst>
            <pc:docMk/>
            <pc:sldMk cId="2200906561" sldId="290"/>
            <ac:spMk id="56" creationId="{AC55C9CE-FB5E-4553-BB50-F9A580E554ED}"/>
          </ac:spMkLst>
        </pc:spChg>
        <pc:spChg chg="mod">
          <ac:chgData name="Yang, Shengming - ARS" userId="37bd5b25-7571-49cb-bfc8-588a18706c35" providerId="ADAL" clId="{CFBAF56D-42EE-45FC-B2D3-E2B27F95FCE9}" dt="2022-03-15T21:52:23.342" v="286" actId="113"/>
          <ac:spMkLst>
            <pc:docMk/>
            <pc:sldMk cId="2200906561" sldId="290"/>
            <ac:spMk id="58" creationId="{127FACC4-AEA3-45C6-A512-B76CA41EF55B}"/>
          </ac:spMkLst>
        </pc:spChg>
      </pc:sldChg>
      <pc:sldChg chg="modSp add mod">
        <pc:chgData name="Yang, Shengming - ARS" userId="37bd5b25-7571-49cb-bfc8-588a18706c35" providerId="ADAL" clId="{CFBAF56D-42EE-45FC-B2D3-E2B27F95FCE9}" dt="2022-03-15T21:40:00.422" v="16" actId="20577"/>
        <pc:sldMkLst>
          <pc:docMk/>
          <pc:sldMk cId="530921904" sldId="291"/>
        </pc:sldMkLst>
        <pc:spChg chg="mod">
          <ac:chgData name="Yang, Shengming - ARS" userId="37bd5b25-7571-49cb-bfc8-588a18706c35" providerId="ADAL" clId="{CFBAF56D-42EE-45FC-B2D3-E2B27F95FCE9}" dt="2022-03-15T21:40:00.422" v="16" actId="20577"/>
          <ac:spMkLst>
            <pc:docMk/>
            <pc:sldMk cId="530921904" sldId="291"/>
            <ac:spMk id="5" creationId="{22CABD5C-E7F8-4D30-AF77-D1DF38BD1326}"/>
          </ac:spMkLst>
        </pc:spChg>
      </pc:sldChg>
      <pc:sldChg chg="del">
        <pc:chgData name="Yang, Shengming - ARS" userId="37bd5b25-7571-49cb-bfc8-588a18706c35" providerId="ADAL" clId="{CFBAF56D-42EE-45FC-B2D3-E2B27F95FCE9}" dt="2022-03-15T21:36:24.368" v="7" actId="47"/>
        <pc:sldMkLst>
          <pc:docMk/>
          <pc:sldMk cId="2612662908" sldId="291"/>
        </pc:sldMkLst>
      </pc:sldChg>
      <pc:sldChg chg="modSp add mod">
        <pc:chgData name="Yang, Shengming - ARS" userId="37bd5b25-7571-49cb-bfc8-588a18706c35" providerId="ADAL" clId="{CFBAF56D-42EE-45FC-B2D3-E2B27F95FCE9}" dt="2022-03-15T21:54:49.161" v="340" actId="1076"/>
        <pc:sldMkLst>
          <pc:docMk/>
          <pc:sldMk cId="2282065266" sldId="292"/>
        </pc:sldMkLst>
        <pc:spChg chg="mod">
          <ac:chgData name="Yang, Shengming - ARS" userId="37bd5b25-7571-49cb-bfc8-588a18706c35" providerId="ADAL" clId="{CFBAF56D-42EE-45FC-B2D3-E2B27F95FCE9}" dt="2022-03-15T21:54:49.161" v="340" actId="1076"/>
          <ac:spMkLst>
            <pc:docMk/>
            <pc:sldMk cId="2282065266" sldId="292"/>
            <ac:spMk id="5" creationId="{22CABD5C-E7F8-4D30-AF77-D1DF38BD1326}"/>
          </ac:spMkLst>
        </pc:spChg>
      </pc:sldChg>
      <pc:sldChg chg="del">
        <pc:chgData name="Yang, Shengming - ARS" userId="37bd5b25-7571-49cb-bfc8-588a18706c35" providerId="ADAL" clId="{CFBAF56D-42EE-45FC-B2D3-E2B27F95FCE9}" dt="2022-03-15T21:36:20.897" v="4" actId="47"/>
        <pc:sldMkLst>
          <pc:docMk/>
          <pc:sldMk cId="3303732898" sldId="292"/>
        </pc:sldMkLst>
      </pc:sldChg>
    </pc:docChg>
  </pc:docChgLst>
  <pc:docChgLst>
    <pc:chgData name="Yang, Shengming - ARS" userId="37bd5b25-7571-49cb-bfc8-588a18706c35" providerId="ADAL" clId="{64974484-A414-4DA9-9FFB-7D0FAE92FD4F}"/>
    <pc:docChg chg="modSld">
      <pc:chgData name="Yang, Shengming - ARS" userId="37bd5b25-7571-49cb-bfc8-588a18706c35" providerId="ADAL" clId="{64974484-A414-4DA9-9FFB-7D0FAE92FD4F}" dt="2022-01-04T15:08:28.685" v="12" actId="1038"/>
      <pc:docMkLst>
        <pc:docMk/>
      </pc:docMkLst>
      <pc:sldChg chg="modSp mod">
        <pc:chgData name="Yang, Shengming - ARS" userId="37bd5b25-7571-49cb-bfc8-588a18706c35" providerId="ADAL" clId="{64974484-A414-4DA9-9FFB-7D0FAE92FD4F}" dt="2022-01-04T15:08:28.685" v="12" actId="1038"/>
        <pc:sldMkLst>
          <pc:docMk/>
          <pc:sldMk cId="1327558011" sldId="276"/>
        </pc:sldMkLst>
        <pc:picChg chg="mod">
          <ac:chgData name="Yang, Shengming - ARS" userId="37bd5b25-7571-49cb-bfc8-588a18706c35" providerId="ADAL" clId="{64974484-A414-4DA9-9FFB-7D0FAE92FD4F}" dt="2022-01-04T15:08:11.027" v="8" actId="14100"/>
          <ac:picMkLst>
            <pc:docMk/>
            <pc:sldMk cId="1327558011" sldId="276"/>
            <ac:picMk id="10" creationId="{05A166F1-4B35-440B-8A66-9471844B2815}"/>
          </ac:picMkLst>
        </pc:picChg>
        <pc:picChg chg="mod">
          <ac:chgData name="Yang, Shengming - ARS" userId="37bd5b25-7571-49cb-bfc8-588a18706c35" providerId="ADAL" clId="{64974484-A414-4DA9-9FFB-7D0FAE92FD4F}" dt="2022-01-04T15:08:28.685" v="12" actId="1038"/>
          <ac:picMkLst>
            <pc:docMk/>
            <pc:sldMk cId="1327558011" sldId="276"/>
            <ac:picMk id="13" creationId="{7337B5DD-D9CC-4FD6-9539-A6256FEF0D65}"/>
          </ac:picMkLst>
        </pc:picChg>
      </pc:sldChg>
    </pc:docChg>
  </pc:docChgLst>
  <pc:docChgLst>
    <pc:chgData name="Yang, Shengming - ARS" userId="37bd5b25-7571-49cb-bfc8-588a18706c35" providerId="ADAL" clId="{0A6E7208-8512-4C97-A871-65C860D78EB1}"/>
    <pc:docChg chg="undo custSel addSld modSld">
      <pc:chgData name="Yang, Shengming - ARS" userId="37bd5b25-7571-49cb-bfc8-588a18706c35" providerId="ADAL" clId="{0A6E7208-8512-4C97-A871-65C860D78EB1}" dt="2021-12-10T22:55:18.926" v="107" actId="14100"/>
      <pc:docMkLst>
        <pc:docMk/>
      </pc:docMkLst>
      <pc:sldChg chg="modSp mod">
        <pc:chgData name="Yang, Shengming - ARS" userId="37bd5b25-7571-49cb-bfc8-588a18706c35" providerId="ADAL" clId="{0A6E7208-8512-4C97-A871-65C860D78EB1}" dt="2021-12-10T22:55:18.926" v="107" actId="14100"/>
        <pc:sldMkLst>
          <pc:docMk/>
          <pc:sldMk cId="187198215" sldId="256"/>
        </pc:sldMkLst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8" creationId="{7A85EE01-37A5-48DD-82B2-CC61EFCB05A6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4" creationId="{8E1BB1BC-4655-4667-9A9A-9388A8CD0B6A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5" creationId="{9245E1A8-7BA6-44DB-9AB5-CC7429F5BAB9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6" creationId="{14ACD6D4-6C84-4831-98FA-1D0760256699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7" creationId="{4F8D18C1-A3FB-49E5-9800-8A0CDAAC9A06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8" creationId="{55FC71C1-3FE7-4850-AC87-2D5CC70E4B67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29" creationId="{C72ED974-59CB-4AC2-A042-C083C26196DF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30" creationId="{3588F8F0-AE71-4D43-A1BE-9835CB267077}"/>
          </ac:spMkLst>
        </pc:spChg>
        <pc:spChg chg="mod">
          <ac:chgData name="Yang, Shengming - ARS" userId="37bd5b25-7571-49cb-bfc8-588a18706c35" providerId="ADAL" clId="{0A6E7208-8512-4C97-A871-65C860D78EB1}" dt="2021-12-10T22:55:12.229" v="106" actId="404"/>
          <ac:spMkLst>
            <pc:docMk/>
            <pc:sldMk cId="187198215" sldId="256"/>
            <ac:spMk id="31" creationId="{F216FF89-0AA4-4565-88C4-DA0A12A877DC}"/>
          </ac:spMkLst>
        </pc:spChg>
        <pc:grpChg chg="mod">
          <ac:chgData name="Yang, Shengming - ARS" userId="37bd5b25-7571-49cb-bfc8-588a18706c35" providerId="ADAL" clId="{0A6E7208-8512-4C97-A871-65C860D78EB1}" dt="2021-12-10T22:55:18.926" v="107" actId="14100"/>
          <ac:grpSpMkLst>
            <pc:docMk/>
            <pc:sldMk cId="187198215" sldId="256"/>
            <ac:grpSpMk id="4" creationId="{4713D267-1D1C-445B-9270-5911825C9C0B}"/>
          </ac:grpSpMkLst>
        </pc:grpChg>
      </pc:sldChg>
      <pc:sldChg chg="delSp modSp mod">
        <pc:chgData name="Yang, Shengming - ARS" userId="37bd5b25-7571-49cb-bfc8-588a18706c35" providerId="ADAL" clId="{0A6E7208-8512-4C97-A871-65C860D78EB1}" dt="2021-12-04T18:48:08.858" v="17" actId="1076"/>
        <pc:sldMkLst>
          <pc:docMk/>
          <pc:sldMk cId="1525299809" sldId="275"/>
        </pc:sldMkLst>
        <pc:spChg chg="mod topLvl">
          <ac:chgData name="Yang, Shengming - ARS" userId="37bd5b25-7571-49cb-bfc8-588a18706c35" providerId="ADAL" clId="{0A6E7208-8512-4C97-A871-65C860D78EB1}" dt="2021-12-04T18:48:08.858" v="17" actId="1076"/>
          <ac:spMkLst>
            <pc:docMk/>
            <pc:sldMk cId="1525299809" sldId="275"/>
            <ac:spMk id="22" creationId="{4D948ADA-E9AF-42DA-8B05-03DACB9C498C}"/>
          </ac:spMkLst>
        </pc:spChg>
        <pc:spChg chg="mod topLvl">
          <ac:chgData name="Yang, Shengming - ARS" userId="37bd5b25-7571-49cb-bfc8-588a18706c35" providerId="ADAL" clId="{0A6E7208-8512-4C97-A871-65C860D78EB1}" dt="2021-12-04T18:48:08.858" v="17" actId="1076"/>
          <ac:spMkLst>
            <pc:docMk/>
            <pc:sldMk cId="1525299809" sldId="275"/>
            <ac:spMk id="24" creationId="{4162F7BC-929B-45B6-BA7F-921891A36F89}"/>
          </ac:spMkLst>
        </pc:spChg>
        <pc:spChg chg="mod topLvl">
          <ac:chgData name="Yang, Shengming - ARS" userId="37bd5b25-7571-49cb-bfc8-588a18706c35" providerId="ADAL" clId="{0A6E7208-8512-4C97-A871-65C860D78EB1}" dt="2021-12-04T18:48:08.858" v="17" actId="1076"/>
          <ac:spMkLst>
            <pc:docMk/>
            <pc:sldMk cId="1525299809" sldId="275"/>
            <ac:spMk id="26" creationId="{B9CCD95B-3889-4379-A2D1-2FC056F98C66}"/>
          </ac:spMkLst>
        </pc:spChg>
        <pc:spChg chg="mod topLvl">
          <ac:chgData name="Yang, Shengming - ARS" userId="37bd5b25-7571-49cb-bfc8-588a18706c35" providerId="ADAL" clId="{0A6E7208-8512-4C97-A871-65C860D78EB1}" dt="2021-12-04T18:48:08.858" v="17" actId="1076"/>
          <ac:spMkLst>
            <pc:docMk/>
            <pc:sldMk cId="1525299809" sldId="275"/>
            <ac:spMk id="27" creationId="{A025DAFC-93D1-4F78-945F-66FA9798F458}"/>
          </ac:spMkLst>
        </pc:spChg>
        <pc:grpChg chg="del mod">
          <ac:chgData name="Yang, Shengming - ARS" userId="37bd5b25-7571-49cb-bfc8-588a18706c35" providerId="ADAL" clId="{0A6E7208-8512-4C97-A871-65C860D78EB1}" dt="2021-12-04T18:45:56.093" v="3" actId="165"/>
          <ac:grpSpMkLst>
            <pc:docMk/>
            <pc:sldMk cId="1525299809" sldId="275"/>
            <ac:grpSpMk id="2" creationId="{F4EE9DA4-CB9F-486A-923F-388B16F5FCA0}"/>
          </ac:grpSpMkLst>
        </pc:grpChg>
        <pc:grpChg chg="del mod topLvl">
          <ac:chgData name="Yang, Shengming - ARS" userId="37bd5b25-7571-49cb-bfc8-588a18706c35" providerId="ADAL" clId="{0A6E7208-8512-4C97-A871-65C860D78EB1}" dt="2021-12-04T18:47:01.512" v="7" actId="165"/>
          <ac:grpSpMkLst>
            <pc:docMk/>
            <pc:sldMk cId="1525299809" sldId="275"/>
            <ac:grpSpMk id="16" creationId="{6CE4D0D7-A763-4BAE-8CC2-D0BA38EEC42E}"/>
          </ac:grpSpMkLst>
        </pc:grpChg>
        <pc:picChg chg="mod topLvl">
          <ac:chgData name="Yang, Shengming - ARS" userId="37bd5b25-7571-49cb-bfc8-588a18706c35" providerId="ADAL" clId="{0A6E7208-8512-4C97-A871-65C860D78EB1}" dt="2021-12-04T18:48:08.858" v="17" actId="1076"/>
          <ac:picMkLst>
            <pc:docMk/>
            <pc:sldMk cId="1525299809" sldId="275"/>
            <ac:picMk id="18" creationId="{DC957572-5F76-4953-A205-6FFE95C92F40}"/>
          </ac:picMkLst>
        </pc:picChg>
        <pc:picChg chg="mod topLvl">
          <ac:chgData name="Yang, Shengming - ARS" userId="37bd5b25-7571-49cb-bfc8-588a18706c35" providerId="ADAL" clId="{0A6E7208-8512-4C97-A871-65C860D78EB1}" dt="2021-12-04T18:48:08.858" v="17" actId="1076"/>
          <ac:picMkLst>
            <pc:docMk/>
            <pc:sldMk cId="1525299809" sldId="275"/>
            <ac:picMk id="20" creationId="{82B004C6-1B02-4AAE-9F53-D06DA1D4183C}"/>
          </ac:picMkLst>
        </pc:picChg>
      </pc:sldChg>
      <pc:sldChg chg="modSp mod">
        <pc:chgData name="Yang, Shengming - ARS" userId="37bd5b25-7571-49cb-bfc8-588a18706c35" providerId="ADAL" clId="{0A6E7208-8512-4C97-A871-65C860D78EB1}" dt="2021-12-04T18:52:50.378" v="73" actId="1076"/>
        <pc:sldMkLst>
          <pc:docMk/>
          <pc:sldMk cId="2338164932" sldId="277"/>
        </pc:sldMkLst>
        <pc:spChg chg="mod">
          <ac:chgData name="Yang, Shengming - ARS" userId="37bd5b25-7571-49cb-bfc8-588a18706c35" providerId="ADAL" clId="{0A6E7208-8512-4C97-A871-65C860D78EB1}" dt="2021-12-04T18:52:44.386" v="72" actId="1076"/>
          <ac:spMkLst>
            <pc:docMk/>
            <pc:sldMk cId="2338164932" sldId="277"/>
            <ac:spMk id="4" creationId="{327864F8-1AF9-48FF-8153-91701A03977B}"/>
          </ac:spMkLst>
        </pc:spChg>
        <pc:spChg chg="mod">
          <ac:chgData name="Yang, Shengming - ARS" userId="37bd5b25-7571-49cb-bfc8-588a18706c35" providerId="ADAL" clId="{0A6E7208-8512-4C97-A871-65C860D78EB1}" dt="2021-12-04T18:52:00.372" v="63" actId="404"/>
          <ac:spMkLst>
            <pc:docMk/>
            <pc:sldMk cId="2338164932" sldId="277"/>
            <ac:spMk id="9" creationId="{ACF661F1-6CE1-44C8-9915-E53CDBFA7B63}"/>
          </ac:spMkLst>
        </pc:spChg>
        <pc:spChg chg="mod">
          <ac:chgData name="Yang, Shengming - ARS" userId="37bd5b25-7571-49cb-bfc8-588a18706c35" providerId="ADAL" clId="{0A6E7208-8512-4C97-A871-65C860D78EB1}" dt="2021-12-04T18:52:44.386" v="72" actId="1076"/>
          <ac:spMkLst>
            <pc:docMk/>
            <pc:sldMk cId="2338164932" sldId="277"/>
            <ac:spMk id="12" creationId="{E6D8814D-51B2-4292-BAC4-B3F2C8897A0A}"/>
          </ac:spMkLst>
        </pc:spChg>
        <pc:spChg chg="mod">
          <ac:chgData name="Yang, Shengming - ARS" userId="37bd5b25-7571-49cb-bfc8-588a18706c35" providerId="ADAL" clId="{0A6E7208-8512-4C97-A871-65C860D78EB1}" dt="2021-12-04T18:52:44.386" v="72" actId="1076"/>
          <ac:spMkLst>
            <pc:docMk/>
            <pc:sldMk cId="2338164932" sldId="277"/>
            <ac:spMk id="25" creationId="{A0451547-3B00-4C7C-8802-76D22D0B3C4E}"/>
          </ac:spMkLst>
        </pc:spChg>
        <pc:spChg chg="mod">
          <ac:chgData name="Yang, Shengming - ARS" userId="37bd5b25-7571-49cb-bfc8-588a18706c35" providerId="ADAL" clId="{0A6E7208-8512-4C97-A871-65C860D78EB1}" dt="2021-12-04T18:52:44.386" v="72" actId="1076"/>
          <ac:spMkLst>
            <pc:docMk/>
            <pc:sldMk cId="2338164932" sldId="277"/>
            <ac:spMk id="34" creationId="{98406564-1BCE-451A-BB23-839381D5B6A9}"/>
          </ac:spMkLst>
        </pc:spChg>
        <pc:spChg chg="mod">
          <ac:chgData name="Yang, Shengming - ARS" userId="37bd5b25-7571-49cb-bfc8-588a18706c35" providerId="ADAL" clId="{0A6E7208-8512-4C97-A871-65C860D78EB1}" dt="2021-12-04T18:52:50.378" v="73" actId="1076"/>
          <ac:spMkLst>
            <pc:docMk/>
            <pc:sldMk cId="2338164932" sldId="277"/>
            <ac:spMk id="35" creationId="{AF0B610E-81AE-45AA-BE91-3A074F40C5EE}"/>
          </ac:spMkLst>
        </pc:spChg>
        <pc:cxnChg chg="mod">
          <ac:chgData name="Yang, Shengming - ARS" userId="37bd5b25-7571-49cb-bfc8-588a18706c35" providerId="ADAL" clId="{0A6E7208-8512-4C97-A871-65C860D78EB1}" dt="2021-12-04T18:26:04.990" v="0" actId="14100"/>
          <ac:cxnSpMkLst>
            <pc:docMk/>
            <pc:sldMk cId="2338164932" sldId="277"/>
            <ac:cxnSpMk id="27" creationId="{C212F65D-5149-4C30-97FA-04BD3B35D5C5}"/>
          </ac:cxnSpMkLst>
        </pc:cxnChg>
      </pc:sldChg>
      <pc:sldChg chg="addSp delSp modSp new mod">
        <pc:chgData name="Yang, Shengming - ARS" userId="37bd5b25-7571-49cb-bfc8-588a18706c35" providerId="ADAL" clId="{0A6E7208-8512-4C97-A871-65C860D78EB1}" dt="2021-12-09T01:36:59.684" v="97" actId="1076"/>
        <pc:sldMkLst>
          <pc:docMk/>
          <pc:sldMk cId="1104748975" sldId="281"/>
        </pc:sldMkLst>
        <pc:spChg chg="del">
          <ac:chgData name="Yang, Shengming - ARS" userId="37bd5b25-7571-49cb-bfc8-588a18706c35" providerId="ADAL" clId="{0A6E7208-8512-4C97-A871-65C860D78EB1}" dt="2021-12-09T01:03:48.325" v="75" actId="478"/>
          <ac:spMkLst>
            <pc:docMk/>
            <pc:sldMk cId="1104748975" sldId="281"/>
            <ac:spMk id="2" creationId="{B8064EB0-5F71-448E-A08E-7B2703279E8F}"/>
          </ac:spMkLst>
        </pc:spChg>
        <pc:spChg chg="del">
          <ac:chgData name="Yang, Shengming - ARS" userId="37bd5b25-7571-49cb-bfc8-588a18706c35" providerId="ADAL" clId="{0A6E7208-8512-4C97-A871-65C860D78EB1}" dt="2021-12-09T01:03:48.325" v="75" actId="478"/>
          <ac:spMkLst>
            <pc:docMk/>
            <pc:sldMk cId="1104748975" sldId="281"/>
            <ac:spMk id="3" creationId="{391D6937-A431-4ED8-BBA4-5C37ED9AA521}"/>
          </ac:spMkLst>
        </pc:spChg>
        <pc:picChg chg="add mod">
          <ac:chgData name="Yang, Shengming - ARS" userId="37bd5b25-7571-49cb-bfc8-588a18706c35" providerId="ADAL" clId="{0A6E7208-8512-4C97-A871-65C860D78EB1}" dt="2021-12-09T01:36:59.684" v="97" actId="1076"/>
          <ac:picMkLst>
            <pc:docMk/>
            <pc:sldMk cId="1104748975" sldId="281"/>
            <ac:picMk id="5" creationId="{268BE0B8-DA26-4BA7-BBC9-1F2701F84E01}"/>
          </ac:picMkLst>
        </pc:picChg>
        <pc:picChg chg="add del mod">
          <ac:chgData name="Yang, Shengming - ARS" userId="37bd5b25-7571-49cb-bfc8-588a18706c35" providerId="ADAL" clId="{0A6E7208-8512-4C97-A871-65C860D78EB1}" dt="2021-12-09T01:28:02.170" v="88" actId="478"/>
          <ac:picMkLst>
            <pc:docMk/>
            <pc:sldMk cId="1104748975" sldId="281"/>
            <ac:picMk id="7" creationId="{D0DD1CF9-C0F7-4686-8DE2-5AA9E9FBC220}"/>
          </ac:picMkLst>
        </pc:picChg>
        <pc:picChg chg="add mod">
          <ac:chgData name="Yang, Shengming - ARS" userId="37bd5b25-7571-49cb-bfc8-588a18706c35" providerId="ADAL" clId="{0A6E7208-8512-4C97-A871-65C860D78EB1}" dt="2021-12-09T01:36:59.684" v="97" actId="1076"/>
          <ac:picMkLst>
            <pc:docMk/>
            <pc:sldMk cId="1104748975" sldId="281"/>
            <ac:picMk id="9" creationId="{44F233FB-2819-41D0-9AF4-54786682BBC0}"/>
          </ac:picMkLst>
        </pc:picChg>
      </pc:sldChg>
    </pc:docChg>
  </pc:docChgLst>
  <pc:docChgLst>
    <pc:chgData name="Yang, Shengming - ARS" userId="37bd5b25-7571-49cb-bfc8-588a18706c35" providerId="ADAL" clId="{73BA1FA4-9FF7-406E-A355-CA3B9319D1EF}"/>
    <pc:docChg chg="undo custSel addSld modSld sldOrd">
      <pc:chgData name="Yang, Shengming - ARS" userId="37bd5b25-7571-49cb-bfc8-588a18706c35" providerId="ADAL" clId="{73BA1FA4-9FF7-406E-A355-CA3B9319D1EF}" dt="2022-02-24T03:31:32.621" v="518"/>
      <pc:docMkLst>
        <pc:docMk/>
      </pc:docMkLst>
      <pc:sldChg chg="modSp mod ord">
        <pc:chgData name="Yang, Shengming - ARS" userId="37bd5b25-7571-49cb-bfc8-588a18706c35" providerId="ADAL" clId="{73BA1FA4-9FF7-406E-A355-CA3B9319D1EF}" dt="2022-02-18T18:18:38.060" v="224"/>
        <pc:sldMkLst>
          <pc:docMk/>
          <pc:sldMk cId="1327558011" sldId="276"/>
        </pc:sldMkLst>
        <pc:spChg chg="mod">
          <ac:chgData name="Yang, Shengming - ARS" userId="37bd5b25-7571-49cb-bfc8-588a18706c35" providerId="ADAL" clId="{73BA1FA4-9FF7-406E-A355-CA3B9319D1EF}" dt="2022-02-17T22:33:37.155" v="29" actId="20577"/>
          <ac:spMkLst>
            <pc:docMk/>
            <pc:sldMk cId="1327558011" sldId="276"/>
            <ac:spMk id="26" creationId="{557EC437-7B38-4A6E-97F8-966514E076E1}"/>
          </ac:spMkLst>
        </pc:spChg>
      </pc:sldChg>
      <pc:sldChg chg="addSp delSp modSp mod modNotesTx">
        <pc:chgData name="Yang, Shengming - ARS" userId="37bd5b25-7571-49cb-bfc8-588a18706c35" providerId="ADAL" clId="{73BA1FA4-9FF7-406E-A355-CA3B9319D1EF}" dt="2022-02-18T23:01:00.990" v="450" actId="164"/>
        <pc:sldMkLst>
          <pc:docMk/>
          <pc:sldMk cId="3951076637" sldId="279"/>
        </pc:sldMkLst>
        <pc:spChg chg="add del mod">
          <ac:chgData name="Yang, Shengming - ARS" userId="37bd5b25-7571-49cb-bfc8-588a18706c35" providerId="ADAL" clId="{73BA1FA4-9FF7-406E-A355-CA3B9319D1EF}" dt="2022-02-18T23:01:00.990" v="450" actId="164"/>
          <ac:spMkLst>
            <pc:docMk/>
            <pc:sldMk cId="3951076637" sldId="279"/>
            <ac:spMk id="35" creationId="{88071EA3-5D2C-44FE-B04C-3F420FF1A797}"/>
          </ac:spMkLst>
        </pc:spChg>
        <pc:spChg chg="add mod">
          <ac:chgData name="Yang, Shengming - ARS" userId="37bd5b25-7571-49cb-bfc8-588a18706c35" providerId="ADAL" clId="{73BA1FA4-9FF7-406E-A355-CA3B9319D1EF}" dt="2022-02-18T23:01:00.990" v="450" actId="164"/>
          <ac:spMkLst>
            <pc:docMk/>
            <pc:sldMk cId="3951076637" sldId="279"/>
            <ac:spMk id="41" creationId="{4ED00229-25CF-4B71-862F-47E567DD6907}"/>
          </ac:spMkLst>
        </pc:spChg>
        <pc:spChg chg="add mod">
          <ac:chgData name="Yang, Shengming - ARS" userId="37bd5b25-7571-49cb-bfc8-588a18706c35" providerId="ADAL" clId="{73BA1FA4-9FF7-406E-A355-CA3B9319D1EF}" dt="2022-02-18T23:01:00.990" v="450" actId="164"/>
          <ac:spMkLst>
            <pc:docMk/>
            <pc:sldMk cId="3951076637" sldId="279"/>
            <ac:spMk id="42" creationId="{A79F5BC6-9DE1-45AC-8C5E-EB61788D4266}"/>
          </ac:spMkLst>
        </pc:spChg>
        <pc:spChg chg="add mod">
          <ac:chgData name="Yang, Shengming - ARS" userId="37bd5b25-7571-49cb-bfc8-588a18706c35" providerId="ADAL" clId="{73BA1FA4-9FF7-406E-A355-CA3B9319D1EF}" dt="2022-02-18T23:01:00.990" v="450" actId="164"/>
          <ac:spMkLst>
            <pc:docMk/>
            <pc:sldMk cId="3951076637" sldId="279"/>
            <ac:spMk id="43" creationId="{2231B456-CD2F-4FDF-90E8-3764DE82DFC0}"/>
          </ac:spMkLst>
        </pc:spChg>
        <pc:spChg chg="add mod">
          <ac:chgData name="Yang, Shengming - ARS" userId="37bd5b25-7571-49cb-bfc8-588a18706c35" providerId="ADAL" clId="{73BA1FA4-9FF7-406E-A355-CA3B9319D1EF}" dt="2022-02-18T23:01:00.990" v="450" actId="164"/>
          <ac:spMkLst>
            <pc:docMk/>
            <pc:sldMk cId="3951076637" sldId="279"/>
            <ac:spMk id="44" creationId="{E2D00A27-FE20-4DDC-AF85-E2C84AB2F70D}"/>
          </ac:spMkLst>
        </pc:spChg>
        <pc:grpChg chg="add mod">
          <ac:chgData name="Yang, Shengming - ARS" userId="37bd5b25-7571-49cb-bfc8-588a18706c35" providerId="ADAL" clId="{73BA1FA4-9FF7-406E-A355-CA3B9319D1EF}" dt="2022-02-18T23:01:00.990" v="450" actId="164"/>
          <ac:grpSpMkLst>
            <pc:docMk/>
            <pc:sldMk cId="3951076637" sldId="279"/>
            <ac:grpSpMk id="49" creationId="{C0231E8A-E728-4F57-9567-B5F93B699AA5}"/>
          </ac:grpSpMkLst>
        </pc:grpChg>
        <pc:graphicFrameChg chg="add mod">
          <ac:chgData name="Yang, Shengming - ARS" userId="37bd5b25-7571-49cb-bfc8-588a18706c35" providerId="ADAL" clId="{73BA1FA4-9FF7-406E-A355-CA3B9319D1EF}" dt="2022-02-18T22:52:16.523" v="343" actId="1076"/>
          <ac:graphicFrameMkLst>
            <pc:docMk/>
            <pc:sldMk cId="3951076637" sldId="279"/>
            <ac:graphicFrameMk id="36" creationId="{6F1D622B-363F-4DE5-B31A-0E65AA636F7D}"/>
          </ac:graphicFrameMkLst>
        </pc:graphicFrameChg>
        <pc:picChg chg="add del mod">
          <ac:chgData name="Yang, Shengming - ARS" userId="37bd5b25-7571-49cb-bfc8-588a18706c35" providerId="ADAL" clId="{73BA1FA4-9FF7-406E-A355-CA3B9319D1EF}" dt="2022-02-18T22:54:36.355" v="344" actId="478"/>
          <ac:picMkLst>
            <pc:docMk/>
            <pc:sldMk cId="3951076637" sldId="279"/>
            <ac:picMk id="3" creationId="{7B91685B-8DE6-4902-B8D9-81B59B5BD5C3}"/>
          </ac:picMkLst>
        </pc:picChg>
        <pc:picChg chg="del">
          <ac:chgData name="Yang, Shengming - ARS" userId="37bd5b25-7571-49cb-bfc8-588a18706c35" providerId="ADAL" clId="{73BA1FA4-9FF7-406E-A355-CA3B9319D1EF}" dt="2022-02-18T20:31:15.587" v="326" actId="478"/>
          <ac:picMkLst>
            <pc:docMk/>
            <pc:sldMk cId="3951076637" sldId="279"/>
            <ac:picMk id="30" creationId="{121D0B31-5F7E-439F-8FDF-148E33A12C9B}"/>
          </ac:picMkLst>
        </pc:picChg>
        <pc:picChg chg="add del mod">
          <ac:chgData name="Yang, Shengming - ARS" userId="37bd5b25-7571-49cb-bfc8-588a18706c35" providerId="ADAL" clId="{73BA1FA4-9FF7-406E-A355-CA3B9319D1EF}" dt="2022-02-18T22:55:24.075" v="357" actId="478"/>
          <ac:picMkLst>
            <pc:docMk/>
            <pc:sldMk cId="3951076637" sldId="279"/>
            <ac:picMk id="38" creationId="{3A404D67-7746-4FA5-A122-B9C6E43B7DAC}"/>
          </ac:picMkLst>
        </pc:picChg>
        <pc:picChg chg="add del mod">
          <ac:chgData name="Yang, Shengming - ARS" userId="37bd5b25-7571-49cb-bfc8-588a18706c35" providerId="ADAL" clId="{73BA1FA4-9FF7-406E-A355-CA3B9319D1EF}" dt="2022-02-18T22:59:23.288" v="412" actId="478"/>
          <ac:picMkLst>
            <pc:docMk/>
            <pc:sldMk cId="3951076637" sldId="279"/>
            <ac:picMk id="40" creationId="{0558C519-C7B8-4D34-A691-5F2031D93DD7}"/>
          </ac:picMkLst>
        </pc:picChg>
        <pc:picChg chg="add del mod">
          <ac:chgData name="Yang, Shengming - ARS" userId="37bd5b25-7571-49cb-bfc8-588a18706c35" providerId="ADAL" clId="{73BA1FA4-9FF7-406E-A355-CA3B9319D1EF}" dt="2022-02-18T22:59:12.193" v="409" actId="478"/>
          <ac:picMkLst>
            <pc:docMk/>
            <pc:sldMk cId="3951076637" sldId="279"/>
            <ac:picMk id="46" creationId="{E9CE3130-ED48-41A3-9877-B3993AC33B90}"/>
          </ac:picMkLst>
        </pc:picChg>
        <pc:picChg chg="add mod ord">
          <ac:chgData name="Yang, Shengming - ARS" userId="37bd5b25-7571-49cb-bfc8-588a18706c35" providerId="ADAL" clId="{73BA1FA4-9FF7-406E-A355-CA3B9319D1EF}" dt="2022-02-18T23:01:00.990" v="450" actId="164"/>
          <ac:picMkLst>
            <pc:docMk/>
            <pc:sldMk cId="3951076637" sldId="279"/>
            <ac:picMk id="48" creationId="{F67EFA2E-A2AE-409F-8ED6-2ABC8981BF59}"/>
          </ac:picMkLst>
        </pc:picChg>
      </pc:sldChg>
      <pc:sldChg chg="ord">
        <pc:chgData name="Yang, Shengming - ARS" userId="37bd5b25-7571-49cb-bfc8-588a18706c35" providerId="ADAL" clId="{73BA1FA4-9FF7-406E-A355-CA3B9319D1EF}" dt="2022-02-18T18:50:00.384" v="230"/>
        <pc:sldMkLst>
          <pc:docMk/>
          <pc:sldMk cId="2943728638" sldId="280"/>
        </pc:sldMkLst>
      </pc:sldChg>
      <pc:sldChg chg="addSp delSp modSp mod modNotesTx">
        <pc:chgData name="Yang, Shengming - ARS" userId="37bd5b25-7571-49cb-bfc8-588a18706c35" providerId="ADAL" clId="{73BA1FA4-9FF7-406E-A355-CA3B9319D1EF}" dt="2022-02-18T18:54:45.639" v="263"/>
        <pc:sldMkLst>
          <pc:docMk/>
          <pc:sldMk cId="1658013936" sldId="287"/>
        </pc:sldMkLst>
        <pc:spChg chg="mod">
          <ac:chgData name="Yang, Shengming - ARS" userId="37bd5b25-7571-49cb-bfc8-588a18706c35" providerId="ADAL" clId="{73BA1FA4-9FF7-406E-A355-CA3B9319D1EF}" dt="2022-02-18T18:09:30.281" v="196" actId="1038"/>
          <ac:spMkLst>
            <pc:docMk/>
            <pc:sldMk cId="1658013936" sldId="287"/>
            <ac:spMk id="16" creationId="{B7B2EC02-8BA0-46AE-94E8-3EAFFE586302}"/>
          </ac:spMkLst>
        </pc:spChg>
        <pc:spChg chg="mod">
          <ac:chgData name="Yang, Shengming - ARS" userId="37bd5b25-7571-49cb-bfc8-588a18706c35" providerId="ADAL" clId="{73BA1FA4-9FF7-406E-A355-CA3B9319D1EF}" dt="2022-02-18T18:11:48.694" v="212" actId="1076"/>
          <ac:spMkLst>
            <pc:docMk/>
            <pc:sldMk cId="1658013936" sldId="287"/>
            <ac:spMk id="18" creationId="{DB4A7B80-04F4-4694-9635-269D7B93FAB8}"/>
          </ac:spMkLst>
        </pc:spChg>
        <pc:spChg chg="mod">
          <ac:chgData name="Yang, Shengming - ARS" userId="37bd5b25-7571-49cb-bfc8-588a18706c35" providerId="ADAL" clId="{73BA1FA4-9FF7-406E-A355-CA3B9319D1EF}" dt="2022-02-18T18:53:52.030" v="260" actId="20577"/>
          <ac:spMkLst>
            <pc:docMk/>
            <pc:sldMk cId="1658013936" sldId="287"/>
            <ac:spMk id="26" creationId="{557EC437-7B38-4A6E-97F8-966514E076E1}"/>
          </ac:spMkLst>
        </pc:spChg>
        <pc:spChg chg="mod">
          <ac:chgData name="Yang, Shengming - ARS" userId="37bd5b25-7571-49cb-bfc8-588a18706c35" providerId="ADAL" clId="{73BA1FA4-9FF7-406E-A355-CA3B9319D1EF}" dt="2022-02-18T18:11:38.258" v="211" actId="404"/>
          <ac:spMkLst>
            <pc:docMk/>
            <pc:sldMk cId="1658013936" sldId="287"/>
            <ac:spMk id="27" creationId="{93D67171-A90F-4D90-B3D3-C8C3BD804DF3}"/>
          </ac:spMkLst>
        </pc:spChg>
        <pc:spChg chg="mod">
          <ac:chgData name="Yang, Shengming - ARS" userId="37bd5b25-7571-49cb-bfc8-588a18706c35" providerId="ADAL" clId="{73BA1FA4-9FF7-406E-A355-CA3B9319D1EF}" dt="2022-02-18T18:11:53.188" v="213" actId="1076"/>
          <ac:spMkLst>
            <pc:docMk/>
            <pc:sldMk cId="1658013936" sldId="287"/>
            <ac:spMk id="28" creationId="{D716D1A0-A1CE-4DF1-BF62-0045C30619D6}"/>
          </ac:spMkLst>
        </pc:spChg>
        <pc:spChg chg="add mod">
          <ac:chgData name="Yang, Shengming - ARS" userId="37bd5b25-7571-49cb-bfc8-588a18706c35" providerId="ADAL" clId="{73BA1FA4-9FF7-406E-A355-CA3B9319D1EF}" dt="2022-02-18T18:12:41.391" v="218" actId="1076"/>
          <ac:spMkLst>
            <pc:docMk/>
            <pc:sldMk cId="1658013936" sldId="287"/>
            <ac:spMk id="40" creationId="{4ADC4297-4F6D-4975-858B-B7B53439234C}"/>
          </ac:spMkLst>
        </pc:spChg>
        <pc:spChg chg="add mod">
          <ac:chgData name="Yang, Shengming - ARS" userId="37bd5b25-7571-49cb-bfc8-588a18706c35" providerId="ADAL" clId="{73BA1FA4-9FF7-406E-A355-CA3B9319D1EF}" dt="2022-02-18T17:43:21.363" v="157" actId="20577"/>
          <ac:spMkLst>
            <pc:docMk/>
            <pc:sldMk cId="1658013936" sldId="287"/>
            <ac:spMk id="41" creationId="{0EAC1524-5625-450E-8543-B43575C52F5D}"/>
          </ac:spMkLst>
        </pc:spChg>
        <pc:spChg chg="add mod">
          <ac:chgData name="Yang, Shengming - ARS" userId="37bd5b25-7571-49cb-bfc8-588a18706c35" providerId="ADAL" clId="{73BA1FA4-9FF7-406E-A355-CA3B9319D1EF}" dt="2022-02-18T18:12:00.354" v="215" actId="1076"/>
          <ac:spMkLst>
            <pc:docMk/>
            <pc:sldMk cId="1658013936" sldId="287"/>
            <ac:spMk id="44" creationId="{979412E0-B832-4DC7-B7B2-06AAE60DED71}"/>
          </ac:spMkLst>
        </pc:spChg>
        <pc:graphicFrameChg chg="add mod">
          <ac:chgData name="Yang, Shengming - ARS" userId="37bd5b25-7571-49cb-bfc8-588a18706c35" providerId="ADAL" clId="{73BA1FA4-9FF7-406E-A355-CA3B9319D1EF}" dt="2022-02-18T18:54:45.639" v="263"/>
          <ac:graphicFrameMkLst>
            <pc:docMk/>
            <pc:sldMk cId="1658013936" sldId="287"/>
            <ac:graphicFrameMk id="34" creationId="{C87DD994-6237-4F88-AF77-8EF5403E3B8C}"/>
          </ac:graphicFrameMkLst>
        </pc:graphicFrameChg>
        <pc:picChg chg="mod">
          <ac:chgData name="Yang, Shengming - ARS" userId="37bd5b25-7571-49cb-bfc8-588a18706c35" providerId="ADAL" clId="{73BA1FA4-9FF7-406E-A355-CA3B9319D1EF}" dt="2022-02-18T18:09:30.281" v="196" actId="1038"/>
          <ac:picMkLst>
            <pc:docMk/>
            <pc:sldMk cId="1658013936" sldId="287"/>
            <ac:picMk id="14" creationId="{4FE97BDE-EC44-4359-BC83-63F3A53D94A1}"/>
          </ac:picMkLst>
        </pc:picChg>
        <pc:cxnChg chg="mod">
          <ac:chgData name="Yang, Shengming - ARS" userId="37bd5b25-7571-49cb-bfc8-588a18706c35" providerId="ADAL" clId="{73BA1FA4-9FF7-406E-A355-CA3B9319D1EF}" dt="2022-02-18T18:09:30.281" v="196" actId="1038"/>
          <ac:cxnSpMkLst>
            <pc:docMk/>
            <pc:sldMk cId="1658013936" sldId="287"/>
            <ac:cxnSpMk id="4" creationId="{7323C978-CD2D-4425-8B78-301E4142303F}"/>
          </ac:cxnSpMkLst>
        </pc:cxnChg>
        <pc:cxnChg chg="mod">
          <ac:chgData name="Yang, Shengming - ARS" userId="37bd5b25-7571-49cb-bfc8-588a18706c35" providerId="ADAL" clId="{73BA1FA4-9FF7-406E-A355-CA3B9319D1EF}" dt="2022-02-18T18:08:10.309" v="194" actId="1037"/>
          <ac:cxnSpMkLst>
            <pc:docMk/>
            <pc:sldMk cId="1658013936" sldId="287"/>
            <ac:cxnSpMk id="12" creationId="{CF8AF98E-D611-4EE4-B63B-47ABEAA70C8D}"/>
          </ac:cxnSpMkLst>
        </pc:cxnChg>
        <pc:cxnChg chg="del">
          <ac:chgData name="Yang, Shengming - ARS" userId="37bd5b25-7571-49cb-bfc8-588a18706c35" providerId="ADAL" clId="{73BA1FA4-9FF7-406E-A355-CA3B9319D1EF}" dt="2022-02-17T22:34:13.514" v="30" actId="478"/>
          <ac:cxnSpMkLst>
            <pc:docMk/>
            <pc:sldMk cId="1658013936" sldId="287"/>
            <ac:cxnSpMk id="34" creationId="{CD9C69E7-995C-432C-8155-C8741858946E}"/>
          </ac:cxnSpMkLst>
        </pc:cxnChg>
      </pc:sldChg>
      <pc:sldChg chg="addSp delSp modSp new mod">
        <pc:chgData name="Yang, Shengming - ARS" userId="37bd5b25-7571-49cb-bfc8-588a18706c35" providerId="ADAL" clId="{73BA1FA4-9FF7-406E-A355-CA3B9319D1EF}" dt="2022-02-24T03:31:32.621" v="518"/>
        <pc:sldMkLst>
          <pc:docMk/>
          <pc:sldMk cId="4208113970" sldId="288"/>
        </pc:sldMkLst>
        <pc:spChg chg="del">
          <ac:chgData name="Yang, Shengming - ARS" userId="37bd5b25-7571-49cb-bfc8-588a18706c35" providerId="ADAL" clId="{73BA1FA4-9FF7-406E-A355-CA3B9319D1EF}" dt="2022-02-17T22:56:40.548" v="38" actId="478"/>
          <ac:spMkLst>
            <pc:docMk/>
            <pc:sldMk cId="4208113970" sldId="288"/>
            <ac:spMk id="2" creationId="{AB29608C-B853-438A-AFEF-6F59DA25799B}"/>
          </ac:spMkLst>
        </pc:spChg>
        <pc:spChg chg="del">
          <ac:chgData name="Yang, Shengming - ARS" userId="37bd5b25-7571-49cb-bfc8-588a18706c35" providerId="ADAL" clId="{73BA1FA4-9FF7-406E-A355-CA3B9319D1EF}" dt="2022-02-17T22:56:40.548" v="38" actId="478"/>
          <ac:spMkLst>
            <pc:docMk/>
            <pc:sldMk cId="4208113970" sldId="288"/>
            <ac:spMk id="3" creationId="{7906FE8C-7117-4FEF-BF3B-783125544883}"/>
          </ac:spMkLst>
        </pc:spChg>
        <pc:picChg chg="add del mod modCrop">
          <ac:chgData name="Yang, Shengming - ARS" userId="37bd5b25-7571-49cb-bfc8-588a18706c35" providerId="ADAL" clId="{73BA1FA4-9FF7-406E-A355-CA3B9319D1EF}" dt="2022-02-17T23:04:35.997" v="123" actId="478"/>
          <ac:picMkLst>
            <pc:docMk/>
            <pc:sldMk cId="4208113970" sldId="288"/>
            <ac:picMk id="5" creationId="{9643421D-CC3A-4AB9-84DA-85489BF54172}"/>
          </ac:picMkLst>
        </pc:picChg>
        <pc:picChg chg="add del mod modCrop">
          <ac:chgData name="Yang, Shengming - ARS" userId="37bd5b25-7571-49cb-bfc8-588a18706c35" providerId="ADAL" clId="{73BA1FA4-9FF7-406E-A355-CA3B9319D1EF}" dt="2022-02-17T23:04:49.307" v="127" actId="478"/>
          <ac:picMkLst>
            <pc:docMk/>
            <pc:sldMk cId="4208113970" sldId="288"/>
            <ac:picMk id="7" creationId="{4130D544-0AFF-4C09-8DFD-EEDB9373AD51}"/>
          </ac:picMkLst>
        </pc:picChg>
        <pc:picChg chg="add del mod modCrop">
          <ac:chgData name="Yang, Shengming - ARS" userId="37bd5b25-7571-49cb-bfc8-588a18706c35" providerId="ADAL" clId="{73BA1FA4-9FF7-406E-A355-CA3B9319D1EF}" dt="2022-02-17T23:04:17.804" v="117" actId="478"/>
          <ac:picMkLst>
            <pc:docMk/>
            <pc:sldMk cId="4208113970" sldId="288"/>
            <ac:picMk id="9" creationId="{C5B88DC7-B98B-477C-B267-D0F84E4D58E2}"/>
          </ac:picMkLst>
        </pc:picChg>
        <pc:picChg chg="add del mod">
          <ac:chgData name="Yang, Shengming - ARS" userId="37bd5b25-7571-49cb-bfc8-588a18706c35" providerId="ADAL" clId="{73BA1FA4-9FF7-406E-A355-CA3B9319D1EF}" dt="2022-02-17T23:04:57.755" v="128" actId="478"/>
          <ac:picMkLst>
            <pc:docMk/>
            <pc:sldMk cId="4208113970" sldId="288"/>
            <ac:picMk id="10" creationId="{21D12051-BEF0-4E1F-8275-3E630826FCA4}"/>
          </ac:picMkLst>
        </pc:picChg>
        <pc:picChg chg="add mod">
          <ac:chgData name="Yang, Shengming - ARS" userId="37bd5b25-7571-49cb-bfc8-588a18706c35" providerId="ADAL" clId="{73BA1FA4-9FF7-406E-A355-CA3B9319D1EF}" dt="2022-02-24T03:31:32.621" v="518"/>
          <ac:picMkLst>
            <pc:docMk/>
            <pc:sldMk cId="4208113970" sldId="288"/>
            <ac:picMk id="11" creationId="{61543F96-5AEF-48F7-A896-6222CD062B93}"/>
          </ac:picMkLst>
        </pc:picChg>
        <pc:picChg chg="add del mod">
          <ac:chgData name="Yang, Shengming - ARS" userId="37bd5b25-7571-49cb-bfc8-588a18706c35" providerId="ADAL" clId="{73BA1FA4-9FF7-406E-A355-CA3B9319D1EF}" dt="2022-02-17T23:04:31.275" v="120" actId="478"/>
          <ac:picMkLst>
            <pc:docMk/>
            <pc:sldMk cId="4208113970" sldId="288"/>
            <ac:picMk id="12" creationId="{43BB6166-12AA-4DD3-A391-731074169C10}"/>
          </ac:picMkLst>
        </pc:picChg>
        <pc:picChg chg="add mod">
          <ac:chgData name="Yang, Shengming - ARS" userId="37bd5b25-7571-49cb-bfc8-588a18706c35" providerId="ADAL" clId="{73BA1FA4-9FF7-406E-A355-CA3B9319D1EF}" dt="2022-02-18T18:33:48.468" v="227" actId="1076"/>
          <ac:picMkLst>
            <pc:docMk/>
            <pc:sldMk cId="4208113970" sldId="288"/>
            <ac:picMk id="13" creationId="{7C857758-7BB1-4B2C-9389-B4776791175A}"/>
          </ac:picMkLst>
        </pc:picChg>
        <pc:picChg chg="add mod">
          <ac:chgData name="Yang, Shengming - ARS" userId="37bd5b25-7571-49cb-bfc8-588a18706c35" providerId="ADAL" clId="{73BA1FA4-9FF7-406E-A355-CA3B9319D1EF}" dt="2022-02-24T03:26:49.701" v="486" actId="1038"/>
          <ac:picMkLst>
            <pc:docMk/>
            <pc:sldMk cId="4208113970" sldId="288"/>
            <ac:picMk id="14" creationId="{378C07F1-338D-484D-AC20-21B17222885B}"/>
          </ac:picMkLst>
        </pc:picChg>
      </pc:sldChg>
      <pc:sldChg chg="add">
        <pc:chgData name="Yang, Shengming - ARS" userId="37bd5b25-7571-49cb-bfc8-588a18706c35" providerId="ADAL" clId="{73BA1FA4-9FF7-406E-A355-CA3B9319D1EF}" dt="2022-02-17T23:04:07.538" v="114" actId="2890"/>
        <pc:sldMkLst>
          <pc:docMk/>
          <pc:sldMk cId="3220999384" sldId="289"/>
        </pc:sldMkLst>
      </pc:sldChg>
      <pc:sldChg chg="addSp delSp modSp new mod">
        <pc:chgData name="Yang, Shengming - ARS" userId="37bd5b25-7571-49cb-bfc8-588a18706c35" providerId="ADAL" clId="{73BA1FA4-9FF7-406E-A355-CA3B9319D1EF}" dt="2022-02-18T20:25:13.632" v="325" actId="1076"/>
        <pc:sldMkLst>
          <pc:docMk/>
          <pc:sldMk cId="2200906561" sldId="290"/>
        </pc:sldMkLst>
        <pc:spChg chg="del">
          <ac:chgData name="Yang, Shengming - ARS" userId="37bd5b25-7571-49cb-bfc8-588a18706c35" providerId="ADAL" clId="{73BA1FA4-9FF7-406E-A355-CA3B9319D1EF}" dt="2022-02-18T19:21:45.231" v="265" actId="478"/>
          <ac:spMkLst>
            <pc:docMk/>
            <pc:sldMk cId="2200906561" sldId="290"/>
            <ac:spMk id="2" creationId="{F10849D5-9DED-4EA6-8B9F-BB67DCD598CD}"/>
          </ac:spMkLst>
        </pc:spChg>
        <pc:spChg chg="del">
          <ac:chgData name="Yang, Shengming - ARS" userId="37bd5b25-7571-49cb-bfc8-588a18706c35" providerId="ADAL" clId="{73BA1FA4-9FF7-406E-A355-CA3B9319D1EF}" dt="2022-02-18T19:21:45.231" v="265" actId="478"/>
          <ac:spMkLst>
            <pc:docMk/>
            <pc:sldMk cId="2200906561" sldId="290"/>
            <ac:spMk id="3" creationId="{B563AD90-3C4C-48CF-B5D2-F2891A7BEEAF}"/>
          </ac:spMkLst>
        </pc:spChg>
        <pc:spChg chg="add del mod">
          <ac:chgData name="Yang, Shengming - ARS" userId="37bd5b25-7571-49cb-bfc8-588a18706c35" providerId="ADAL" clId="{73BA1FA4-9FF7-406E-A355-CA3B9319D1EF}" dt="2022-02-18T20:24:46.324" v="315" actId="478"/>
          <ac:spMkLst>
            <pc:docMk/>
            <pc:sldMk cId="2200906561" sldId="290"/>
            <ac:spMk id="5" creationId="{093A9F08-7D84-4732-A8C5-9B6F46AD8A45}"/>
          </ac:spMkLst>
        </pc:spChg>
        <pc:spChg chg="add del mod">
          <ac:chgData name="Yang, Shengming - ARS" userId="37bd5b25-7571-49cb-bfc8-588a18706c35" providerId="ADAL" clId="{73BA1FA4-9FF7-406E-A355-CA3B9319D1EF}" dt="2022-02-18T20:24:48.113" v="316" actId="478"/>
          <ac:spMkLst>
            <pc:docMk/>
            <pc:sldMk cId="2200906561" sldId="290"/>
            <ac:spMk id="7" creationId="{ABECF8B5-389F-4E67-881B-A95469EF60AA}"/>
          </ac:spMkLst>
        </pc:spChg>
        <pc:spChg chg="add mod">
          <ac:chgData name="Yang, Shengming - ARS" userId="37bd5b25-7571-49cb-bfc8-588a18706c35" providerId="ADAL" clId="{73BA1FA4-9FF7-406E-A355-CA3B9319D1EF}" dt="2022-02-18T20:25:13.632" v="325" actId="1076"/>
          <ac:spMkLst>
            <pc:docMk/>
            <pc:sldMk cId="2200906561" sldId="290"/>
            <ac:spMk id="9" creationId="{326B85DA-5FEB-49AA-9B1D-779F6E66A986}"/>
          </ac:spMkLst>
        </pc:spChg>
      </pc:sldChg>
    </pc:docChg>
  </pc:docChgLst>
  <pc:docChgLst>
    <pc:chgData name="Yang, Shengming - ARS" userId="37bd5b25-7571-49cb-bfc8-588a18706c35" providerId="ADAL" clId="{8181BEEC-D432-47B7-AEC6-1B03061D2BAA}"/>
    <pc:docChg chg="custSel addSld modSld">
      <pc:chgData name="Yang, Shengming - ARS" userId="37bd5b25-7571-49cb-bfc8-588a18706c35" providerId="ADAL" clId="{8181BEEC-D432-47B7-AEC6-1B03061D2BAA}" dt="2021-11-10T21:34:38.553" v="7" actId="1076"/>
      <pc:docMkLst>
        <pc:docMk/>
      </pc:docMkLst>
      <pc:sldChg chg="addSp delSp modSp new mod">
        <pc:chgData name="Yang, Shengming - ARS" userId="37bd5b25-7571-49cb-bfc8-588a18706c35" providerId="ADAL" clId="{8181BEEC-D432-47B7-AEC6-1B03061D2BAA}" dt="2021-11-10T21:34:38.553" v="7" actId="1076"/>
        <pc:sldMkLst>
          <pc:docMk/>
          <pc:sldMk cId="187198215" sldId="256"/>
        </pc:sldMkLst>
        <pc:spChg chg="del">
          <ac:chgData name="Yang, Shengming - ARS" userId="37bd5b25-7571-49cb-bfc8-588a18706c35" providerId="ADAL" clId="{8181BEEC-D432-47B7-AEC6-1B03061D2BAA}" dt="2021-11-10T21:34:14.537" v="1" actId="478"/>
          <ac:spMkLst>
            <pc:docMk/>
            <pc:sldMk cId="187198215" sldId="256"/>
            <ac:spMk id="2" creationId="{174C92CA-D17C-4B68-8E47-43F55709FDB0}"/>
          </ac:spMkLst>
        </pc:spChg>
        <pc:spChg chg="del">
          <ac:chgData name="Yang, Shengming - ARS" userId="37bd5b25-7571-49cb-bfc8-588a18706c35" providerId="ADAL" clId="{8181BEEC-D432-47B7-AEC6-1B03061D2BAA}" dt="2021-11-10T21:34:14.537" v="1" actId="478"/>
          <ac:spMkLst>
            <pc:docMk/>
            <pc:sldMk cId="187198215" sldId="256"/>
            <ac:spMk id="3" creationId="{99198A80-0D7E-4A14-B7CD-CC59C9537C7F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8" creationId="{7A85EE01-37A5-48DD-82B2-CC61EFCB05A6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4" creationId="{8E1BB1BC-4655-4667-9A9A-9388A8CD0B6A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5" creationId="{9245E1A8-7BA6-44DB-9AB5-CC7429F5BAB9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6" creationId="{14ACD6D4-6C84-4831-98FA-1D0760256699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7" creationId="{4F8D18C1-A3FB-49E5-9800-8A0CDAAC9A06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8" creationId="{55FC71C1-3FE7-4850-AC87-2D5CC70E4B67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29" creationId="{C72ED974-59CB-4AC2-A042-C083C26196DF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30" creationId="{3588F8F0-AE71-4D43-A1BE-9835CB267077}"/>
          </ac:spMkLst>
        </pc:spChg>
        <pc:spChg chg="mod">
          <ac:chgData name="Yang, Shengming - ARS" userId="37bd5b25-7571-49cb-bfc8-588a18706c35" providerId="ADAL" clId="{8181BEEC-D432-47B7-AEC6-1B03061D2BAA}" dt="2021-11-10T21:34:34.407" v="5" actId="255"/>
          <ac:spMkLst>
            <pc:docMk/>
            <pc:sldMk cId="187198215" sldId="256"/>
            <ac:spMk id="31" creationId="{F216FF89-0AA4-4565-88C4-DA0A12A877DC}"/>
          </ac:spMkLst>
        </pc:spChg>
        <pc:grpChg chg="add mod">
          <ac:chgData name="Yang, Shengming - ARS" userId="37bd5b25-7571-49cb-bfc8-588a18706c35" providerId="ADAL" clId="{8181BEEC-D432-47B7-AEC6-1B03061D2BAA}" dt="2021-11-10T21:34:38.553" v="7" actId="1076"/>
          <ac:grpSpMkLst>
            <pc:docMk/>
            <pc:sldMk cId="187198215" sldId="256"/>
            <ac:grpSpMk id="4" creationId="{4713D267-1D1C-445B-9270-5911825C9C0B}"/>
          </ac:grpSpMkLst>
        </pc:grpChg>
        <pc:grpChg chg="mod">
          <ac:chgData name="Yang, Shengming - ARS" userId="37bd5b25-7571-49cb-bfc8-588a18706c35" providerId="ADAL" clId="{8181BEEC-D432-47B7-AEC6-1B03061D2BAA}" dt="2021-11-10T21:34:16.857" v="2"/>
          <ac:grpSpMkLst>
            <pc:docMk/>
            <pc:sldMk cId="187198215" sldId="256"/>
            <ac:grpSpMk id="5" creationId="{F740D394-183F-4D4D-AA43-7211E88DC47D}"/>
          </ac:grpSpMkLst>
        </pc:grpChg>
        <pc:grpChg chg="mod">
          <ac:chgData name="Yang, Shengming - ARS" userId="37bd5b25-7571-49cb-bfc8-588a18706c35" providerId="ADAL" clId="{8181BEEC-D432-47B7-AEC6-1B03061D2BAA}" dt="2021-11-10T21:34:16.857" v="2"/>
          <ac:grpSpMkLst>
            <pc:docMk/>
            <pc:sldMk cId="187198215" sldId="256"/>
            <ac:grpSpMk id="6" creationId="{300C27BE-E024-44B7-B7B1-E5B56F1A2728}"/>
          </ac:grpSpMkLst>
        </pc:grpChg>
        <pc:grpChg chg="mod">
          <ac:chgData name="Yang, Shengming - ARS" userId="37bd5b25-7571-49cb-bfc8-588a18706c35" providerId="ADAL" clId="{8181BEEC-D432-47B7-AEC6-1B03061D2BAA}" dt="2021-11-10T21:34:16.857" v="2"/>
          <ac:grpSpMkLst>
            <pc:docMk/>
            <pc:sldMk cId="187198215" sldId="256"/>
            <ac:grpSpMk id="7" creationId="{027E727B-2E96-4A7D-B302-E1E15EE0C686}"/>
          </ac:grpSpMkLst>
        </pc:grp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9" creationId="{6B11905C-7860-49DB-83C0-E8C0A4A15334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0" creationId="{0C107A29-8CB4-46AF-B036-5F67B9237BA9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1" creationId="{FE47F660-E864-4926-86A4-2F616104C257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2" creationId="{B5026062-0D1F-4D3F-BDD8-307A2A8AC7D0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3" creationId="{0ABC98F5-E4B4-42A9-8A4D-75C0DF8065D5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4" creationId="{817A2E5B-A163-48E2-8F8F-C01CDE89880D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5" creationId="{EB9E6CC9-A9C2-4546-845B-C3E705049554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6" creationId="{C681FB39-0F8F-4BEB-B08F-18348E347E74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7" creationId="{BF74E94F-9465-49FC-8A6F-F44500C94FDD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8" creationId="{BFF432DA-5E76-4E26-993C-DA37D1DD5254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19" creationId="{BF6A49B2-E203-4E5B-B9CF-2CE2B4643E6B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20" creationId="{B7B5B9D5-40CB-427A-AF7A-E528C995C57A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21" creationId="{B3BBBD8E-0989-478C-B309-A80799A33A67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22" creationId="{937692F3-19F4-4E0F-8FCE-C1AA41913086}"/>
          </ac:cxnSpMkLst>
        </pc:cxnChg>
        <pc:cxnChg chg="mod">
          <ac:chgData name="Yang, Shengming - ARS" userId="37bd5b25-7571-49cb-bfc8-588a18706c35" providerId="ADAL" clId="{8181BEEC-D432-47B7-AEC6-1B03061D2BAA}" dt="2021-11-10T21:34:16.857" v="2"/>
          <ac:cxnSpMkLst>
            <pc:docMk/>
            <pc:sldMk cId="187198215" sldId="256"/>
            <ac:cxnSpMk id="23" creationId="{1D4DE95D-5E32-439B-AF44-9C6A8818970C}"/>
          </ac:cxnSpMkLst>
        </pc:cxnChg>
      </pc:sldChg>
    </pc:docChg>
  </pc:docChgLst>
  <pc:docChgLst>
    <pc:chgData name="Yang, Shengming - ARS" userId="37bd5b25-7571-49cb-bfc8-588a18706c35" providerId="ADAL" clId="{AE56A9E5-EE4C-4DAB-B208-155664F2B8E0}"/>
    <pc:docChg chg="modSld">
      <pc:chgData name="Yang, Shengming - ARS" userId="37bd5b25-7571-49cb-bfc8-588a18706c35" providerId="ADAL" clId="{AE56A9E5-EE4C-4DAB-B208-155664F2B8E0}" dt="2021-11-11T21:59:36.790" v="6" actId="1076"/>
      <pc:docMkLst>
        <pc:docMk/>
      </pc:docMkLst>
      <pc:sldChg chg="modSp mod">
        <pc:chgData name="Yang, Shengming - ARS" userId="37bd5b25-7571-49cb-bfc8-588a18706c35" providerId="ADAL" clId="{AE56A9E5-EE4C-4DAB-B208-155664F2B8E0}" dt="2021-11-11T21:59:36.790" v="6" actId="1076"/>
        <pc:sldMkLst>
          <pc:docMk/>
          <pc:sldMk cId="187198215" sldId="256"/>
        </pc:sldMkLst>
        <pc:grpChg chg="mod">
          <ac:chgData name="Yang, Shengming - ARS" userId="37bd5b25-7571-49cb-bfc8-588a18706c35" providerId="ADAL" clId="{AE56A9E5-EE4C-4DAB-B208-155664F2B8E0}" dt="2021-11-11T21:59:36.790" v="6" actId="1076"/>
          <ac:grpSpMkLst>
            <pc:docMk/>
            <pc:sldMk cId="187198215" sldId="256"/>
            <ac:grpSpMk id="4" creationId="{4713D267-1D1C-445B-9270-5911825C9C0B}"/>
          </ac:grpSpMkLst>
        </pc:grpChg>
      </pc:sldChg>
    </pc:docChg>
  </pc:docChgLst>
  <pc:docChgLst>
    <pc:chgData name="Yang, Shengming - ARS" userId="37bd5b25-7571-49cb-bfc8-588a18706c35" providerId="ADAL" clId="{1CEC4EA3-DB05-44BE-AF57-7E2779412AED}"/>
    <pc:docChg chg="undo redo custSel addSld modSld sldOrd">
      <pc:chgData name="Yang, Shengming - ARS" userId="37bd5b25-7571-49cb-bfc8-588a18706c35" providerId="ADAL" clId="{1CEC4EA3-DB05-44BE-AF57-7E2779412AED}" dt="2021-12-23T19:45:07.913" v="2112" actId="1037"/>
      <pc:docMkLst>
        <pc:docMk/>
      </pc:docMkLst>
      <pc:sldChg chg="ord">
        <pc:chgData name="Yang, Shengming - ARS" userId="37bd5b25-7571-49cb-bfc8-588a18706c35" providerId="ADAL" clId="{1CEC4EA3-DB05-44BE-AF57-7E2779412AED}" dt="2021-12-22T20:53:48.615" v="2098"/>
        <pc:sldMkLst>
          <pc:docMk/>
          <pc:sldMk cId="187198215" sldId="256"/>
        </pc:sldMkLst>
      </pc:sldChg>
      <pc:sldChg chg="addSp delSp modSp mod">
        <pc:chgData name="Yang, Shengming - ARS" userId="37bd5b25-7571-49cb-bfc8-588a18706c35" providerId="ADAL" clId="{1CEC4EA3-DB05-44BE-AF57-7E2779412AED}" dt="2021-12-02T22:13:06.346" v="1082" actId="478"/>
        <pc:sldMkLst>
          <pc:docMk/>
          <pc:sldMk cId="1525299809" sldId="275"/>
        </pc:sldMkLst>
        <pc:spChg chg="mod">
          <ac:chgData name="Yang, Shengming - ARS" userId="37bd5b25-7571-49cb-bfc8-588a18706c35" providerId="ADAL" clId="{1CEC4EA3-DB05-44BE-AF57-7E2779412AED}" dt="2021-12-02T22:12:18.547" v="1079" actId="1076"/>
          <ac:spMkLst>
            <pc:docMk/>
            <pc:sldMk cId="1525299809" sldId="275"/>
            <ac:spMk id="7" creationId="{59EC5E2F-A06C-44C2-9BC7-5083B8DB0158}"/>
          </ac:spMkLst>
        </pc:spChg>
        <pc:spChg chg="mod">
          <ac:chgData name="Yang, Shengming - ARS" userId="37bd5b25-7571-49cb-bfc8-588a18706c35" providerId="ADAL" clId="{1CEC4EA3-DB05-44BE-AF57-7E2779412AED}" dt="2021-12-02T22:12:18.547" v="1079" actId="1076"/>
          <ac:spMkLst>
            <pc:docMk/>
            <pc:sldMk cId="1525299809" sldId="275"/>
            <ac:spMk id="12" creationId="{521E7359-7336-437C-8A90-B14583285988}"/>
          </ac:spMkLst>
        </pc:spChg>
        <pc:spChg chg="mod">
          <ac:chgData name="Yang, Shengming - ARS" userId="37bd5b25-7571-49cb-bfc8-588a18706c35" providerId="ADAL" clId="{1CEC4EA3-DB05-44BE-AF57-7E2779412AED}" dt="2021-12-01T23:59:58.370" v="985" actId="1035"/>
          <ac:spMkLst>
            <pc:docMk/>
            <pc:sldMk cId="1525299809" sldId="275"/>
            <ac:spMk id="13" creationId="{50A0EE90-3932-4530-A2F6-B29B53FA3754}"/>
          </ac:spMkLst>
        </pc:spChg>
        <pc:spChg chg="add del mod">
          <ac:chgData name="Yang, Shengming - ARS" userId="37bd5b25-7571-49cb-bfc8-588a18706c35" providerId="ADAL" clId="{1CEC4EA3-DB05-44BE-AF57-7E2779412AED}" dt="2021-12-02T22:13:06.346" v="1082" actId="478"/>
          <ac:spMkLst>
            <pc:docMk/>
            <pc:sldMk cId="1525299809" sldId="275"/>
            <ac:spMk id="14" creationId="{307A9350-3668-45A2-AF7F-F848504A6A35}"/>
          </ac:spMkLst>
        </pc:spChg>
        <pc:spChg chg="mod">
          <ac:chgData name="Yang, Shengming - ARS" userId="37bd5b25-7571-49cb-bfc8-588a18706c35" providerId="ADAL" clId="{1CEC4EA3-DB05-44BE-AF57-7E2779412AED}" dt="2021-12-02T22:12:18.547" v="1079" actId="1076"/>
          <ac:spMkLst>
            <pc:docMk/>
            <pc:sldMk cId="1525299809" sldId="275"/>
            <ac:spMk id="17" creationId="{EF72585C-D2AF-45D3-97AC-199E08312281}"/>
          </ac:spMkLst>
        </pc:spChg>
        <pc:spChg chg="add mod">
          <ac:chgData name="Yang, Shengming - ARS" userId="37bd5b25-7571-49cb-bfc8-588a18706c35" providerId="ADAL" clId="{1CEC4EA3-DB05-44BE-AF57-7E2779412AED}" dt="2021-12-02T22:11:40.562" v="1070" actId="164"/>
          <ac:spMkLst>
            <pc:docMk/>
            <pc:sldMk cId="1525299809" sldId="275"/>
            <ac:spMk id="22" creationId="{4D948ADA-E9AF-42DA-8B05-03DACB9C498C}"/>
          </ac:spMkLst>
        </pc:spChg>
        <pc:spChg chg="mod">
          <ac:chgData name="Yang, Shengming - ARS" userId="37bd5b25-7571-49cb-bfc8-588a18706c35" providerId="ADAL" clId="{1CEC4EA3-DB05-44BE-AF57-7E2779412AED}" dt="2021-12-02T22:12:18.547" v="1079" actId="1076"/>
          <ac:spMkLst>
            <pc:docMk/>
            <pc:sldMk cId="1525299809" sldId="275"/>
            <ac:spMk id="23" creationId="{EE0E463B-8D9C-4CD8-A0EC-C0A58991BB7D}"/>
          </ac:spMkLst>
        </pc:spChg>
        <pc:spChg chg="add mod">
          <ac:chgData name="Yang, Shengming - ARS" userId="37bd5b25-7571-49cb-bfc8-588a18706c35" providerId="ADAL" clId="{1CEC4EA3-DB05-44BE-AF57-7E2779412AED}" dt="2021-12-02T22:11:40.562" v="1070" actId="164"/>
          <ac:spMkLst>
            <pc:docMk/>
            <pc:sldMk cId="1525299809" sldId="275"/>
            <ac:spMk id="24" creationId="{4162F7BC-929B-45B6-BA7F-921891A36F89}"/>
          </ac:spMkLst>
        </pc:spChg>
        <pc:spChg chg="mod">
          <ac:chgData name="Yang, Shengming - ARS" userId="37bd5b25-7571-49cb-bfc8-588a18706c35" providerId="ADAL" clId="{1CEC4EA3-DB05-44BE-AF57-7E2779412AED}" dt="2021-12-02T22:12:18.547" v="1079" actId="1076"/>
          <ac:spMkLst>
            <pc:docMk/>
            <pc:sldMk cId="1525299809" sldId="275"/>
            <ac:spMk id="25" creationId="{A876130B-ED92-4416-90CA-563FA5FCBC5F}"/>
          </ac:spMkLst>
        </pc:spChg>
        <pc:spChg chg="add mod">
          <ac:chgData name="Yang, Shengming - ARS" userId="37bd5b25-7571-49cb-bfc8-588a18706c35" providerId="ADAL" clId="{1CEC4EA3-DB05-44BE-AF57-7E2779412AED}" dt="2021-12-02T22:11:40.562" v="1070" actId="164"/>
          <ac:spMkLst>
            <pc:docMk/>
            <pc:sldMk cId="1525299809" sldId="275"/>
            <ac:spMk id="26" creationId="{B9CCD95B-3889-4379-A2D1-2FC056F98C66}"/>
          </ac:spMkLst>
        </pc:spChg>
        <pc:spChg chg="add mod">
          <ac:chgData name="Yang, Shengming - ARS" userId="37bd5b25-7571-49cb-bfc8-588a18706c35" providerId="ADAL" clId="{1CEC4EA3-DB05-44BE-AF57-7E2779412AED}" dt="2021-12-02T22:11:40.562" v="1070" actId="164"/>
          <ac:spMkLst>
            <pc:docMk/>
            <pc:sldMk cId="1525299809" sldId="275"/>
            <ac:spMk id="27" creationId="{A025DAFC-93D1-4F78-945F-66FA9798F458}"/>
          </ac:spMkLst>
        </pc:spChg>
        <pc:grpChg chg="add mod">
          <ac:chgData name="Yang, Shengming - ARS" userId="37bd5b25-7571-49cb-bfc8-588a18706c35" providerId="ADAL" clId="{1CEC4EA3-DB05-44BE-AF57-7E2779412AED}" dt="2021-12-02T22:12:34.074" v="1080" actId="1076"/>
          <ac:grpSpMkLst>
            <pc:docMk/>
            <pc:sldMk cId="1525299809" sldId="275"/>
            <ac:grpSpMk id="2" creationId="{F4EE9DA4-CB9F-486A-923F-388B16F5FCA0}"/>
          </ac:grpSpMkLst>
        </pc:grpChg>
        <pc:grpChg chg="add mod">
          <ac:chgData name="Yang, Shengming - ARS" userId="37bd5b25-7571-49cb-bfc8-588a18706c35" providerId="ADAL" clId="{1CEC4EA3-DB05-44BE-AF57-7E2779412AED}" dt="2021-12-02T22:11:40.562" v="1070" actId="164"/>
          <ac:grpSpMkLst>
            <pc:docMk/>
            <pc:sldMk cId="1525299809" sldId="275"/>
            <ac:grpSpMk id="16" creationId="{6CE4D0D7-A763-4BAE-8CC2-D0BA38EEC42E}"/>
          </ac:grpSpMkLst>
        </pc:grpChg>
        <pc:picChg chg="add del mod">
          <ac:chgData name="Yang, Shengming - ARS" userId="37bd5b25-7571-49cb-bfc8-588a18706c35" providerId="ADAL" clId="{1CEC4EA3-DB05-44BE-AF57-7E2779412AED}" dt="2021-12-01T23:12:11.258" v="72" actId="22"/>
          <ac:picMkLst>
            <pc:docMk/>
            <pc:sldMk cId="1525299809" sldId="275"/>
            <ac:picMk id="4" creationId="{A80C1CA3-0CE0-465C-A984-55570D653F13}"/>
          </ac:picMkLst>
        </pc:picChg>
        <pc:picChg chg="mod">
          <ac:chgData name="Yang, Shengming - ARS" userId="37bd5b25-7571-49cb-bfc8-588a18706c35" providerId="ADAL" clId="{1CEC4EA3-DB05-44BE-AF57-7E2779412AED}" dt="2021-12-02T22:12:18.547" v="1079" actId="1076"/>
          <ac:picMkLst>
            <pc:docMk/>
            <pc:sldMk cId="1525299809" sldId="275"/>
            <ac:picMk id="5" creationId="{47886F41-8483-490F-AFEC-C9F34925FEB4}"/>
          </ac:picMkLst>
        </pc:picChg>
        <pc:picChg chg="mod">
          <ac:chgData name="Yang, Shengming - ARS" userId="37bd5b25-7571-49cb-bfc8-588a18706c35" providerId="ADAL" clId="{1CEC4EA3-DB05-44BE-AF57-7E2779412AED}" dt="2021-12-02T22:12:18.547" v="1079" actId="1076"/>
          <ac:picMkLst>
            <pc:docMk/>
            <pc:sldMk cId="1525299809" sldId="275"/>
            <ac:picMk id="9" creationId="{8A5CA8A6-E525-4485-ADF9-36221A12B462}"/>
          </ac:picMkLst>
        </pc:picChg>
        <pc:picChg chg="mod">
          <ac:chgData name="Yang, Shengming - ARS" userId="37bd5b25-7571-49cb-bfc8-588a18706c35" providerId="ADAL" clId="{1CEC4EA3-DB05-44BE-AF57-7E2779412AED}" dt="2021-12-02T22:12:18.547" v="1079" actId="1076"/>
          <ac:picMkLst>
            <pc:docMk/>
            <pc:sldMk cId="1525299809" sldId="275"/>
            <ac:picMk id="15" creationId="{59E8A476-E459-49E7-BC90-C0244CB29CE8}"/>
          </ac:picMkLst>
        </pc:picChg>
        <pc:picChg chg="mod">
          <ac:chgData name="Yang, Shengming - ARS" userId="37bd5b25-7571-49cb-bfc8-588a18706c35" providerId="ADAL" clId="{1CEC4EA3-DB05-44BE-AF57-7E2779412AED}" dt="2021-12-02T22:01:43.889" v="1002" actId="14100"/>
          <ac:picMkLst>
            <pc:docMk/>
            <pc:sldMk cId="1525299809" sldId="275"/>
            <ac:picMk id="18" creationId="{DC957572-5F76-4953-A205-6FFE95C92F40}"/>
          </ac:picMkLst>
        </pc:picChg>
        <pc:picChg chg="mod">
          <ac:chgData name="Yang, Shengming - ARS" userId="37bd5b25-7571-49cb-bfc8-588a18706c35" providerId="ADAL" clId="{1CEC4EA3-DB05-44BE-AF57-7E2779412AED}" dt="2021-12-02T22:12:18.547" v="1079" actId="1076"/>
          <ac:picMkLst>
            <pc:docMk/>
            <pc:sldMk cId="1525299809" sldId="275"/>
            <ac:picMk id="19" creationId="{596237EC-86BA-4274-95FA-01770DA46B69}"/>
          </ac:picMkLst>
        </pc:picChg>
        <pc:picChg chg="mod">
          <ac:chgData name="Yang, Shengming - ARS" userId="37bd5b25-7571-49cb-bfc8-588a18706c35" providerId="ADAL" clId="{1CEC4EA3-DB05-44BE-AF57-7E2779412AED}" dt="2021-12-02T22:11:50.317" v="1076" actId="1038"/>
          <ac:picMkLst>
            <pc:docMk/>
            <pc:sldMk cId="1525299809" sldId="275"/>
            <ac:picMk id="20" creationId="{82B004C6-1B02-4AAE-9F53-D06DA1D4183C}"/>
          </ac:picMkLst>
        </pc:picChg>
        <pc:picChg chg="mod">
          <ac:chgData name="Yang, Shengming - ARS" userId="37bd5b25-7571-49cb-bfc8-588a18706c35" providerId="ADAL" clId="{1CEC4EA3-DB05-44BE-AF57-7E2779412AED}" dt="2021-12-02T22:12:18.547" v="1079" actId="1076"/>
          <ac:picMkLst>
            <pc:docMk/>
            <pc:sldMk cId="1525299809" sldId="275"/>
            <ac:picMk id="21" creationId="{678FCA89-43B8-45BE-8851-22EE7A6E7A89}"/>
          </ac:picMkLst>
        </pc:picChg>
      </pc:sldChg>
      <pc:sldChg chg="addSp delSp modSp new mod">
        <pc:chgData name="Yang, Shengming - ARS" userId="37bd5b25-7571-49cb-bfc8-588a18706c35" providerId="ADAL" clId="{1CEC4EA3-DB05-44BE-AF57-7E2779412AED}" dt="2021-12-23T19:45:07.913" v="2112" actId="1037"/>
        <pc:sldMkLst>
          <pc:docMk/>
          <pc:sldMk cId="1327558011" sldId="276"/>
        </pc:sldMkLst>
        <pc:spChg chg="add del">
          <ac:chgData name="Yang, Shengming - ARS" userId="37bd5b25-7571-49cb-bfc8-588a18706c35" providerId="ADAL" clId="{1CEC4EA3-DB05-44BE-AF57-7E2779412AED}" dt="2021-12-01T23:29:52.703" v="78" actId="478"/>
          <ac:spMkLst>
            <pc:docMk/>
            <pc:sldMk cId="1327558011" sldId="276"/>
            <ac:spMk id="2" creationId="{723B58EE-3585-49F8-9A1D-A240C225E60D}"/>
          </ac:spMkLst>
        </pc:spChg>
        <pc:spChg chg="add del">
          <ac:chgData name="Yang, Shengming - ARS" userId="37bd5b25-7571-49cb-bfc8-588a18706c35" providerId="ADAL" clId="{1CEC4EA3-DB05-44BE-AF57-7E2779412AED}" dt="2021-12-01T23:29:52.703" v="78" actId="478"/>
          <ac:spMkLst>
            <pc:docMk/>
            <pc:sldMk cId="1327558011" sldId="276"/>
            <ac:spMk id="3" creationId="{0C1C5AC5-8B83-4B2A-A163-09D2DA7D2269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7" creationId="{7E46E0E5-BB9E-44F8-8D6A-842B44DB0A47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8" creationId="{5460B423-280A-41A1-BE43-A49C3B469594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9" creationId="{00B6E138-4B98-43DD-A293-5FD523EA9044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10" creationId="{6BD9CA6D-B8DE-43F4-A6EC-1D1BC0855CE6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11" creationId="{C0CA89E4-43EC-409B-8E13-87895460CCA5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12" creationId="{2C05E07F-1F0B-45EA-8034-057A3E651EDB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13" creationId="{CCFB574E-0FBA-4402-B656-E883160D1338}"/>
          </ac:spMkLst>
        </pc:spChg>
        <pc:spChg chg="add del mod">
          <ac:chgData name="Yang, Shengming - ARS" userId="37bd5b25-7571-49cb-bfc8-588a18706c35" providerId="ADAL" clId="{1CEC4EA3-DB05-44BE-AF57-7E2779412AED}" dt="2021-12-01T23:29:47.380" v="76"/>
          <ac:spMkLst>
            <pc:docMk/>
            <pc:sldMk cId="1327558011" sldId="276"/>
            <ac:spMk id="14" creationId="{FA463342-9FEF-4297-BF20-D6D64643A751}"/>
          </ac:spMkLst>
        </pc:spChg>
        <pc:spChg chg="add mod">
          <ac:chgData name="Yang, Shengming - ARS" userId="37bd5b25-7571-49cb-bfc8-588a18706c35" providerId="ADAL" clId="{1CEC4EA3-DB05-44BE-AF57-7E2779412AED}" dt="2021-12-22T20:24:14.446" v="2096" actId="14100"/>
          <ac:spMkLst>
            <pc:docMk/>
            <pc:sldMk cId="1327558011" sldId="276"/>
            <ac:spMk id="18" creationId="{DB4A7B80-04F4-4694-9635-269D7B93FAB8}"/>
          </ac:spMkLst>
        </pc:spChg>
        <pc:spChg chg="add mod">
          <ac:chgData name="Yang, Shengming - ARS" userId="37bd5b25-7571-49cb-bfc8-588a18706c35" providerId="ADAL" clId="{1CEC4EA3-DB05-44BE-AF57-7E2779412AED}" dt="2021-12-22T20:18:56.062" v="2028" actId="207"/>
          <ac:spMkLst>
            <pc:docMk/>
            <pc:sldMk cId="1327558011" sldId="276"/>
            <ac:spMk id="19" creationId="{27F8DD3C-80AD-48AB-8EFA-F850B3C34DE3}"/>
          </ac:spMkLst>
        </pc:spChg>
        <pc:spChg chg="add mod">
          <ac:chgData name="Yang, Shengming - ARS" userId="37bd5b25-7571-49cb-bfc8-588a18706c35" providerId="ADAL" clId="{1CEC4EA3-DB05-44BE-AF57-7E2779412AED}" dt="2021-12-01T23:30:19.157" v="82" actId="1076"/>
          <ac:spMkLst>
            <pc:docMk/>
            <pc:sldMk cId="1327558011" sldId="276"/>
            <ac:spMk id="20" creationId="{62CDE6E2-BA1A-48A7-85F8-B39551A96D35}"/>
          </ac:spMkLst>
        </pc:spChg>
        <pc:spChg chg="add mod">
          <ac:chgData name="Yang, Shengming - ARS" userId="37bd5b25-7571-49cb-bfc8-588a18706c35" providerId="ADAL" clId="{1CEC4EA3-DB05-44BE-AF57-7E2779412AED}" dt="2021-12-01T23:30:19.157" v="82" actId="1076"/>
          <ac:spMkLst>
            <pc:docMk/>
            <pc:sldMk cId="1327558011" sldId="276"/>
            <ac:spMk id="21" creationId="{DE08A5F3-A209-4864-B1A4-E0FBE1E8CC2D}"/>
          </ac:spMkLst>
        </pc:spChg>
        <pc:spChg chg="add mod">
          <ac:chgData name="Yang, Shengming - ARS" userId="37bd5b25-7571-49cb-bfc8-588a18706c35" providerId="ADAL" clId="{1CEC4EA3-DB05-44BE-AF57-7E2779412AED}" dt="2021-12-01T23:30:19.157" v="82" actId="1076"/>
          <ac:spMkLst>
            <pc:docMk/>
            <pc:sldMk cId="1327558011" sldId="276"/>
            <ac:spMk id="22" creationId="{AF3F4660-366A-452D-88A8-E3DAF32F069D}"/>
          </ac:spMkLst>
        </pc:spChg>
        <pc:spChg chg="add mod">
          <ac:chgData name="Yang, Shengming - ARS" userId="37bd5b25-7571-49cb-bfc8-588a18706c35" providerId="ADAL" clId="{1CEC4EA3-DB05-44BE-AF57-7E2779412AED}" dt="2021-12-01T23:30:19.157" v="82" actId="1076"/>
          <ac:spMkLst>
            <pc:docMk/>
            <pc:sldMk cId="1327558011" sldId="276"/>
            <ac:spMk id="23" creationId="{0F5CAEC3-2F3B-498D-A713-21B9156DF953}"/>
          </ac:spMkLst>
        </pc:spChg>
        <pc:spChg chg="add del mod">
          <ac:chgData name="Yang, Shengming - ARS" userId="37bd5b25-7571-49cb-bfc8-588a18706c35" providerId="ADAL" clId="{1CEC4EA3-DB05-44BE-AF57-7E2779412AED}" dt="2021-12-22T20:08:27.113" v="2009" actId="478"/>
          <ac:spMkLst>
            <pc:docMk/>
            <pc:sldMk cId="1327558011" sldId="276"/>
            <ac:spMk id="24" creationId="{666B6B69-E7A3-4ACF-B033-07A7747744AE}"/>
          </ac:spMkLst>
        </pc:spChg>
        <pc:spChg chg="add del mod">
          <ac:chgData name="Yang, Shengming - ARS" userId="37bd5b25-7571-49cb-bfc8-588a18706c35" providerId="ADAL" clId="{1CEC4EA3-DB05-44BE-AF57-7E2779412AED}" dt="2021-12-22T20:08:24.632" v="2008" actId="478"/>
          <ac:spMkLst>
            <pc:docMk/>
            <pc:sldMk cId="1327558011" sldId="276"/>
            <ac:spMk id="25" creationId="{4934FF44-6D06-4A7E-97D6-90295BB0E2B4}"/>
          </ac:spMkLst>
        </pc:spChg>
        <pc:spChg chg="add mod">
          <ac:chgData name="Yang, Shengming - ARS" userId="37bd5b25-7571-49cb-bfc8-588a18706c35" providerId="ADAL" clId="{1CEC4EA3-DB05-44BE-AF57-7E2779412AED}" dt="2021-12-01T23:46:06.875" v="780" actId="14100"/>
          <ac:spMkLst>
            <pc:docMk/>
            <pc:sldMk cId="1327558011" sldId="276"/>
            <ac:spMk id="26" creationId="{557EC437-7B38-4A6E-97F8-966514E076E1}"/>
          </ac:spMkLst>
        </pc:spChg>
        <pc:spChg chg="add mod">
          <ac:chgData name="Yang, Shengming - ARS" userId="37bd5b25-7571-49cb-bfc8-588a18706c35" providerId="ADAL" clId="{1CEC4EA3-DB05-44BE-AF57-7E2779412AED}" dt="2021-12-22T20:19:54.273" v="2080" actId="14100"/>
          <ac:spMkLst>
            <pc:docMk/>
            <pc:sldMk cId="1327558011" sldId="276"/>
            <ac:spMk id="27" creationId="{93D67171-A90F-4D90-B3D3-C8C3BD804DF3}"/>
          </ac:spMkLst>
        </pc:spChg>
        <pc:spChg chg="add mod">
          <ac:chgData name="Yang, Shengming - ARS" userId="37bd5b25-7571-49cb-bfc8-588a18706c35" providerId="ADAL" clId="{1CEC4EA3-DB05-44BE-AF57-7E2779412AED}" dt="2021-12-22T20:20:17.718" v="2093" actId="1037"/>
          <ac:spMkLst>
            <pc:docMk/>
            <pc:sldMk cId="1327558011" sldId="276"/>
            <ac:spMk id="28" creationId="{D716D1A0-A1CE-4DF1-BF62-0045C30619D6}"/>
          </ac:spMkLst>
        </pc:spChg>
        <pc:picChg chg="add del mod ord modCrop">
          <ac:chgData name="Yang, Shengming - ARS" userId="37bd5b25-7571-49cb-bfc8-588a18706c35" providerId="ADAL" clId="{1CEC4EA3-DB05-44BE-AF57-7E2779412AED}" dt="2021-12-23T19:44:37.644" v="2107" actId="478"/>
          <ac:picMkLst>
            <pc:docMk/>
            <pc:sldMk cId="1327558011" sldId="276"/>
            <ac:picMk id="3" creationId="{47515810-1A32-4C86-A72B-3D11768C8C9D}"/>
          </ac:picMkLst>
        </pc:picChg>
        <pc:picChg chg="add del mod">
          <ac:chgData name="Yang, Shengming - ARS" userId="37bd5b25-7571-49cb-bfc8-588a18706c35" providerId="ADAL" clId="{1CEC4EA3-DB05-44BE-AF57-7E2779412AED}" dt="2021-12-01T23:29:47.380" v="76"/>
          <ac:picMkLst>
            <pc:docMk/>
            <pc:sldMk cId="1327558011" sldId="276"/>
            <ac:picMk id="4" creationId="{6E1ED88A-FE5E-448D-B7E2-F7B8005A0E5B}"/>
          </ac:picMkLst>
        </pc:picChg>
        <pc:picChg chg="add del mod">
          <ac:chgData name="Yang, Shengming - ARS" userId="37bd5b25-7571-49cb-bfc8-588a18706c35" providerId="ADAL" clId="{1CEC4EA3-DB05-44BE-AF57-7E2779412AED}" dt="2021-12-01T23:29:47.380" v="76"/>
          <ac:picMkLst>
            <pc:docMk/>
            <pc:sldMk cId="1327558011" sldId="276"/>
            <ac:picMk id="5" creationId="{1CB5EFE4-291E-4DB0-AEC6-4FC1122B2821}"/>
          </ac:picMkLst>
        </pc:picChg>
        <pc:picChg chg="add del mod modCrop">
          <ac:chgData name="Yang, Shengming - ARS" userId="37bd5b25-7571-49cb-bfc8-588a18706c35" providerId="ADAL" clId="{1CEC4EA3-DB05-44BE-AF57-7E2779412AED}" dt="2021-12-22T19:32:44.785" v="1978" actId="478"/>
          <ac:picMkLst>
            <pc:docMk/>
            <pc:sldMk cId="1327558011" sldId="276"/>
            <ac:picMk id="5" creationId="{3381DD81-F4CB-4116-AB31-33C2B9C41158}"/>
          </ac:picMkLst>
        </pc:picChg>
        <pc:picChg chg="add del mod">
          <ac:chgData name="Yang, Shengming - ARS" userId="37bd5b25-7571-49cb-bfc8-588a18706c35" providerId="ADAL" clId="{1CEC4EA3-DB05-44BE-AF57-7E2779412AED}" dt="2021-12-01T23:29:47.380" v="76"/>
          <ac:picMkLst>
            <pc:docMk/>
            <pc:sldMk cId="1327558011" sldId="276"/>
            <ac:picMk id="6" creationId="{9398DC8A-AFC5-4744-88CF-4B53A1E4DC87}"/>
          </ac:picMkLst>
        </pc:picChg>
        <pc:picChg chg="add del mod modCrop">
          <ac:chgData name="Yang, Shengming - ARS" userId="37bd5b25-7571-49cb-bfc8-588a18706c35" providerId="ADAL" clId="{1CEC4EA3-DB05-44BE-AF57-7E2779412AED}" dt="2021-12-22T17:49:41.990" v="1936" actId="478"/>
          <ac:picMkLst>
            <pc:docMk/>
            <pc:sldMk cId="1327558011" sldId="276"/>
            <ac:picMk id="7" creationId="{B991E4E1-A418-4A59-B1C9-F6BB8A5A7A7F}"/>
          </ac:picMkLst>
        </pc:picChg>
        <pc:picChg chg="add del mod modCrop">
          <ac:chgData name="Yang, Shengming - ARS" userId="37bd5b25-7571-49cb-bfc8-588a18706c35" providerId="ADAL" clId="{1CEC4EA3-DB05-44BE-AF57-7E2779412AED}" dt="2021-12-22T19:32:44.256" v="1977" actId="478"/>
          <ac:picMkLst>
            <pc:docMk/>
            <pc:sldMk cId="1327558011" sldId="276"/>
            <ac:picMk id="9" creationId="{D2106145-624E-4A03-AC6D-2880EE6214C5}"/>
          </ac:picMkLst>
        </pc:picChg>
        <pc:picChg chg="add mod ord modCrop">
          <ac:chgData name="Yang, Shengming - ARS" userId="37bd5b25-7571-49cb-bfc8-588a18706c35" providerId="ADAL" clId="{1CEC4EA3-DB05-44BE-AF57-7E2779412AED}" dt="2021-12-22T20:19:40.060" v="2061" actId="1037"/>
          <ac:picMkLst>
            <pc:docMk/>
            <pc:sldMk cId="1327558011" sldId="276"/>
            <ac:picMk id="10" creationId="{05A166F1-4B35-440B-8A66-9471844B2815}"/>
          </ac:picMkLst>
        </pc:picChg>
        <pc:picChg chg="add del mod ord modCrop">
          <ac:chgData name="Yang, Shengming - ARS" userId="37bd5b25-7571-49cb-bfc8-588a18706c35" providerId="ADAL" clId="{1CEC4EA3-DB05-44BE-AF57-7E2779412AED}" dt="2021-12-23T19:44:03.529" v="2103" actId="478"/>
          <ac:picMkLst>
            <pc:docMk/>
            <pc:sldMk cId="1327558011" sldId="276"/>
            <ac:picMk id="12" creationId="{6DE83228-71C3-4269-A8A6-2B8B65F5CCFF}"/>
          </ac:picMkLst>
        </pc:picChg>
        <pc:picChg chg="add mod ord">
          <ac:chgData name="Yang, Shengming - ARS" userId="37bd5b25-7571-49cb-bfc8-588a18706c35" providerId="ADAL" clId="{1CEC4EA3-DB05-44BE-AF57-7E2779412AED}" dt="2021-12-23T19:45:07.913" v="2112" actId="1037"/>
          <ac:picMkLst>
            <pc:docMk/>
            <pc:sldMk cId="1327558011" sldId="276"/>
            <ac:picMk id="13" creationId="{7337B5DD-D9CC-4FD6-9539-A6256FEF0D65}"/>
          </ac:picMkLst>
        </pc:picChg>
        <pc:picChg chg="add mod ord">
          <ac:chgData name="Yang, Shengming - ARS" userId="37bd5b25-7571-49cb-bfc8-588a18706c35" providerId="ADAL" clId="{1CEC4EA3-DB05-44BE-AF57-7E2779412AED}" dt="2021-12-23T19:44:48.658" v="2109" actId="167"/>
          <ac:picMkLst>
            <pc:docMk/>
            <pc:sldMk cId="1327558011" sldId="276"/>
            <ac:picMk id="14" creationId="{4FE97BDE-EC44-4359-BC83-63F3A53D94A1}"/>
          </ac:picMkLst>
        </pc:picChg>
        <pc:picChg chg="add del mod">
          <ac:chgData name="Yang, Shengming - ARS" userId="37bd5b25-7571-49cb-bfc8-588a18706c35" providerId="ADAL" clId="{1CEC4EA3-DB05-44BE-AF57-7E2779412AED}" dt="2021-12-22T19:30:14.752" v="1953" actId="478"/>
          <ac:picMkLst>
            <pc:docMk/>
            <pc:sldMk cId="1327558011" sldId="276"/>
            <ac:picMk id="15" creationId="{5D284B7B-1E42-4AFB-BAFB-26A7ECED02F4}"/>
          </ac:picMkLst>
        </pc:picChg>
        <pc:picChg chg="add del mod">
          <ac:chgData name="Yang, Shengming - ARS" userId="37bd5b25-7571-49cb-bfc8-588a18706c35" providerId="ADAL" clId="{1CEC4EA3-DB05-44BE-AF57-7E2779412AED}" dt="2021-12-22T19:30:15.313" v="1954" actId="478"/>
          <ac:picMkLst>
            <pc:docMk/>
            <pc:sldMk cId="1327558011" sldId="276"/>
            <ac:picMk id="16" creationId="{D0A0019A-9F34-4D53-8E9B-BA0D87793C36}"/>
          </ac:picMkLst>
        </pc:picChg>
        <pc:picChg chg="add del mod ord">
          <ac:chgData name="Yang, Shengming - ARS" userId="37bd5b25-7571-49cb-bfc8-588a18706c35" providerId="ADAL" clId="{1CEC4EA3-DB05-44BE-AF57-7E2779412AED}" dt="2021-12-22T20:18:43.624" v="2027" actId="167"/>
          <ac:picMkLst>
            <pc:docMk/>
            <pc:sldMk cId="1327558011" sldId="276"/>
            <ac:picMk id="17" creationId="{D41D87DC-71F0-406C-ACAE-7C86675098DF}"/>
          </ac:picMkLst>
        </pc:picChg>
      </pc:sldChg>
      <pc:sldChg chg="addSp delSp modSp new mod">
        <pc:chgData name="Yang, Shengming - ARS" userId="37bd5b25-7571-49cb-bfc8-588a18706c35" providerId="ADAL" clId="{1CEC4EA3-DB05-44BE-AF57-7E2779412AED}" dt="2021-12-01T23:52:30.595" v="982" actId="1076"/>
        <pc:sldMkLst>
          <pc:docMk/>
          <pc:sldMk cId="2338164932" sldId="277"/>
        </pc:sldMkLst>
        <pc:spChg chg="del">
          <ac:chgData name="Yang, Shengming - ARS" userId="37bd5b25-7571-49cb-bfc8-588a18706c35" providerId="ADAL" clId="{1CEC4EA3-DB05-44BE-AF57-7E2779412AED}" dt="2021-12-01T23:31:03.858" v="193" actId="478"/>
          <ac:spMkLst>
            <pc:docMk/>
            <pc:sldMk cId="2338164932" sldId="277"/>
            <ac:spMk id="2" creationId="{728A7D8B-F7B1-492C-9A1A-60FFDA88367D}"/>
          </ac:spMkLst>
        </pc:spChg>
        <pc:spChg chg="del">
          <ac:chgData name="Yang, Shengming - ARS" userId="37bd5b25-7571-49cb-bfc8-588a18706c35" providerId="ADAL" clId="{1CEC4EA3-DB05-44BE-AF57-7E2779412AED}" dt="2021-12-01T23:31:05.115" v="194" actId="478"/>
          <ac:spMkLst>
            <pc:docMk/>
            <pc:sldMk cId="2338164932" sldId="277"/>
            <ac:spMk id="3" creationId="{6111AE31-EA02-4F39-9E72-828201652876}"/>
          </ac:spMkLst>
        </pc:spChg>
        <pc:spChg chg="add mod">
          <ac:chgData name="Yang, Shengming - ARS" userId="37bd5b25-7571-49cb-bfc8-588a18706c35" providerId="ADAL" clId="{1CEC4EA3-DB05-44BE-AF57-7E2779412AED}" dt="2021-12-01T23:32:33.992" v="201" actId="14100"/>
          <ac:spMkLst>
            <pc:docMk/>
            <pc:sldMk cId="2338164932" sldId="277"/>
            <ac:spMk id="4" creationId="{327864F8-1AF9-48FF-8153-91701A03977B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7" creationId="{A3D35586-BD6A-4FE2-808B-FA9714C5DBB9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8" creationId="{42555822-7078-4F85-B25D-30C1D9D934BD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9" creationId="{ACF661F1-6CE1-44C8-9915-E53CDBFA7B63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11" creationId="{7239F33E-AD20-49E6-902F-B73EC6258D4B}"/>
          </ac:spMkLst>
        </pc:spChg>
        <pc:spChg chg="add mod">
          <ac:chgData name="Yang, Shengming - ARS" userId="37bd5b25-7571-49cb-bfc8-588a18706c35" providerId="ADAL" clId="{1CEC4EA3-DB05-44BE-AF57-7E2779412AED}" dt="2021-12-01T23:32:33.992" v="201" actId="14100"/>
          <ac:spMkLst>
            <pc:docMk/>
            <pc:sldMk cId="2338164932" sldId="277"/>
            <ac:spMk id="12" creationId="{E6D8814D-51B2-4292-BAC4-B3F2C8897A0A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14" creationId="{DAB78677-6D06-432A-BCD6-E04FE82D5685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15" creationId="{3864D079-E178-4514-9A88-6B9FD98734A4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24" creationId="{77100186-872C-426D-A183-A632241A907F}"/>
          </ac:spMkLst>
        </pc:spChg>
        <pc:spChg chg="add mod">
          <ac:chgData name="Yang, Shengming - ARS" userId="37bd5b25-7571-49cb-bfc8-588a18706c35" providerId="ADAL" clId="{1CEC4EA3-DB05-44BE-AF57-7E2779412AED}" dt="2021-12-01T23:32:33.992" v="201" actId="14100"/>
          <ac:spMkLst>
            <pc:docMk/>
            <pc:sldMk cId="2338164932" sldId="277"/>
            <ac:spMk id="25" creationId="{A0451547-3B00-4C7C-8802-76D22D0B3C4E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28" creationId="{34CD60B6-BEC4-4EFA-A66E-7485135F6CFF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0" creationId="{A394E1F8-BAD6-4AAC-9CB9-53287D112279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1" creationId="{D0C7CC23-CEB5-4396-980D-625B8772C86D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2" creationId="{67C98EFE-9C99-484F-A423-AA1826EF0B0B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3" creationId="{C06B46B4-7FE1-4D21-9576-E6E499E89C28}"/>
          </ac:spMkLst>
        </pc:spChg>
        <pc:spChg chg="add mod">
          <ac:chgData name="Yang, Shengming - ARS" userId="37bd5b25-7571-49cb-bfc8-588a18706c35" providerId="ADAL" clId="{1CEC4EA3-DB05-44BE-AF57-7E2779412AED}" dt="2021-12-01T23:32:33.992" v="201" actId="14100"/>
          <ac:spMkLst>
            <pc:docMk/>
            <pc:sldMk cId="2338164932" sldId="277"/>
            <ac:spMk id="34" creationId="{98406564-1BCE-451A-BB23-839381D5B6A9}"/>
          </ac:spMkLst>
        </pc:spChg>
        <pc:spChg chg="add mod">
          <ac:chgData name="Yang, Shengming - ARS" userId="37bd5b25-7571-49cb-bfc8-588a18706c35" providerId="ADAL" clId="{1CEC4EA3-DB05-44BE-AF57-7E2779412AED}" dt="2021-12-01T23:51:56.487" v="970" actId="1076"/>
          <ac:spMkLst>
            <pc:docMk/>
            <pc:sldMk cId="2338164932" sldId="277"/>
            <ac:spMk id="35" creationId="{AF0B610E-81AE-45AA-BE91-3A074F40C5EE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6" creationId="{4CB62AB7-EA9A-40FD-94C4-5F40A116414D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7" creationId="{754E176E-B4BB-400A-B7EE-74E4F5B5C122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8" creationId="{8C2D1CD4-9040-4797-905A-5771CE165C82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39" creationId="{34A716DA-9228-49F6-9E76-3813E1DA9BFC}"/>
          </ac:spMkLst>
        </pc:spChg>
        <pc:spChg chg="add mod">
          <ac:chgData name="Yang, Shengming - ARS" userId="37bd5b25-7571-49cb-bfc8-588a18706c35" providerId="ADAL" clId="{1CEC4EA3-DB05-44BE-AF57-7E2779412AED}" dt="2021-12-01T23:52:30.595" v="982" actId="1076"/>
          <ac:spMkLst>
            <pc:docMk/>
            <pc:sldMk cId="2338164932" sldId="277"/>
            <ac:spMk id="40" creationId="{361ADB74-A2C3-46CC-9327-A2B0964D717A}"/>
          </ac:spMkLst>
        </pc:spChg>
        <pc:spChg chg="add mod">
          <ac:chgData name="Yang, Shengming - ARS" userId="37bd5b25-7571-49cb-bfc8-588a18706c35" providerId="ADAL" clId="{1CEC4EA3-DB05-44BE-AF57-7E2779412AED}" dt="2021-12-01T23:52:17.867" v="980" actId="14100"/>
          <ac:spMkLst>
            <pc:docMk/>
            <pc:sldMk cId="2338164932" sldId="277"/>
            <ac:spMk id="76" creationId="{6147EB84-2895-4307-9090-3D0D591FEAE9}"/>
          </ac:spMkLst>
        </pc:sp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5" creationId="{C280D1A0-E619-472D-B962-D7BB43CB4642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6" creationId="{081B810E-59C1-4960-A8E9-7D06890CB976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0" creationId="{E437BF3B-2DB7-456F-AD4B-006336880030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3" creationId="{2CB789A5-9AF5-4C81-9503-51042581E924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6" creationId="{A8E15AF5-A1A7-435E-B938-56D64E126FB0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7" creationId="{278E7179-8422-48AC-8DF4-4813C14D1D47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8" creationId="{35BB3255-75B0-4E3C-9360-8B2AB71D2C1F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19" creationId="{25E0BE3D-2FFE-4BAC-8B39-FCB0A50FABA0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0" creationId="{9102A972-1223-4915-AD82-1DBC29E04B4B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1" creationId="{C7EECC96-3EB2-4331-A664-AF1FDCA408B1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2" creationId="{9077870D-6131-463B-B574-8413AFF56AF8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3" creationId="{09447729-9490-458D-B1A4-6F8472F46086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6" creationId="{31AB6231-0E89-4298-8537-1192B72AB47C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7" creationId="{C212F65D-5149-4C30-97FA-04BD3B35D5C5}"/>
          </ac:cxnSpMkLst>
        </pc:cxnChg>
        <pc:cxnChg chg="add mod">
          <ac:chgData name="Yang, Shengming - ARS" userId="37bd5b25-7571-49cb-bfc8-588a18706c35" providerId="ADAL" clId="{1CEC4EA3-DB05-44BE-AF57-7E2779412AED}" dt="2021-12-01T23:52:30.595" v="982" actId="1076"/>
          <ac:cxnSpMkLst>
            <pc:docMk/>
            <pc:sldMk cId="2338164932" sldId="277"/>
            <ac:cxnSpMk id="29" creationId="{83E026B4-35C6-4C9F-8965-B6E8B89DF339}"/>
          </ac:cxnSpMkLst>
        </pc:cxnChg>
      </pc:sldChg>
      <pc:sldChg chg="addSp delSp modSp new mod">
        <pc:chgData name="Yang, Shengming - ARS" userId="37bd5b25-7571-49cb-bfc8-588a18706c35" providerId="ADAL" clId="{1CEC4EA3-DB05-44BE-AF57-7E2779412AED}" dt="2021-12-01T23:44:59.024" v="766" actId="14100"/>
        <pc:sldMkLst>
          <pc:docMk/>
          <pc:sldMk cId="887383785" sldId="278"/>
        </pc:sldMkLst>
        <pc:spChg chg="del">
          <ac:chgData name="Yang, Shengming - ARS" userId="37bd5b25-7571-49cb-bfc8-588a18706c35" providerId="ADAL" clId="{1CEC4EA3-DB05-44BE-AF57-7E2779412AED}" dt="2021-12-01T23:44:05.370" v="751" actId="478"/>
          <ac:spMkLst>
            <pc:docMk/>
            <pc:sldMk cId="887383785" sldId="278"/>
            <ac:spMk id="2" creationId="{314B20EA-FE22-41B2-BB17-666155644240}"/>
          </ac:spMkLst>
        </pc:spChg>
        <pc:spChg chg="del">
          <ac:chgData name="Yang, Shengming - ARS" userId="37bd5b25-7571-49cb-bfc8-588a18706c35" providerId="ADAL" clId="{1CEC4EA3-DB05-44BE-AF57-7E2779412AED}" dt="2021-12-01T23:44:05.370" v="751" actId="478"/>
          <ac:spMkLst>
            <pc:docMk/>
            <pc:sldMk cId="887383785" sldId="278"/>
            <ac:spMk id="3" creationId="{E1448CDD-84DB-4FDD-AA5F-6C8ED2529851}"/>
          </ac:spMkLst>
        </pc:spChg>
        <pc:graphicFrameChg chg="add mod modGraphic">
          <ac:chgData name="Yang, Shengming - ARS" userId="37bd5b25-7571-49cb-bfc8-588a18706c35" providerId="ADAL" clId="{1CEC4EA3-DB05-44BE-AF57-7E2779412AED}" dt="2021-12-01T23:44:59.024" v="766" actId="14100"/>
          <ac:graphicFrameMkLst>
            <pc:docMk/>
            <pc:sldMk cId="887383785" sldId="278"/>
            <ac:graphicFrameMk id="4" creationId="{12240337-9653-4844-83C7-8964481C8519}"/>
          </ac:graphicFrameMkLst>
        </pc:graphicFrameChg>
      </pc:sldChg>
      <pc:sldChg chg="addSp delSp modSp new mod ord">
        <pc:chgData name="Yang, Shengming - ARS" userId="37bd5b25-7571-49cb-bfc8-588a18706c35" providerId="ADAL" clId="{1CEC4EA3-DB05-44BE-AF57-7E2779412AED}" dt="2021-12-20T16:17:29.333" v="1898"/>
        <pc:sldMkLst>
          <pc:docMk/>
          <pc:sldMk cId="3951076637" sldId="279"/>
        </pc:sldMkLst>
        <pc:spChg chg="del">
          <ac:chgData name="Yang, Shengming - ARS" userId="37bd5b25-7571-49cb-bfc8-588a18706c35" providerId="ADAL" clId="{1CEC4EA3-DB05-44BE-AF57-7E2779412AED}" dt="2021-12-06T17:48:35.479" v="1094" actId="478"/>
          <ac:spMkLst>
            <pc:docMk/>
            <pc:sldMk cId="3951076637" sldId="279"/>
            <ac:spMk id="2" creationId="{728DFCB7-5E2F-4D0C-B571-6C54E4DB481F}"/>
          </ac:spMkLst>
        </pc:spChg>
        <pc:spChg chg="del">
          <ac:chgData name="Yang, Shengming - ARS" userId="37bd5b25-7571-49cb-bfc8-588a18706c35" providerId="ADAL" clId="{1CEC4EA3-DB05-44BE-AF57-7E2779412AED}" dt="2021-12-06T17:48:31.856" v="1093" actId="478"/>
          <ac:spMkLst>
            <pc:docMk/>
            <pc:sldMk cId="3951076637" sldId="279"/>
            <ac:spMk id="3" creationId="{2C65469C-A1B0-4D26-BA57-90CD8EC2903C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5" creationId="{145BD528-BFA0-4D45-9687-079068890D7E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9" creationId="{1DBA7A38-F1C2-43F1-B07B-6DB945F9489B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0" creationId="{3D2326B1-C546-4D12-8752-20DF7547E757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1" creationId="{9CEA8F64-D0F9-437A-B0CD-26A049A077C5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2" creationId="{9A1CB18C-708F-4490-8E3B-0E81F8B8F925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3" creationId="{90553A36-194B-4661-8528-8B1849BB7519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4" creationId="{C4F6644D-D88C-416B-A004-6086EFE2868C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5" creationId="{F3DED48D-CE70-40FE-A39D-B971BC9389C5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6" creationId="{E0E41763-64B4-493B-B8C5-44023B9A4868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7" creationId="{B88AA1AD-6740-41FB-8D03-55FD7DD6881F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8" creationId="{C11AFC66-BEAB-4A07-9543-1548CB6DFB82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19" creationId="{749D19CB-F2A5-4F3D-9AA1-9B63159D6EB5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0" creationId="{47C1E7A6-3888-4BF6-AF81-7889EAB920DA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1" creationId="{63AD6A1F-A67A-4E9B-B1F2-1AAA334BDE29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2" creationId="{2277B4F2-190F-4C43-BA86-871B416D3C6D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3" creationId="{8E58034F-46E8-4DEB-A53C-A4EFA9DF7AE5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4" creationId="{119F3634-2A44-4A1E-B9A1-20D2CD30BFE8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5" creationId="{DEDD0E87-E7AD-4F9C-810D-65C7C9B37EB3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6" creationId="{8EF545B0-FBB5-4A8A-AC3B-7EC09B4C7B60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7" creationId="{2579254F-6C34-4A01-B85F-1044A5595F64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8" creationId="{2681E759-E980-4D0E-8A19-3C6930055144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29" creationId="{36469305-C272-4EBC-894D-2CF648336826}"/>
          </ac:spMkLst>
        </pc:spChg>
        <pc:spChg chg="mod">
          <ac:chgData name="Yang, Shengming - ARS" userId="37bd5b25-7571-49cb-bfc8-588a18706c35" providerId="ADAL" clId="{1CEC4EA3-DB05-44BE-AF57-7E2779412AED}" dt="2021-12-06T17:49:09.761" v="1100" actId="255"/>
          <ac:spMkLst>
            <pc:docMk/>
            <pc:sldMk cId="3951076637" sldId="279"/>
            <ac:spMk id="31" creationId="{8C88D3CF-522A-4F82-9D1E-F2BA0C73E44A}"/>
          </ac:spMkLst>
        </pc:spChg>
        <pc:grpChg chg="add mod">
          <ac:chgData name="Yang, Shengming - ARS" userId="37bd5b25-7571-49cb-bfc8-588a18706c35" providerId="ADAL" clId="{1CEC4EA3-DB05-44BE-AF57-7E2779412AED}" dt="2021-12-13T15:24:58.276" v="1311" actId="1076"/>
          <ac:grpSpMkLst>
            <pc:docMk/>
            <pc:sldMk cId="3951076637" sldId="279"/>
            <ac:grpSpMk id="4" creationId="{AFBEF914-C123-4457-BA33-D246EBC7B174}"/>
          </ac:grpSpMkLst>
        </pc:grpChg>
        <pc:picChg chg="mod">
          <ac:chgData name="Yang, Shengming - ARS" userId="37bd5b25-7571-49cb-bfc8-588a18706c35" providerId="ADAL" clId="{1CEC4EA3-DB05-44BE-AF57-7E2779412AED}" dt="2021-12-06T17:48:15.720" v="1084"/>
          <ac:picMkLst>
            <pc:docMk/>
            <pc:sldMk cId="3951076637" sldId="279"/>
            <ac:picMk id="6" creationId="{D5D3F2C3-992B-4E29-AC45-94D57298A263}"/>
          </ac:picMkLst>
        </pc:picChg>
        <pc:picChg chg="mod">
          <ac:chgData name="Yang, Shengming - ARS" userId="37bd5b25-7571-49cb-bfc8-588a18706c35" providerId="ADAL" clId="{1CEC4EA3-DB05-44BE-AF57-7E2779412AED}" dt="2021-12-06T17:48:15.720" v="1084"/>
          <ac:picMkLst>
            <pc:docMk/>
            <pc:sldMk cId="3951076637" sldId="279"/>
            <ac:picMk id="7" creationId="{E65D33FD-4A8B-4730-B051-114648063CC8}"/>
          </ac:picMkLst>
        </pc:picChg>
        <pc:picChg chg="mod">
          <ac:chgData name="Yang, Shengming - ARS" userId="37bd5b25-7571-49cb-bfc8-588a18706c35" providerId="ADAL" clId="{1CEC4EA3-DB05-44BE-AF57-7E2779412AED}" dt="2021-12-06T17:48:15.720" v="1084"/>
          <ac:picMkLst>
            <pc:docMk/>
            <pc:sldMk cId="3951076637" sldId="279"/>
            <ac:picMk id="8" creationId="{03A0FCB9-0014-44CD-9C1E-29A0071AF403}"/>
          </ac:picMkLst>
        </pc:picChg>
        <pc:picChg chg="mod">
          <ac:chgData name="Yang, Shengming - ARS" userId="37bd5b25-7571-49cb-bfc8-588a18706c35" providerId="ADAL" clId="{1CEC4EA3-DB05-44BE-AF57-7E2779412AED}" dt="2021-12-13T15:24:48.338" v="1310" actId="1076"/>
          <ac:picMkLst>
            <pc:docMk/>
            <pc:sldMk cId="3951076637" sldId="279"/>
            <ac:picMk id="30" creationId="{121D0B31-5F7E-439F-8FDF-148E33A12C9B}"/>
          </ac:picMkLst>
        </pc:picChg>
        <pc:cxnChg chg="mod">
          <ac:chgData name="Yang, Shengming - ARS" userId="37bd5b25-7571-49cb-bfc8-588a18706c35" providerId="ADAL" clId="{1CEC4EA3-DB05-44BE-AF57-7E2779412AED}" dt="2021-12-06T17:48:15.720" v="1084"/>
          <ac:cxnSpMkLst>
            <pc:docMk/>
            <pc:sldMk cId="3951076637" sldId="279"/>
            <ac:cxnSpMk id="32" creationId="{0ED014C2-BD9C-48CA-9230-869B95F1C1B6}"/>
          </ac:cxnSpMkLst>
        </pc:cxnChg>
      </pc:sldChg>
      <pc:sldChg chg="addSp delSp modSp new mod">
        <pc:chgData name="Yang, Shengming - ARS" userId="37bd5b25-7571-49cb-bfc8-588a18706c35" providerId="ADAL" clId="{1CEC4EA3-DB05-44BE-AF57-7E2779412AED}" dt="2021-12-08T18:54:03.960" v="1208" actId="1076"/>
        <pc:sldMkLst>
          <pc:docMk/>
          <pc:sldMk cId="2943728638" sldId="280"/>
        </pc:sldMkLst>
        <pc:spChg chg="del">
          <ac:chgData name="Yang, Shengming - ARS" userId="37bd5b25-7571-49cb-bfc8-588a18706c35" providerId="ADAL" clId="{1CEC4EA3-DB05-44BE-AF57-7E2779412AED}" dt="2021-12-08T16:21:19.408" v="1121" actId="478"/>
          <ac:spMkLst>
            <pc:docMk/>
            <pc:sldMk cId="2943728638" sldId="280"/>
            <ac:spMk id="2" creationId="{B51E652E-D2FC-4D48-8087-A1F950BE5727}"/>
          </ac:spMkLst>
        </pc:spChg>
        <pc:spChg chg="del mod">
          <ac:chgData name="Yang, Shengming - ARS" userId="37bd5b25-7571-49cb-bfc8-588a18706c35" providerId="ADAL" clId="{1CEC4EA3-DB05-44BE-AF57-7E2779412AED}" dt="2021-12-08T16:21:13.279" v="1119" actId="478"/>
          <ac:spMkLst>
            <pc:docMk/>
            <pc:sldMk cId="2943728638" sldId="280"/>
            <ac:spMk id="3" creationId="{388544ED-8267-450B-8A07-45CD100E700E}"/>
          </ac:spMkLst>
        </pc:spChg>
        <pc:spChg chg="add del mod">
          <ac:chgData name="Yang, Shengming - ARS" userId="37bd5b25-7571-49cb-bfc8-588a18706c35" providerId="ADAL" clId="{1CEC4EA3-DB05-44BE-AF57-7E2779412AED}" dt="2021-12-08T18:53:50.761" v="1205" actId="478"/>
          <ac:spMkLst>
            <pc:docMk/>
            <pc:sldMk cId="2943728638" sldId="280"/>
            <ac:spMk id="5" creationId="{3536617E-1BA2-4306-87E2-94E17F93A1C4}"/>
          </ac:spMkLst>
        </pc:spChg>
        <pc:spChg chg="add del mod">
          <ac:chgData name="Yang, Shengming - ARS" userId="37bd5b25-7571-49cb-bfc8-588a18706c35" providerId="ADAL" clId="{1CEC4EA3-DB05-44BE-AF57-7E2779412AED}" dt="2021-12-08T18:53:57.243" v="1206" actId="478"/>
          <ac:spMkLst>
            <pc:docMk/>
            <pc:sldMk cId="2943728638" sldId="280"/>
            <ac:spMk id="6" creationId="{A8A0E309-8391-424E-8D03-208DB2BCD810}"/>
          </ac:spMkLst>
        </pc:spChg>
        <pc:spChg chg="add del mod">
          <ac:chgData name="Yang, Shengming - ARS" userId="37bd5b25-7571-49cb-bfc8-588a18706c35" providerId="ADAL" clId="{1CEC4EA3-DB05-44BE-AF57-7E2779412AED}" dt="2021-12-08T18:53:57.243" v="1206" actId="478"/>
          <ac:spMkLst>
            <pc:docMk/>
            <pc:sldMk cId="2943728638" sldId="280"/>
            <ac:spMk id="7" creationId="{2917777C-F9D6-43C5-9101-F2D17AFAA31B}"/>
          </ac:spMkLst>
        </pc:spChg>
        <pc:spChg chg="add del mod">
          <ac:chgData name="Yang, Shengming - ARS" userId="37bd5b25-7571-49cb-bfc8-588a18706c35" providerId="ADAL" clId="{1CEC4EA3-DB05-44BE-AF57-7E2779412AED}" dt="2021-12-08T18:53:57.243" v="1206" actId="478"/>
          <ac:spMkLst>
            <pc:docMk/>
            <pc:sldMk cId="2943728638" sldId="280"/>
            <ac:spMk id="8" creationId="{E7B2515A-6A47-4169-8C54-FB6DF31C2F8B}"/>
          </ac:spMkLst>
        </pc:spChg>
        <pc:spChg chg="add del mod">
          <ac:chgData name="Yang, Shengming - ARS" userId="37bd5b25-7571-49cb-bfc8-588a18706c35" providerId="ADAL" clId="{1CEC4EA3-DB05-44BE-AF57-7E2779412AED}" dt="2021-12-08T18:53:57.243" v="1206" actId="478"/>
          <ac:spMkLst>
            <pc:docMk/>
            <pc:sldMk cId="2943728638" sldId="280"/>
            <ac:spMk id="9" creationId="{10F04274-2379-4852-9243-9B709DD8FE66}"/>
          </ac:spMkLst>
        </pc:spChg>
        <pc:spChg chg="add del mod">
          <ac:chgData name="Yang, Shengming - ARS" userId="37bd5b25-7571-49cb-bfc8-588a18706c35" providerId="ADAL" clId="{1CEC4EA3-DB05-44BE-AF57-7E2779412AED}" dt="2021-12-08T18:53:50.761" v="1205" actId="478"/>
          <ac:spMkLst>
            <pc:docMk/>
            <pc:sldMk cId="2943728638" sldId="280"/>
            <ac:spMk id="10" creationId="{69341816-BA84-4B7D-A956-E21569141471}"/>
          </ac:spMkLst>
        </pc:spChg>
        <pc:spChg chg="add mod">
          <ac:chgData name="Yang, Shengming - ARS" userId="37bd5b25-7571-49cb-bfc8-588a18706c35" providerId="ADAL" clId="{1CEC4EA3-DB05-44BE-AF57-7E2779412AED}" dt="2021-12-08T18:54:00.249" v="1207" actId="1076"/>
          <ac:spMkLst>
            <pc:docMk/>
            <pc:sldMk cId="2943728638" sldId="280"/>
            <ac:spMk id="12" creationId="{7A0C94AB-AB8A-4555-AA02-A6F3CCFAF47B}"/>
          </ac:spMkLst>
        </pc:spChg>
        <pc:graphicFrameChg chg="add mod">
          <ac:chgData name="Yang, Shengming - ARS" userId="37bd5b25-7571-49cb-bfc8-588a18706c35" providerId="ADAL" clId="{1CEC4EA3-DB05-44BE-AF57-7E2779412AED}" dt="2021-12-08T18:54:03.960" v="1208" actId="1076"/>
          <ac:graphicFrameMkLst>
            <pc:docMk/>
            <pc:sldMk cId="2943728638" sldId="280"/>
            <ac:graphicFrameMk id="11" creationId="{E6938A52-A21B-46C3-8EC5-EF88A90920AD}"/>
          </ac:graphicFrameMkLst>
        </pc:graphicFrameChg>
      </pc:sldChg>
      <pc:sldChg chg="delSp mod">
        <pc:chgData name="Yang, Shengming - ARS" userId="37bd5b25-7571-49cb-bfc8-588a18706c35" providerId="ADAL" clId="{1CEC4EA3-DB05-44BE-AF57-7E2779412AED}" dt="2021-12-16T19:32:16.441" v="1313" actId="478"/>
        <pc:sldMkLst>
          <pc:docMk/>
          <pc:sldMk cId="1104748975" sldId="281"/>
        </pc:sldMkLst>
        <pc:picChg chg="del">
          <ac:chgData name="Yang, Shengming - ARS" userId="37bd5b25-7571-49cb-bfc8-588a18706c35" providerId="ADAL" clId="{1CEC4EA3-DB05-44BE-AF57-7E2779412AED}" dt="2021-12-16T19:32:16.441" v="1313" actId="478"/>
          <ac:picMkLst>
            <pc:docMk/>
            <pc:sldMk cId="1104748975" sldId="281"/>
            <ac:picMk id="5" creationId="{268BE0B8-DA26-4BA7-BBC9-1F2701F84E01}"/>
          </ac:picMkLst>
        </pc:picChg>
        <pc:picChg chg="del">
          <ac:chgData name="Yang, Shengming - ARS" userId="37bd5b25-7571-49cb-bfc8-588a18706c35" providerId="ADAL" clId="{1CEC4EA3-DB05-44BE-AF57-7E2779412AED}" dt="2021-12-16T19:32:15.855" v="1312" actId="478"/>
          <ac:picMkLst>
            <pc:docMk/>
            <pc:sldMk cId="1104748975" sldId="281"/>
            <ac:picMk id="9" creationId="{44F233FB-2819-41D0-9AF4-54786682BBC0}"/>
          </ac:picMkLst>
        </pc:picChg>
      </pc:sldChg>
      <pc:sldChg chg="addSp delSp modSp new mod">
        <pc:chgData name="Yang, Shengming - ARS" userId="37bd5b25-7571-49cb-bfc8-588a18706c35" providerId="ADAL" clId="{1CEC4EA3-DB05-44BE-AF57-7E2779412AED}" dt="2021-12-17T19:25:10.407" v="1376" actId="21"/>
        <pc:sldMkLst>
          <pc:docMk/>
          <pc:sldMk cId="1705255663" sldId="282"/>
        </pc:sldMkLst>
        <pc:spChg chg="del">
          <ac:chgData name="Yang, Shengming - ARS" userId="37bd5b25-7571-49cb-bfc8-588a18706c35" providerId="ADAL" clId="{1CEC4EA3-DB05-44BE-AF57-7E2779412AED}" dt="2021-12-10T18:42:32.562" v="1210" actId="478"/>
          <ac:spMkLst>
            <pc:docMk/>
            <pc:sldMk cId="1705255663" sldId="282"/>
            <ac:spMk id="2" creationId="{DB944BA2-C0EA-4843-B061-EB5A884480B0}"/>
          </ac:spMkLst>
        </pc:spChg>
        <pc:spChg chg="del">
          <ac:chgData name="Yang, Shengming - ARS" userId="37bd5b25-7571-49cb-bfc8-588a18706c35" providerId="ADAL" clId="{1CEC4EA3-DB05-44BE-AF57-7E2779412AED}" dt="2021-12-10T18:42:32.562" v="1210" actId="478"/>
          <ac:spMkLst>
            <pc:docMk/>
            <pc:sldMk cId="1705255663" sldId="282"/>
            <ac:spMk id="3" creationId="{12C1210D-6CF4-4C58-8EDA-7EDF42BE7504}"/>
          </ac:spMkLst>
        </pc:spChg>
        <pc:spChg chg="add mod">
          <ac:chgData name="Yang, Shengming - ARS" userId="37bd5b25-7571-49cb-bfc8-588a18706c35" providerId="ADAL" clId="{1CEC4EA3-DB05-44BE-AF57-7E2779412AED}" dt="2021-12-16T19:45:46.853" v="1352" actId="404"/>
          <ac:spMkLst>
            <pc:docMk/>
            <pc:sldMk cId="1705255663" sldId="282"/>
            <ac:spMk id="4" creationId="{6803CA9D-13EE-4B97-90E9-5ACCDFE5FC3F}"/>
          </ac:spMkLst>
        </pc:spChg>
        <pc:spChg chg="add mod">
          <ac:chgData name="Yang, Shengming - ARS" userId="37bd5b25-7571-49cb-bfc8-588a18706c35" providerId="ADAL" clId="{1CEC4EA3-DB05-44BE-AF57-7E2779412AED}" dt="2021-12-10T18:44:35.659" v="1304" actId="1076"/>
          <ac:spMkLst>
            <pc:docMk/>
            <pc:sldMk cId="1705255663" sldId="282"/>
            <ac:spMk id="5" creationId="{B1448A8A-544D-438F-A286-694D3FDB58FE}"/>
          </ac:spMkLst>
        </pc:spChg>
        <pc:spChg chg="add mod">
          <ac:chgData name="Yang, Shengming - ARS" userId="37bd5b25-7571-49cb-bfc8-588a18706c35" providerId="ADAL" clId="{1CEC4EA3-DB05-44BE-AF57-7E2779412AED}" dt="2021-12-16T19:45:46.853" v="1352" actId="404"/>
          <ac:spMkLst>
            <pc:docMk/>
            <pc:sldMk cId="1705255663" sldId="282"/>
            <ac:spMk id="6" creationId="{565B2CCC-9E63-4D2E-9A47-DE9222FABAA9}"/>
          </ac:spMkLst>
        </pc:spChg>
        <pc:spChg chg="add mod">
          <ac:chgData name="Yang, Shengming - ARS" userId="37bd5b25-7571-49cb-bfc8-588a18706c35" providerId="ADAL" clId="{1CEC4EA3-DB05-44BE-AF57-7E2779412AED}" dt="2021-12-16T19:45:46.853" v="1352" actId="404"/>
          <ac:spMkLst>
            <pc:docMk/>
            <pc:sldMk cId="1705255663" sldId="282"/>
            <ac:spMk id="7" creationId="{44BAA3C1-28BB-4D76-A02E-FC5544EA2535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9" creationId="{A2C97B91-6271-4345-996F-8330209F9B49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10" creationId="{90CF2A94-EDB8-48E5-9D18-168AC82424CF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11" creationId="{39D94598-D1BA-455B-8FFC-874C040049FA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12" creationId="{A55BD882-FC2F-4D27-9757-F4435CDF4802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13" creationId="{FF53C586-10C1-4FE1-96F6-AF8CC4D9E8FC}"/>
          </ac:spMkLst>
        </pc:spChg>
        <pc:spChg chg="add del mod">
          <ac:chgData name="Yang, Shengming - ARS" userId="37bd5b25-7571-49cb-bfc8-588a18706c35" providerId="ADAL" clId="{1CEC4EA3-DB05-44BE-AF57-7E2779412AED}" dt="2021-12-17T19:25:10.407" v="1376" actId="21"/>
          <ac:spMkLst>
            <pc:docMk/>
            <pc:sldMk cId="1705255663" sldId="282"/>
            <ac:spMk id="14" creationId="{A915411F-8DBD-426D-8EAC-812B36DB50F6}"/>
          </ac:spMkLst>
        </pc:spChg>
        <pc:picChg chg="add mod">
          <ac:chgData name="Yang, Shengming - ARS" userId="37bd5b25-7571-49cb-bfc8-588a18706c35" providerId="ADAL" clId="{1CEC4EA3-DB05-44BE-AF57-7E2779412AED}" dt="2021-12-16T19:45:43.872" v="1347" actId="1076"/>
          <ac:picMkLst>
            <pc:docMk/>
            <pc:sldMk cId="1705255663" sldId="282"/>
            <ac:picMk id="3" creationId="{4D0CFDD5-3BF9-4979-86AD-60EDDA799CAE}"/>
          </ac:picMkLst>
        </pc:picChg>
        <pc:picChg chg="add del mod modCrop">
          <ac:chgData name="Yang, Shengming - ARS" userId="37bd5b25-7571-49cb-bfc8-588a18706c35" providerId="ADAL" clId="{1CEC4EA3-DB05-44BE-AF57-7E2779412AED}" dt="2021-12-17T19:25:10.407" v="1376" actId="21"/>
          <ac:picMkLst>
            <pc:docMk/>
            <pc:sldMk cId="1705255663" sldId="282"/>
            <ac:picMk id="8" creationId="{086F982F-E701-4A51-B69A-FEB24B454EDC}"/>
          </ac:picMkLst>
        </pc:picChg>
      </pc:sldChg>
      <pc:sldChg chg="addSp delSp modSp new mod ord">
        <pc:chgData name="Yang, Shengming - ARS" userId="37bd5b25-7571-49cb-bfc8-588a18706c35" providerId="ADAL" clId="{1CEC4EA3-DB05-44BE-AF57-7E2779412AED}" dt="2021-12-17T22:12:37.619" v="1893"/>
        <pc:sldMkLst>
          <pc:docMk/>
          <pc:sldMk cId="3161562260" sldId="283"/>
        </pc:sldMkLst>
        <pc:spChg chg="del">
          <ac:chgData name="Yang, Shengming - ARS" userId="37bd5b25-7571-49cb-bfc8-588a18706c35" providerId="ADAL" clId="{1CEC4EA3-DB05-44BE-AF57-7E2779412AED}" dt="2021-12-17T19:25:15.811" v="1377" actId="478"/>
          <ac:spMkLst>
            <pc:docMk/>
            <pc:sldMk cId="3161562260" sldId="283"/>
            <ac:spMk id="2" creationId="{9CA5E1DF-2C08-4681-8A48-CC5FDCA964CD}"/>
          </ac:spMkLst>
        </pc:spChg>
        <pc:spChg chg="del mod">
          <ac:chgData name="Yang, Shengming - ARS" userId="37bd5b25-7571-49cb-bfc8-588a18706c35" providerId="ADAL" clId="{1CEC4EA3-DB05-44BE-AF57-7E2779412AED}" dt="2021-12-17T19:25:24.148" v="1381" actId="478"/>
          <ac:spMkLst>
            <pc:docMk/>
            <pc:sldMk cId="3161562260" sldId="283"/>
            <ac:spMk id="3" creationId="{8E9ED299-84F3-496D-AEBD-B1FC11F97E02}"/>
          </ac:spMkLst>
        </pc:spChg>
        <pc:spChg chg="add mod">
          <ac:chgData name="Yang, Shengming - ARS" userId="37bd5b25-7571-49cb-bfc8-588a18706c35" providerId="ADAL" clId="{1CEC4EA3-DB05-44BE-AF57-7E2779412AED}" dt="2021-12-17T19:39:41.285" v="1592" actId="1076"/>
          <ac:spMkLst>
            <pc:docMk/>
            <pc:sldMk cId="3161562260" sldId="283"/>
            <ac:spMk id="5" creationId="{E2BD0D26-E684-4309-A4E1-0F3D7206D0E0}"/>
          </ac:spMkLst>
        </pc:spChg>
        <pc:spChg chg="add mod">
          <ac:chgData name="Yang, Shengming - ARS" userId="37bd5b25-7571-49cb-bfc8-588a18706c35" providerId="ADAL" clId="{1CEC4EA3-DB05-44BE-AF57-7E2779412AED}" dt="2021-12-17T19:25:27.605" v="1383" actId="1076"/>
          <ac:spMkLst>
            <pc:docMk/>
            <pc:sldMk cId="3161562260" sldId="283"/>
            <ac:spMk id="6" creationId="{00CB93E8-3871-4314-915D-1A6D23580C12}"/>
          </ac:spMkLst>
        </pc:spChg>
        <pc:spChg chg="add mod">
          <ac:chgData name="Yang, Shengming - ARS" userId="37bd5b25-7571-49cb-bfc8-588a18706c35" providerId="ADAL" clId="{1CEC4EA3-DB05-44BE-AF57-7E2779412AED}" dt="2021-12-17T19:39:41.285" v="1592" actId="1076"/>
          <ac:spMkLst>
            <pc:docMk/>
            <pc:sldMk cId="3161562260" sldId="283"/>
            <ac:spMk id="7" creationId="{6B5D02AE-A96B-4B49-AC76-99C0549859AF}"/>
          </ac:spMkLst>
        </pc:spChg>
        <pc:spChg chg="add mod">
          <ac:chgData name="Yang, Shengming - ARS" userId="37bd5b25-7571-49cb-bfc8-588a18706c35" providerId="ADAL" clId="{1CEC4EA3-DB05-44BE-AF57-7E2779412AED}" dt="2021-12-17T19:39:41.285" v="1592" actId="1076"/>
          <ac:spMkLst>
            <pc:docMk/>
            <pc:sldMk cId="3161562260" sldId="283"/>
            <ac:spMk id="8" creationId="{8F9B1C04-E6D0-4D94-BFBA-5FE59E2C2A0B}"/>
          </ac:spMkLst>
        </pc:spChg>
        <pc:spChg chg="add mod">
          <ac:chgData name="Yang, Shengming - ARS" userId="37bd5b25-7571-49cb-bfc8-588a18706c35" providerId="ADAL" clId="{1CEC4EA3-DB05-44BE-AF57-7E2779412AED}" dt="2021-12-17T19:39:41.285" v="1592" actId="1076"/>
          <ac:spMkLst>
            <pc:docMk/>
            <pc:sldMk cId="3161562260" sldId="283"/>
            <ac:spMk id="9" creationId="{BDB59B55-CAEF-4FA2-A583-5811AAAE98BD}"/>
          </ac:spMkLst>
        </pc:spChg>
        <pc:spChg chg="add mod">
          <ac:chgData name="Yang, Shengming - ARS" userId="37bd5b25-7571-49cb-bfc8-588a18706c35" providerId="ADAL" clId="{1CEC4EA3-DB05-44BE-AF57-7E2779412AED}" dt="2021-12-17T19:39:41.285" v="1592" actId="1076"/>
          <ac:spMkLst>
            <pc:docMk/>
            <pc:sldMk cId="3161562260" sldId="283"/>
            <ac:spMk id="10" creationId="{D66E3EA0-349D-4810-BFE8-1863FB98957A}"/>
          </ac:spMkLst>
        </pc:spChg>
        <pc:spChg chg="add mod">
          <ac:chgData name="Yang, Shengming - ARS" userId="37bd5b25-7571-49cb-bfc8-588a18706c35" providerId="ADAL" clId="{1CEC4EA3-DB05-44BE-AF57-7E2779412AED}" dt="2021-12-17T19:31:20.805" v="1520" actId="14100"/>
          <ac:spMkLst>
            <pc:docMk/>
            <pc:sldMk cId="3161562260" sldId="283"/>
            <ac:spMk id="15" creationId="{D0C186DE-5306-4BCD-AFC5-6B935AAE1E14}"/>
          </ac:spMkLst>
        </pc:spChg>
        <pc:spChg chg="add mod">
          <ac:chgData name="Yang, Shengming - ARS" userId="37bd5b25-7571-49cb-bfc8-588a18706c35" providerId="ADAL" clId="{1CEC4EA3-DB05-44BE-AF57-7E2779412AED}" dt="2021-12-17T19:31:20.805" v="1520" actId="14100"/>
          <ac:spMkLst>
            <pc:docMk/>
            <pc:sldMk cId="3161562260" sldId="283"/>
            <ac:spMk id="16" creationId="{73417ACE-C7C7-46D4-AB92-3B4BE10A8B80}"/>
          </ac:spMkLst>
        </pc:spChg>
        <pc:spChg chg="add mod">
          <ac:chgData name="Yang, Shengming - ARS" userId="37bd5b25-7571-49cb-bfc8-588a18706c35" providerId="ADAL" clId="{1CEC4EA3-DB05-44BE-AF57-7E2779412AED}" dt="2021-12-17T19:31:20.805" v="1520" actId="14100"/>
          <ac:spMkLst>
            <pc:docMk/>
            <pc:sldMk cId="3161562260" sldId="283"/>
            <ac:spMk id="17" creationId="{EF30B42F-B2D3-4F6C-82E9-5EE0601F2E0B}"/>
          </ac:spMkLst>
        </pc:spChg>
        <pc:spChg chg="add mod">
          <ac:chgData name="Yang, Shengming - ARS" userId="37bd5b25-7571-49cb-bfc8-588a18706c35" providerId="ADAL" clId="{1CEC4EA3-DB05-44BE-AF57-7E2779412AED}" dt="2021-12-17T19:32:56.339" v="1546" actId="1076"/>
          <ac:spMkLst>
            <pc:docMk/>
            <pc:sldMk cId="3161562260" sldId="283"/>
            <ac:spMk id="18" creationId="{BBB310B0-79EF-49D9-AEDB-5498AF731FED}"/>
          </ac:spMkLst>
        </pc:spChg>
        <pc:spChg chg="add mod">
          <ac:chgData name="Yang, Shengming - ARS" userId="37bd5b25-7571-49cb-bfc8-588a18706c35" providerId="ADAL" clId="{1CEC4EA3-DB05-44BE-AF57-7E2779412AED}" dt="2021-12-17T19:33:17.107" v="1549" actId="1076"/>
          <ac:spMkLst>
            <pc:docMk/>
            <pc:sldMk cId="3161562260" sldId="283"/>
            <ac:spMk id="19" creationId="{0F7A8E18-9C7A-4C86-B619-6CCC77F46459}"/>
          </ac:spMkLst>
        </pc:spChg>
        <pc:spChg chg="add mod">
          <ac:chgData name="Yang, Shengming - ARS" userId="37bd5b25-7571-49cb-bfc8-588a18706c35" providerId="ADAL" clId="{1CEC4EA3-DB05-44BE-AF57-7E2779412AED}" dt="2021-12-17T19:34:35.676" v="1560" actId="1036"/>
          <ac:spMkLst>
            <pc:docMk/>
            <pc:sldMk cId="3161562260" sldId="283"/>
            <ac:spMk id="20" creationId="{87DBDD65-7C4B-4A09-9FE8-241947E11861}"/>
          </ac:spMkLst>
        </pc:spChg>
        <pc:spChg chg="add del mod">
          <ac:chgData name="Yang, Shengming - ARS" userId="37bd5b25-7571-49cb-bfc8-588a18706c35" providerId="ADAL" clId="{1CEC4EA3-DB05-44BE-AF57-7E2779412AED}" dt="2021-12-17T19:35:30.823" v="1569" actId="478"/>
          <ac:spMkLst>
            <pc:docMk/>
            <pc:sldMk cId="3161562260" sldId="283"/>
            <ac:spMk id="21" creationId="{29B57C36-2D16-4171-91D6-29880FD6EAC4}"/>
          </ac:spMkLst>
        </pc:spChg>
        <pc:spChg chg="add del mod">
          <ac:chgData name="Yang, Shengming - ARS" userId="37bd5b25-7571-49cb-bfc8-588a18706c35" providerId="ADAL" clId="{1CEC4EA3-DB05-44BE-AF57-7E2779412AED}" dt="2021-12-17T19:35:22.217" v="1566" actId="478"/>
          <ac:spMkLst>
            <pc:docMk/>
            <pc:sldMk cId="3161562260" sldId="283"/>
            <ac:spMk id="22" creationId="{4EB91606-BD82-4175-984E-43D8D334F332}"/>
          </ac:spMkLst>
        </pc:spChg>
        <pc:spChg chg="add mod">
          <ac:chgData name="Yang, Shengming - ARS" userId="37bd5b25-7571-49cb-bfc8-588a18706c35" providerId="ADAL" clId="{1CEC4EA3-DB05-44BE-AF57-7E2779412AED}" dt="2021-12-17T21:59:05.806" v="1747" actId="1037"/>
          <ac:spMkLst>
            <pc:docMk/>
            <pc:sldMk cId="3161562260" sldId="283"/>
            <ac:spMk id="23" creationId="{3FD2A3E2-01CC-4C02-AED0-6F57BD63ABCB}"/>
          </ac:spMkLst>
        </pc:spChg>
        <pc:spChg chg="add mod">
          <ac:chgData name="Yang, Shengming - ARS" userId="37bd5b25-7571-49cb-bfc8-588a18706c35" providerId="ADAL" clId="{1CEC4EA3-DB05-44BE-AF57-7E2779412AED}" dt="2021-12-17T19:35:40.900" v="1570" actId="1076"/>
          <ac:spMkLst>
            <pc:docMk/>
            <pc:sldMk cId="3161562260" sldId="283"/>
            <ac:spMk id="24" creationId="{E4BAC983-E2D0-4C6B-8CC1-1847A1AEE69F}"/>
          </ac:spMkLst>
        </pc:spChg>
        <pc:spChg chg="add mod">
          <ac:chgData name="Yang, Shengming - ARS" userId="37bd5b25-7571-49cb-bfc8-588a18706c35" providerId="ADAL" clId="{1CEC4EA3-DB05-44BE-AF57-7E2779412AED}" dt="2021-12-17T19:36:00.871" v="1572" actId="1076"/>
          <ac:spMkLst>
            <pc:docMk/>
            <pc:sldMk cId="3161562260" sldId="283"/>
            <ac:spMk id="25" creationId="{29C3D798-A15C-4CBD-B7D3-CC694441C8C7}"/>
          </ac:spMkLst>
        </pc:spChg>
        <pc:spChg chg="add mod">
          <ac:chgData name="Yang, Shengming - ARS" userId="37bd5b25-7571-49cb-bfc8-588a18706c35" providerId="ADAL" clId="{1CEC4EA3-DB05-44BE-AF57-7E2779412AED}" dt="2021-12-17T19:38:22.006" v="1589" actId="1076"/>
          <ac:spMkLst>
            <pc:docMk/>
            <pc:sldMk cId="3161562260" sldId="283"/>
            <ac:spMk id="26" creationId="{9B898974-7798-463F-9982-05850CAB45A5}"/>
          </ac:spMkLst>
        </pc:spChg>
        <pc:spChg chg="add del">
          <ac:chgData name="Yang, Shengming - ARS" userId="37bd5b25-7571-49cb-bfc8-588a18706c35" providerId="ADAL" clId="{1CEC4EA3-DB05-44BE-AF57-7E2779412AED}" dt="2021-12-17T19:37:17.512" v="1576" actId="478"/>
          <ac:spMkLst>
            <pc:docMk/>
            <pc:sldMk cId="3161562260" sldId="283"/>
            <ac:spMk id="28" creationId="{CE151DAA-6817-4FE4-9A5F-4F75199524CE}"/>
          </ac:spMkLst>
        </pc:spChg>
        <pc:spChg chg="add mod">
          <ac:chgData name="Yang, Shengming - ARS" userId="37bd5b25-7571-49cb-bfc8-588a18706c35" providerId="ADAL" clId="{1CEC4EA3-DB05-44BE-AF57-7E2779412AED}" dt="2021-12-17T19:38:28.578" v="1590" actId="1076"/>
          <ac:spMkLst>
            <pc:docMk/>
            <pc:sldMk cId="3161562260" sldId="283"/>
            <ac:spMk id="29" creationId="{C0EAD2EE-9202-427B-889B-A230C6AD52EE}"/>
          </ac:spMkLst>
        </pc:spChg>
        <pc:spChg chg="add mod">
          <ac:chgData name="Yang, Shengming - ARS" userId="37bd5b25-7571-49cb-bfc8-588a18706c35" providerId="ADAL" clId="{1CEC4EA3-DB05-44BE-AF57-7E2779412AED}" dt="2021-12-17T19:38:08.964" v="1586" actId="1076"/>
          <ac:spMkLst>
            <pc:docMk/>
            <pc:sldMk cId="3161562260" sldId="283"/>
            <ac:spMk id="30" creationId="{DB087481-6A71-47A6-9AC7-BB8CE779FA0F}"/>
          </ac:spMkLst>
        </pc:spChg>
        <pc:spChg chg="add mod">
          <ac:chgData name="Yang, Shengming - ARS" userId="37bd5b25-7571-49cb-bfc8-588a18706c35" providerId="ADAL" clId="{1CEC4EA3-DB05-44BE-AF57-7E2779412AED}" dt="2021-12-17T19:38:12.396" v="1587" actId="1076"/>
          <ac:spMkLst>
            <pc:docMk/>
            <pc:sldMk cId="3161562260" sldId="283"/>
            <ac:spMk id="31" creationId="{42E39D23-7995-444E-BD3E-C1F018FFE1B7}"/>
          </ac:spMkLst>
        </pc:spChg>
        <pc:picChg chg="add mod">
          <ac:chgData name="Yang, Shengming - ARS" userId="37bd5b25-7571-49cb-bfc8-588a18706c35" providerId="ADAL" clId="{1CEC4EA3-DB05-44BE-AF57-7E2779412AED}" dt="2021-12-17T19:39:41.285" v="1592" actId="1076"/>
          <ac:picMkLst>
            <pc:docMk/>
            <pc:sldMk cId="3161562260" sldId="283"/>
            <ac:picMk id="4" creationId="{B60F58E5-0C68-4CD5-B42C-7DE9F2F4B61D}"/>
          </ac:picMkLst>
        </pc:picChg>
        <pc:picChg chg="add del mod">
          <ac:chgData name="Yang, Shengming - ARS" userId="37bd5b25-7571-49cb-bfc8-588a18706c35" providerId="ADAL" clId="{1CEC4EA3-DB05-44BE-AF57-7E2779412AED}" dt="2021-12-17T19:34:10.407" v="1552" actId="478"/>
          <ac:picMkLst>
            <pc:docMk/>
            <pc:sldMk cId="3161562260" sldId="283"/>
            <ac:picMk id="12" creationId="{073F6E15-0FED-40E0-A947-98200D70C656}"/>
          </ac:picMkLst>
        </pc:picChg>
        <pc:picChg chg="add mod">
          <ac:chgData name="Yang, Shengming - ARS" userId="37bd5b25-7571-49cb-bfc8-588a18706c35" providerId="ADAL" clId="{1CEC4EA3-DB05-44BE-AF57-7E2779412AED}" dt="2021-12-17T19:39:54.284" v="1594" actId="1076"/>
          <ac:picMkLst>
            <pc:docMk/>
            <pc:sldMk cId="3161562260" sldId="283"/>
            <ac:picMk id="32" creationId="{449EC690-EC57-4819-AF95-3D64529F15F6}"/>
          </ac:picMkLst>
        </pc:picChg>
        <pc:picChg chg="add mod modCrop">
          <ac:chgData name="Yang, Shengming - ARS" userId="37bd5b25-7571-49cb-bfc8-588a18706c35" providerId="ADAL" clId="{1CEC4EA3-DB05-44BE-AF57-7E2779412AED}" dt="2021-12-17T19:43:11.745" v="1611" actId="18131"/>
          <ac:picMkLst>
            <pc:docMk/>
            <pc:sldMk cId="3161562260" sldId="283"/>
            <ac:picMk id="33" creationId="{EF9FEF66-1C62-41F5-81F1-16316F8B449C}"/>
          </ac:picMkLst>
        </pc:picChg>
        <pc:picChg chg="add mod">
          <ac:chgData name="Yang, Shengming - ARS" userId="37bd5b25-7571-49cb-bfc8-588a18706c35" providerId="ADAL" clId="{1CEC4EA3-DB05-44BE-AF57-7E2779412AED}" dt="2021-12-17T19:42:04.789" v="1605" actId="1076"/>
          <ac:picMkLst>
            <pc:docMk/>
            <pc:sldMk cId="3161562260" sldId="283"/>
            <ac:picMk id="34" creationId="{094E8038-731B-43A9-AF78-1344E140F818}"/>
          </ac:picMkLst>
        </pc:picChg>
        <pc:picChg chg="add mod">
          <ac:chgData name="Yang, Shengming - ARS" userId="37bd5b25-7571-49cb-bfc8-588a18706c35" providerId="ADAL" clId="{1CEC4EA3-DB05-44BE-AF57-7E2779412AED}" dt="2021-12-17T19:43:52.132" v="1617" actId="14100"/>
          <ac:picMkLst>
            <pc:docMk/>
            <pc:sldMk cId="3161562260" sldId="283"/>
            <ac:picMk id="35" creationId="{745C001A-D968-411D-967A-269A9A402FD0}"/>
          </ac:picMkLst>
        </pc:picChg>
        <pc:picChg chg="add mod modCrop">
          <ac:chgData name="Yang, Shengming - ARS" userId="37bd5b25-7571-49cb-bfc8-588a18706c35" providerId="ADAL" clId="{1CEC4EA3-DB05-44BE-AF57-7E2779412AED}" dt="2021-12-17T19:44:12.744" v="1618" actId="18131"/>
          <ac:picMkLst>
            <pc:docMk/>
            <pc:sldMk cId="3161562260" sldId="283"/>
            <ac:picMk id="36" creationId="{821896F8-755C-447C-B3AB-FD278D386654}"/>
          </ac:picMkLst>
        </pc:picChg>
        <pc:picChg chg="add mod">
          <ac:chgData name="Yang, Shengming - ARS" userId="37bd5b25-7571-49cb-bfc8-588a18706c35" providerId="ADAL" clId="{1CEC4EA3-DB05-44BE-AF57-7E2779412AED}" dt="2021-12-17T19:43:32.196" v="1614" actId="1076"/>
          <ac:picMkLst>
            <pc:docMk/>
            <pc:sldMk cId="3161562260" sldId="283"/>
            <ac:picMk id="37" creationId="{C2B3FB3C-31C6-4288-924D-874795D58FEB}"/>
          </ac:picMkLst>
        </pc:picChg>
        <pc:picChg chg="add mod">
          <ac:chgData name="Yang, Shengming - ARS" userId="37bd5b25-7571-49cb-bfc8-588a18706c35" providerId="ADAL" clId="{1CEC4EA3-DB05-44BE-AF57-7E2779412AED}" dt="2021-12-17T19:44:24.956" v="1621" actId="1076"/>
          <ac:picMkLst>
            <pc:docMk/>
            <pc:sldMk cId="3161562260" sldId="283"/>
            <ac:picMk id="38" creationId="{B7A19B21-874C-4169-B186-FCABA8034826}"/>
          </ac:picMkLst>
        </pc:picChg>
        <pc:cxnChg chg="add mod">
          <ac:chgData name="Yang, Shengming - ARS" userId="37bd5b25-7571-49cb-bfc8-588a18706c35" providerId="ADAL" clId="{1CEC4EA3-DB05-44BE-AF57-7E2779412AED}" dt="2021-12-17T19:31:38.552" v="1529" actId="1037"/>
          <ac:cxnSpMkLst>
            <pc:docMk/>
            <pc:sldMk cId="3161562260" sldId="283"/>
            <ac:cxnSpMk id="14" creationId="{99C7A676-A738-4063-A92D-FDBAED393C29}"/>
          </ac:cxnSpMkLst>
        </pc:cxnChg>
      </pc:sldChg>
      <pc:sldChg chg="addSp delSp modSp add mod ord">
        <pc:chgData name="Yang, Shengming - ARS" userId="37bd5b25-7571-49cb-bfc8-588a18706c35" providerId="ADAL" clId="{1CEC4EA3-DB05-44BE-AF57-7E2779412AED}" dt="2021-12-20T15:50:05.601" v="1896"/>
        <pc:sldMkLst>
          <pc:docMk/>
          <pc:sldMk cId="2625937353" sldId="284"/>
        </pc:sldMkLst>
        <pc:spChg chg="del mod">
          <ac:chgData name="Yang, Shengming - ARS" userId="37bd5b25-7571-49cb-bfc8-588a18706c35" providerId="ADAL" clId="{1CEC4EA3-DB05-44BE-AF57-7E2779412AED}" dt="2021-12-17T22:09:54.698" v="1888" actId="478"/>
          <ac:spMkLst>
            <pc:docMk/>
            <pc:sldMk cId="2625937353" sldId="284"/>
            <ac:spMk id="5" creationId="{E2BD0D26-E684-4309-A4E1-0F3D7206D0E0}"/>
          </ac:spMkLst>
        </pc:spChg>
        <pc:spChg chg="mod">
          <ac:chgData name="Yang, Shengming - ARS" userId="37bd5b25-7571-49cb-bfc8-588a18706c35" providerId="ADAL" clId="{1CEC4EA3-DB05-44BE-AF57-7E2779412AED}" dt="2021-12-17T22:07:11.421" v="1843" actId="1037"/>
          <ac:spMkLst>
            <pc:docMk/>
            <pc:sldMk cId="2625937353" sldId="284"/>
            <ac:spMk id="6" creationId="{00CB93E8-3871-4314-915D-1A6D23580C12}"/>
          </ac:spMkLst>
        </pc:spChg>
        <pc:spChg chg="del">
          <ac:chgData name="Yang, Shengming - ARS" userId="37bd5b25-7571-49cb-bfc8-588a18706c35" providerId="ADAL" clId="{1CEC4EA3-DB05-44BE-AF57-7E2779412AED}" dt="2021-12-17T22:09:54.698" v="1888" actId="478"/>
          <ac:spMkLst>
            <pc:docMk/>
            <pc:sldMk cId="2625937353" sldId="284"/>
            <ac:spMk id="7" creationId="{6B5D02AE-A96B-4B49-AC76-99C0549859AF}"/>
          </ac:spMkLst>
        </pc:spChg>
        <pc:spChg chg="del">
          <ac:chgData name="Yang, Shengming - ARS" userId="37bd5b25-7571-49cb-bfc8-588a18706c35" providerId="ADAL" clId="{1CEC4EA3-DB05-44BE-AF57-7E2779412AED}" dt="2021-12-17T22:09:54.698" v="1888" actId="478"/>
          <ac:spMkLst>
            <pc:docMk/>
            <pc:sldMk cId="2625937353" sldId="284"/>
            <ac:spMk id="8" creationId="{8F9B1C04-E6D0-4D94-BFBA-5FE59E2C2A0B}"/>
          </ac:spMkLst>
        </pc:spChg>
        <pc:spChg chg="del">
          <ac:chgData name="Yang, Shengming - ARS" userId="37bd5b25-7571-49cb-bfc8-588a18706c35" providerId="ADAL" clId="{1CEC4EA3-DB05-44BE-AF57-7E2779412AED}" dt="2021-12-17T22:09:54.698" v="1888" actId="478"/>
          <ac:spMkLst>
            <pc:docMk/>
            <pc:sldMk cId="2625937353" sldId="284"/>
            <ac:spMk id="9" creationId="{BDB59B55-CAEF-4FA2-A583-5811AAAE98BD}"/>
          </ac:spMkLst>
        </pc:spChg>
        <pc:spChg chg="del">
          <ac:chgData name="Yang, Shengming - ARS" userId="37bd5b25-7571-49cb-bfc8-588a18706c35" providerId="ADAL" clId="{1CEC4EA3-DB05-44BE-AF57-7E2779412AED}" dt="2021-12-17T22:09:54.698" v="1888" actId="478"/>
          <ac:spMkLst>
            <pc:docMk/>
            <pc:sldMk cId="2625937353" sldId="284"/>
            <ac:spMk id="10" creationId="{D66E3EA0-349D-4810-BFE8-1863FB98957A}"/>
          </ac:spMkLst>
        </pc:spChg>
        <pc:spChg chg="mod">
          <ac:chgData name="Yang, Shengming - ARS" userId="37bd5b25-7571-49cb-bfc8-588a18706c35" providerId="ADAL" clId="{1CEC4EA3-DB05-44BE-AF57-7E2779412AED}" dt="2021-12-17T19:46:50.278" v="1654" actId="14100"/>
          <ac:spMkLst>
            <pc:docMk/>
            <pc:sldMk cId="2625937353" sldId="284"/>
            <ac:spMk id="15" creationId="{D0C186DE-5306-4BCD-AFC5-6B935AAE1E14}"/>
          </ac:spMkLst>
        </pc:spChg>
        <pc:spChg chg="mod">
          <ac:chgData name="Yang, Shengming - ARS" userId="37bd5b25-7571-49cb-bfc8-588a18706c35" providerId="ADAL" clId="{1CEC4EA3-DB05-44BE-AF57-7E2779412AED}" dt="2021-12-17T19:47:28.220" v="1694" actId="1037"/>
          <ac:spMkLst>
            <pc:docMk/>
            <pc:sldMk cId="2625937353" sldId="284"/>
            <ac:spMk id="16" creationId="{73417ACE-C7C7-46D4-AB92-3B4BE10A8B80}"/>
          </ac:spMkLst>
        </pc:spChg>
        <pc:spChg chg="mod">
          <ac:chgData name="Yang, Shengming - ARS" userId="37bd5b25-7571-49cb-bfc8-588a18706c35" providerId="ADAL" clId="{1CEC4EA3-DB05-44BE-AF57-7E2779412AED}" dt="2021-12-17T19:46:50.278" v="1654" actId="14100"/>
          <ac:spMkLst>
            <pc:docMk/>
            <pc:sldMk cId="2625937353" sldId="284"/>
            <ac:spMk id="17" creationId="{EF30B42F-B2D3-4F6C-82E9-5EE0601F2E0B}"/>
          </ac:spMkLst>
        </pc:spChg>
        <pc:spChg chg="mod">
          <ac:chgData name="Yang, Shengming - ARS" userId="37bd5b25-7571-49cb-bfc8-588a18706c35" providerId="ADAL" clId="{1CEC4EA3-DB05-44BE-AF57-7E2779412AED}" dt="2021-12-17T22:10:18.827" v="1889" actId="1076"/>
          <ac:spMkLst>
            <pc:docMk/>
            <pc:sldMk cId="2625937353" sldId="284"/>
            <ac:spMk id="18" creationId="{BBB310B0-79EF-49D9-AEDB-5498AF731FED}"/>
          </ac:spMkLst>
        </pc:spChg>
        <pc:spChg chg="mod">
          <ac:chgData name="Yang, Shengming - ARS" userId="37bd5b25-7571-49cb-bfc8-588a18706c35" providerId="ADAL" clId="{1CEC4EA3-DB05-44BE-AF57-7E2779412AED}" dt="2021-12-17T19:46:59.979" v="1657" actId="1035"/>
          <ac:spMkLst>
            <pc:docMk/>
            <pc:sldMk cId="2625937353" sldId="284"/>
            <ac:spMk id="19" creationId="{0F7A8E18-9C7A-4C86-B619-6CCC77F46459}"/>
          </ac:spMkLst>
        </pc:spChg>
        <pc:spChg chg="mod">
          <ac:chgData name="Yang, Shengming - ARS" userId="37bd5b25-7571-49cb-bfc8-588a18706c35" providerId="ADAL" clId="{1CEC4EA3-DB05-44BE-AF57-7E2779412AED}" dt="2021-12-17T22:00:20.500" v="1750" actId="1076"/>
          <ac:spMkLst>
            <pc:docMk/>
            <pc:sldMk cId="2625937353" sldId="284"/>
            <ac:spMk id="23" creationId="{3FD2A3E2-01CC-4C02-AED0-6F57BD63ABCB}"/>
          </ac:spMkLst>
        </pc:spChg>
        <pc:spChg chg="mod">
          <ac:chgData name="Yang, Shengming - ARS" userId="37bd5b25-7571-49cb-bfc8-588a18706c35" providerId="ADAL" clId="{1CEC4EA3-DB05-44BE-AF57-7E2779412AED}" dt="2021-12-17T22:05:06.425" v="1792" actId="1038"/>
          <ac:spMkLst>
            <pc:docMk/>
            <pc:sldMk cId="2625937353" sldId="284"/>
            <ac:spMk id="26" creationId="{9B898974-7798-463F-9982-05850CAB45A5}"/>
          </ac:spMkLst>
        </pc:spChg>
        <pc:spChg chg="mod">
          <ac:chgData name="Yang, Shengming - ARS" userId="37bd5b25-7571-49cb-bfc8-588a18706c35" providerId="ADAL" clId="{1CEC4EA3-DB05-44BE-AF57-7E2779412AED}" dt="2021-12-17T22:07:03.239" v="1834" actId="1038"/>
          <ac:spMkLst>
            <pc:docMk/>
            <pc:sldMk cId="2625937353" sldId="284"/>
            <ac:spMk id="29" creationId="{C0EAD2EE-9202-427B-889B-A230C6AD52EE}"/>
          </ac:spMkLst>
        </pc:spChg>
        <pc:spChg chg="mod">
          <ac:chgData name="Yang, Shengming - ARS" userId="37bd5b25-7571-49cb-bfc8-588a18706c35" providerId="ADAL" clId="{1CEC4EA3-DB05-44BE-AF57-7E2779412AED}" dt="2021-12-17T22:07:26.163" v="1870" actId="1038"/>
          <ac:spMkLst>
            <pc:docMk/>
            <pc:sldMk cId="2625937353" sldId="284"/>
            <ac:spMk id="30" creationId="{DB087481-6A71-47A6-9AC7-BB8CE779FA0F}"/>
          </ac:spMkLst>
        </pc:spChg>
        <pc:spChg chg="mod">
          <ac:chgData name="Yang, Shengming - ARS" userId="37bd5b25-7571-49cb-bfc8-588a18706c35" providerId="ADAL" clId="{1CEC4EA3-DB05-44BE-AF57-7E2779412AED}" dt="2021-12-17T22:06:54.242" v="1810" actId="1038"/>
          <ac:spMkLst>
            <pc:docMk/>
            <pc:sldMk cId="2625937353" sldId="284"/>
            <ac:spMk id="31" creationId="{42E39D23-7995-444E-BD3E-C1F018FFE1B7}"/>
          </ac:spMkLst>
        </pc:spChg>
        <pc:spChg chg="add mod">
          <ac:chgData name="Yang, Shengming - ARS" userId="37bd5b25-7571-49cb-bfc8-588a18706c35" providerId="ADAL" clId="{1CEC4EA3-DB05-44BE-AF57-7E2779412AED}" dt="2021-12-17T19:47:53.117" v="1700" actId="1076"/>
          <ac:spMkLst>
            <pc:docMk/>
            <pc:sldMk cId="2625937353" sldId="284"/>
            <ac:spMk id="39" creationId="{397F490C-7EB1-4EFA-BB3D-77E42EE14657}"/>
          </ac:spMkLst>
        </pc:spChg>
        <pc:spChg chg="add mod">
          <ac:chgData name="Yang, Shengming - ARS" userId="37bd5b25-7571-49cb-bfc8-588a18706c35" providerId="ADAL" clId="{1CEC4EA3-DB05-44BE-AF57-7E2779412AED}" dt="2021-12-17T19:47:45.881" v="1699" actId="20577"/>
          <ac:spMkLst>
            <pc:docMk/>
            <pc:sldMk cId="2625937353" sldId="284"/>
            <ac:spMk id="40" creationId="{DDA24DDD-7F88-43FD-84E8-8D69317885D8}"/>
          </ac:spMkLst>
        </pc:spChg>
        <pc:spChg chg="add mod">
          <ac:chgData name="Yang, Shengming - ARS" userId="37bd5b25-7571-49cb-bfc8-588a18706c35" providerId="ADAL" clId="{1CEC4EA3-DB05-44BE-AF57-7E2779412AED}" dt="2021-12-17T19:48:04.310" v="1703" actId="20577"/>
          <ac:spMkLst>
            <pc:docMk/>
            <pc:sldMk cId="2625937353" sldId="284"/>
            <ac:spMk id="41" creationId="{B1F04B0A-EB32-4F64-A227-03FBA9B8613F}"/>
          </ac:spMkLst>
        </pc:spChg>
        <pc:spChg chg="add mod">
          <ac:chgData name="Yang, Shengming - ARS" userId="37bd5b25-7571-49cb-bfc8-588a18706c35" providerId="ADAL" clId="{1CEC4EA3-DB05-44BE-AF57-7E2779412AED}" dt="2021-12-17T19:48:24.915" v="1707" actId="20577"/>
          <ac:spMkLst>
            <pc:docMk/>
            <pc:sldMk cId="2625937353" sldId="284"/>
            <ac:spMk id="42" creationId="{B2E2514F-3C62-4A36-8AAB-8245B567DE9D}"/>
          </ac:spMkLst>
        </pc:spChg>
        <pc:spChg chg="add mod">
          <ac:chgData name="Yang, Shengming - ARS" userId="37bd5b25-7571-49cb-bfc8-588a18706c35" providerId="ADAL" clId="{1CEC4EA3-DB05-44BE-AF57-7E2779412AED}" dt="2021-12-17T19:48:36.089" v="1711" actId="20577"/>
          <ac:spMkLst>
            <pc:docMk/>
            <pc:sldMk cId="2625937353" sldId="284"/>
            <ac:spMk id="43" creationId="{124F71AF-7115-4C5C-8142-05CD1077714A}"/>
          </ac:spMkLst>
        </pc:spChg>
        <pc:spChg chg="add mod">
          <ac:chgData name="Yang, Shengming - ARS" userId="37bd5b25-7571-49cb-bfc8-588a18706c35" providerId="ADAL" clId="{1CEC4EA3-DB05-44BE-AF57-7E2779412AED}" dt="2021-12-17T22:01:09.018" v="1782" actId="1037"/>
          <ac:spMkLst>
            <pc:docMk/>
            <pc:sldMk cId="2625937353" sldId="284"/>
            <ac:spMk id="44" creationId="{5036E2C2-D0C3-4912-979E-CE0E97BFE4C7}"/>
          </ac:spMkLst>
        </pc:spChg>
        <pc:spChg chg="add mod">
          <ac:chgData name="Yang, Shengming - ARS" userId="37bd5b25-7571-49cb-bfc8-588a18706c35" providerId="ADAL" clId="{1CEC4EA3-DB05-44BE-AF57-7E2779412AED}" dt="2021-12-17T22:08:02.321" v="1879" actId="1076"/>
          <ac:spMkLst>
            <pc:docMk/>
            <pc:sldMk cId="2625937353" sldId="284"/>
            <ac:spMk id="45" creationId="{561A173B-C821-49F3-875D-7AFC1E02CE2F}"/>
          </ac:spMkLst>
        </pc:spChg>
        <pc:spChg chg="add mod">
          <ac:chgData name="Yang, Shengming - ARS" userId="37bd5b25-7571-49cb-bfc8-588a18706c35" providerId="ADAL" clId="{1CEC4EA3-DB05-44BE-AF57-7E2779412AED}" dt="2021-12-17T22:08:06.029" v="1880" actId="20577"/>
          <ac:spMkLst>
            <pc:docMk/>
            <pc:sldMk cId="2625937353" sldId="284"/>
            <ac:spMk id="46" creationId="{1C334073-8210-401F-ABDE-84BF451B23A4}"/>
          </ac:spMkLst>
        </pc:spChg>
        <pc:spChg chg="add mod">
          <ac:chgData name="Yang, Shengming - ARS" userId="37bd5b25-7571-49cb-bfc8-588a18706c35" providerId="ADAL" clId="{1CEC4EA3-DB05-44BE-AF57-7E2779412AED}" dt="2021-12-17T22:08:17.118" v="1883" actId="20577"/>
          <ac:spMkLst>
            <pc:docMk/>
            <pc:sldMk cId="2625937353" sldId="284"/>
            <ac:spMk id="47" creationId="{D320BB33-AD7F-4672-849A-58E930A112F8}"/>
          </ac:spMkLst>
        </pc:spChg>
        <pc:spChg chg="add mod">
          <ac:chgData name="Yang, Shengming - ARS" userId="37bd5b25-7571-49cb-bfc8-588a18706c35" providerId="ADAL" clId="{1CEC4EA3-DB05-44BE-AF57-7E2779412AED}" dt="2021-12-17T22:08:42.031" v="1887" actId="20577"/>
          <ac:spMkLst>
            <pc:docMk/>
            <pc:sldMk cId="2625937353" sldId="284"/>
            <ac:spMk id="48" creationId="{FAD047C0-A68E-42D3-ABA2-034D858DAD9A}"/>
          </ac:spMkLst>
        </pc:spChg>
        <pc:graphicFrameChg chg="add mod modGraphic">
          <ac:chgData name="Yang, Shengming - ARS" userId="37bd5b25-7571-49cb-bfc8-588a18706c35" providerId="ADAL" clId="{1CEC4EA3-DB05-44BE-AF57-7E2779412AED}" dt="2021-12-17T22:29:45.022" v="1894" actId="14100"/>
          <ac:graphicFrameMkLst>
            <pc:docMk/>
            <pc:sldMk cId="2625937353" sldId="284"/>
            <ac:graphicFrameMk id="3" creationId="{3184B4D2-9BCF-43C5-B7F7-49351A76A6E6}"/>
          </ac:graphicFrameMkLst>
        </pc:graphicFrameChg>
        <pc:picChg chg="add mod">
          <ac:chgData name="Yang, Shengming - ARS" userId="37bd5b25-7571-49cb-bfc8-588a18706c35" providerId="ADAL" clId="{1CEC4EA3-DB05-44BE-AF57-7E2779412AED}" dt="2021-12-17T19:52:34.202" v="1728" actId="1076"/>
          <ac:picMkLst>
            <pc:docMk/>
            <pc:sldMk cId="2625937353" sldId="284"/>
            <ac:picMk id="2" creationId="{7556588D-D216-4384-B5CD-01DA16987B6F}"/>
          </ac:picMkLst>
        </pc:picChg>
        <pc:picChg chg="add del">
          <ac:chgData name="Yang, Shengming - ARS" userId="37bd5b25-7571-49cb-bfc8-588a18706c35" providerId="ADAL" clId="{1CEC4EA3-DB05-44BE-AF57-7E2779412AED}" dt="2021-12-17T22:09:54.698" v="1888" actId="478"/>
          <ac:picMkLst>
            <pc:docMk/>
            <pc:sldMk cId="2625937353" sldId="284"/>
            <ac:picMk id="4" creationId="{B60F58E5-0C68-4CD5-B42C-7DE9F2F4B61D}"/>
          </ac:picMkLst>
        </pc:picChg>
        <pc:picChg chg="del">
          <ac:chgData name="Yang, Shengming - ARS" userId="37bd5b25-7571-49cb-bfc8-588a18706c35" providerId="ADAL" clId="{1CEC4EA3-DB05-44BE-AF57-7E2779412AED}" dt="2021-12-17T19:45:51.784" v="1623" actId="478"/>
          <ac:picMkLst>
            <pc:docMk/>
            <pc:sldMk cId="2625937353" sldId="284"/>
            <ac:picMk id="32" creationId="{449EC690-EC57-4819-AF95-3D64529F15F6}"/>
          </ac:picMkLst>
        </pc:picChg>
        <pc:picChg chg="del">
          <ac:chgData name="Yang, Shengming - ARS" userId="37bd5b25-7571-49cb-bfc8-588a18706c35" providerId="ADAL" clId="{1CEC4EA3-DB05-44BE-AF57-7E2779412AED}" dt="2021-12-17T19:45:55.832" v="1626" actId="478"/>
          <ac:picMkLst>
            <pc:docMk/>
            <pc:sldMk cId="2625937353" sldId="284"/>
            <ac:picMk id="33" creationId="{EF9FEF66-1C62-41F5-81F1-16316F8B449C}"/>
          </ac:picMkLst>
        </pc:picChg>
        <pc:picChg chg="del mod modCrop">
          <ac:chgData name="Yang, Shengming - ARS" userId="37bd5b25-7571-49cb-bfc8-588a18706c35" providerId="ADAL" clId="{1CEC4EA3-DB05-44BE-AF57-7E2779412AED}" dt="2021-12-17T22:09:54.698" v="1888" actId="478"/>
          <ac:picMkLst>
            <pc:docMk/>
            <pc:sldMk cId="2625937353" sldId="284"/>
            <ac:picMk id="34" creationId="{094E8038-731B-43A9-AF78-1344E140F818}"/>
          </ac:picMkLst>
        </pc:picChg>
        <pc:picChg chg="mod">
          <ac:chgData name="Yang, Shengming - ARS" userId="37bd5b25-7571-49cb-bfc8-588a18706c35" providerId="ADAL" clId="{1CEC4EA3-DB05-44BE-AF57-7E2779412AED}" dt="2021-12-17T19:52:28.024" v="1726" actId="1076"/>
          <ac:picMkLst>
            <pc:docMk/>
            <pc:sldMk cId="2625937353" sldId="284"/>
            <ac:picMk id="35" creationId="{745C001A-D968-411D-967A-269A9A402FD0}"/>
          </ac:picMkLst>
        </pc:picChg>
        <pc:picChg chg="del">
          <ac:chgData name="Yang, Shengming - ARS" userId="37bd5b25-7571-49cb-bfc8-588a18706c35" providerId="ADAL" clId="{1CEC4EA3-DB05-44BE-AF57-7E2779412AED}" dt="2021-12-17T19:45:56.408" v="1627" actId="478"/>
          <ac:picMkLst>
            <pc:docMk/>
            <pc:sldMk cId="2625937353" sldId="284"/>
            <ac:picMk id="36" creationId="{821896F8-755C-447C-B3AB-FD278D386654}"/>
          </ac:picMkLst>
        </pc:picChg>
        <pc:picChg chg="mod">
          <ac:chgData name="Yang, Shengming - ARS" userId="37bd5b25-7571-49cb-bfc8-588a18706c35" providerId="ADAL" clId="{1CEC4EA3-DB05-44BE-AF57-7E2779412AED}" dt="2021-12-17T19:52:30.308" v="1727" actId="1076"/>
          <ac:picMkLst>
            <pc:docMk/>
            <pc:sldMk cId="2625937353" sldId="284"/>
            <ac:picMk id="37" creationId="{C2B3FB3C-31C6-4288-924D-874795D58FEB}"/>
          </ac:picMkLst>
        </pc:picChg>
        <pc:picChg chg="mod">
          <ac:chgData name="Yang, Shengming - ARS" userId="37bd5b25-7571-49cb-bfc8-588a18706c35" providerId="ADAL" clId="{1CEC4EA3-DB05-44BE-AF57-7E2779412AED}" dt="2021-12-17T19:52:36.561" v="1729" actId="1076"/>
          <ac:picMkLst>
            <pc:docMk/>
            <pc:sldMk cId="2625937353" sldId="284"/>
            <ac:picMk id="38" creationId="{B7A19B21-874C-4169-B186-FCABA8034826}"/>
          </ac:picMkLst>
        </pc:picChg>
      </pc:sldChg>
      <pc:sldChg chg="add ord">
        <pc:chgData name="Yang, Shengming - ARS" userId="37bd5b25-7571-49cb-bfc8-588a18706c35" providerId="ADAL" clId="{1CEC4EA3-DB05-44BE-AF57-7E2779412AED}" dt="2021-12-22T20:20:36.296" v="2095"/>
        <pc:sldMkLst>
          <pc:docMk/>
          <pc:sldMk cId="2301416017" sldId="285"/>
        </pc:sldMkLst>
      </pc:sldChg>
      <pc:sldChg chg="add ord">
        <pc:chgData name="Yang, Shengming - ARS" userId="37bd5b25-7571-49cb-bfc8-588a18706c35" providerId="ADAL" clId="{1CEC4EA3-DB05-44BE-AF57-7E2779412AED}" dt="2021-12-23T19:43:43.681" v="2101"/>
        <pc:sldMkLst>
          <pc:docMk/>
          <pc:sldMk cId="2028917921" sldId="286"/>
        </pc:sldMkLst>
      </pc:sldChg>
    </pc:docChg>
  </pc:docChgLst>
  <pc:docChgLst>
    <pc:chgData name="Yang, Shengming - ARS" userId="37bd5b25-7571-49cb-bfc8-588a18706c35" providerId="ADAL" clId="{289504D4-974E-43B6-9BD4-CC07536E2F15}"/>
    <pc:docChg chg="undo custSel addSld delSld modSld sldOrd">
      <pc:chgData name="Yang, Shengming - ARS" userId="37bd5b25-7571-49cb-bfc8-588a18706c35" providerId="ADAL" clId="{289504D4-974E-43B6-9BD4-CC07536E2F15}" dt="2022-03-15T14:18:58.774" v="1468" actId="1076"/>
      <pc:docMkLst>
        <pc:docMk/>
      </pc:docMkLst>
      <pc:sldChg chg="delSp del mod">
        <pc:chgData name="Yang, Shengming - ARS" userId="37bd5b25-7571-49cb-bfc8-588a18706c35" providerId="ADAL" clId="{289504D4-974E-43B6-9BD4-CC07536E2F15}" dt="2022-03-03T19:34:54.196" v="928" actId="47"/>
        <pc:sldMkLst>
          <pc:docMk/>
          <pc:sldMk cId="187198215" sldId="256"/>
        </pc:sldMkLst>
        <pc:grpChg chg="del">
          <ac:chgData name="Yang, Shengming - ARS" userId="37bd5b25-7571-49cb-bfc8-588a18706c35" providerId="ADAL" clId="{289504D4-974E-43B6-9BD4-CC07536E2F15}" dt="2022-03-03T19:34:51.898" v="927" actId="478"/>
          <ac:grpSpMkLst>
            <pc:docMk/>
            <pc:sldMk cId="187198215" sldId="256"/>
            <ac:grpSpMk id="4" creationId="{4713D267-1D1C-445B-9270-5911825C9C0B}"/>
          </ac:grpSpMkLst>
        </pc:grpChg>
      </pc:sldChg>
      <pc:sldChg chg="addSp delSp modSp mod">
        <pc:chgData name="Yang, Shengming - ARS" userId="37bd5b25-7571-49cb-bfc8-588a18706c35" providerId="ADAL" clId="{289504D4-974E-43B6-9BD4-CC07536E2F15}" dt="2022-03-03T19:37:43.531" v="929" actId="1076"/>
        <pc:sldMkLst>
          <pc:docMk/>
          <pc:sldMk cId="3951076637" sldId="279"/>
        </pc:sldMkLst>
        <pc:spChg chg="mod topLvl">
          <ac:chgData name="Yang, Shengming - ARS" userId="37bd5b25-7571-49cb-bfc8-588a18706c35" providerId="ADAL" clId="{289504D4-974E-43B6-9BD4-CC07536E2F15}" dt="2022-03-01T23:40:08.702" v="907" actId="164"/>
          <ac:spMkLst>
            <pc:docMk/>
            <pc:sldMk cId="3951076637" sldId="279"/>
            <ac:spMk id="5" creationId="{145BD528-BFA0-4D45-9687-079068890D7E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9" creationId="{1DBA7A38-F1C2-43F1-B07B-6DB945F9489B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0" creationId="{3D2326B1-C546-4D12-8752-20DF7547E757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1" creationId="{9CEA8F64-D0F9-437A-B0CD-26A049A077C5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2" creationId="{9A1CB18C-708F-4490-8E3B-0E81F8B8F925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3" creationId="{90553A36-194B-4661-8528-8B1849BB7519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4" creationId="{C4F6644D-D88C-416B-A004-6086EFE2868C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5" creationId="{F3DED48D-CE70-40FE-A39D-B971BC9389C5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6" creationId="{E0E41763-64B4-493B-B8C5-44023B9A4868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7" creationId="{B88AA1AD-6740-41FB-8D03-55FD7DD6881F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8" creationId="{C11AFC66-BEAB-4A07-9543-1548CB6DFB82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19" creationId="{749D19CB-F2A5-4F3D-9AA1-9B63159D6EB5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0" creationId="{47C1E7A6-3888-4BF6-AF81-7889EAB920DA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1" creationId="{63AD6A1F-A67A-4E9B-B1F2-1AAA334BDE29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2" creationId="{2277B4F2-190F-4C43-BA86-871B416D3C6D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3" creationId="{8E58034F-46E8-4DEB-A53C-A4EFA9DF7AE5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4" creationId="{119F3634-2A44-4A1E-B9A1-20D2CD30BFE8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5" creationId="{DEDD0E87-E7AD-4F9C-810D-65C7C9B37EB3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6" creationId="{8EF545B0-FBB5-4A8A-AC3B-7EC09B4C7B60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7" creationId="{2579254F-6C34-4A01-B85F-1044A5595F64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8" creationId="{2681E759-E980-4D0E-8A19-3C6930055144}"/>
          </ac:spMkLst>
        </pc:spChg>
        <pc:spChg chg="del mod topLvl">
          <ac:chgData name="Yang, Shengming - ARS" userId="37bd5b25-7571-49cb-bfc8-588a18706c35" providerId="ADAL" clId="{289504D4-974E-43B6-9BD4-CC07536E2F15}" dt="2022-03-01T23:39:50.479" v="902" actId="478"/>
          <ac:spMkLst>
            <pc:docMk/>
            <pc:sldMk cId="3951076637" sldId="279"/>
            <ac:spMk id="29" creationId="{36469305-C272-4EBC-894D-2CF648336826}"/>
          </ac:spMkLst>
        </pc:spChg>
        <pc:spChg chg="mod topLvl">
          <ac:chgData name="Yang, Shengming - ARS" userId="37bd5b25-7571-49cb-bfc8-588a18706c35" providerId="ADAL" clId="{289504D4-974E-43B6-9BD4-CC07536E2F15}" dt="2022-03-01T23:40:08.702" v="907" actId="164"/>
          <ac:spMkLst>
            <pc:docMk/>
            <pc:sldMk cId="3951076637" sldId="279"/>
            <ac:spMk id="31" creationId="{8C88D3CF-522A-4F82-9D1E-F2BA0C73E44A}"/>
          </ac:spMkLst>
        </pc:spChg>
        <pc:spChg chg="mod">
          <ac:chgData name="Yang, Shengming - ARS" userId="37bd5b25-7571-49cb-bfc8-588a18706c35" providerId="ADAL" clId="{289504D4-974E-43B6-9BD4-CC07536E2F15}" dt="2022-03-01T23:40:16.288" v="910" actId="1076"/>
          <ac:spMkLst>
            <pc:docMk/>
            <pc:sldMk cId="3951076637" sldId="279"/>
            <ac:spMk id="33" creationId="{A3CCCF6D-3F3C-4533-B4BB-23BC1ECC5268}"/>
          </ac:spMkLst>
        </pc:spChg>
        <pc:grpChg chg="del">
          <ac:chgData name="Yang, Shengming - ARS" userId="37bd5b25-7571-49cb-bfc8-588a18706c35" providerId="ADAL" clId="{289504D4-974E-43B6-9BD4-CC07536E2F15}" dt="2022-03-01T23:39:46.177" v="901" actId="165"/>
          <ac:grpSpMkLst>
            <pc:docMk/>
            <pc:sldMk cId="3951076637" sldId="279"/>
            <ac:grpSpMk id="4" creationId="{AFBEF914-C123-4457-BA33-D246EBC7B174}"/>
          </ac:grpSpMkLst>
        </pc:grpChg>
        <pc:grpChg chg="add mod">
          <ac:chgData name="Yang, Shengming - ARS" userId="37bd5b25-7571-49cb-bfc8-588a18706c35" providerId="ADAL" clId="{289504D4-974E-43B6-9BD4-CC07536E2F15}" dt="2022-03-03T19:37:43.531" v="929" actId="1076"/>
          <ac:grpSpMkLst>
            <pc:docMk/>
            <pc:sldMk cId="3951076637" sldId="279"/>
            <ac:grpSpMk id="30" creationId="{50962A51-58E8-4470-B29C-EE836E9FB46F}"/>
          </ac:grpSpMkLst>
        </pc:grpChg>
        <pc:grpChg chg="mod">
          <ac:chgData name="Yang, Shengming - ARS" userId="37bd5b25-7571-49cb-bfc8-588a18706c35" providerId="ADAL" clId="{289504D4-974E-43B6-9BD4-CC07536E2F15}" dt="2022-03-01T23:40:08.702" v="907" actId="164"/>
          <ac:grpSpMkLst>
            <pc:docMk/>
            <pc:sldMk cId="3951076637" sldId="279"/>
            <ac:grpSpMk id="49" creationId="{C0231E8A-E728-4F57-9567-B5F93B699AA5}"/>
          </ac:grpSpMkLst>
        </pc:grpChg>
        <pc:graphicFrameChg chg="mod">
          <ac:chgData name="Yang, Shengming - ARS" userId="37bd5b25-7571-49cb-bfc8-588a18706c35" providerId="ADAL" clId="{289504D4-974E-43B6-9BD4-CC07536E2F15}" dt="2022-03-01T23:40:13.964" v="909" actId="1076"/>
          <ac:graphicFrameMkLst>
            <pc:docMk/>
            <pc:sldMk cId="3951076637" sldId="279"/>
            <ac:graphicFrameMk id="36" creationId="{6F1D622B-363F-4DE5-B31A-0E65AA636F7D}"/>
          </ac:graphicFrameMkLst>
        </pc:graphicFrameChg>
        <pc:picChg chg="add del mod">
          <ac:chgData name="Yang, Shengming - ARS" userId="37bd5b25-7571-49cb-bfc8-588a18706c35" providerId="ADAL" clId="{289504D4-974E-43B6-9BD4-CC07536E2F15}" dt="2022-03-01T23:39:38.419" v="900" actId="478"/>
          <ac:picMkLst>
            <pc:docMk/>
            <pc:sldMk cId="3951076637" sldId="279"/>
            <ac:picMk id="3" creationId="{58C293D0-1D7A-4D60-BF2F-84BF4F92FD55}"/>
          </ac:picMkLst>
        </pc:picChg>
        <pc:picChg chg="del mod topLvl">
          <ac:chgData name="Yang, Shengming - ARS" userId="37bd5b25-7571-49cb-bfc8-588a18706c35" providerId="ADAL" clId="{289504D4-974E-43B6-9BD4-CC07536E2F15}" dt="2022-03-01T23:39:50.479" v="902" actId="478"/>
          <ac:picMkLst>
            <pc:docMk/>
            <pc:sldMk cId="3951076637" sldId="279"/>
            <ac:picMk id="6" creationId="{D5D3F2C3-992B-4E29-AC45-94D57298A263}"/>
          </ac:picMkLst>
        </pc:picChg>
        <pc:picChg chg="del mod topLvl">
          <ac:chgData name="Yang, Shengming - ARS" userId="37bd5b25-7571-49cb-bfc8-588a18706c35" providerId="ADAL" clId="{289504D4-974E-43B6-9BD4-CC07536E2F15}" dt="2022-03-01T23:39:50.479" v="902" actId="478"/>
          <ac:picMkLst>
            <pc:docMk/>
            <pc:sldMk cId="3951076637" sldId="279"/>
            <ac:picMk id="7" creationId="{E65D33FD-4A8B-4730-B051-114648063CC8}"/>
          </ac:picMkLst>
        </pc:picChg>
        <pc:picChg chg="del">
          <ac:chgData name="Yang, Shengming - ARS" userId="37bd5b25-7571-49cb-bfc8-588a18706c35" providerId="ADAL" clId="{289504D4-974E-43B6-9BD4-CC07536E2F15}" dt="2022-03-01T23:39:36.456" v="899" actId="478"/>
          <ac:picMkLst>
            <pc:docMk/>
            <pc:sldMk cId="3951076637" sldId="279"/>
            <ac:picMk id="8" creationId="{03A0FCB9-0014-44CD-9C1E-29A0071AF403}"/>
          </ac:picMkLst>
        </pc:picChg>
        <pc:cxnChg chg="del mod topLvl">
          <ac:chgData name="Yang, Shengming - ARS" userId="37bd5b25-7571-49cb-bfc8-588a18706c35" providerId="ADAL" clId="{289504D4-974E-43B6-9BD4-CC07536E2F15}" dt="2022-03-01T23:39:50.479" v="902" actId="478"/>
          <ac:cxnSpMkLst>
            <pc:docMk/>
            <pc:sldMk cId="3951076637" sldId="279"/>
            <ac:cxnSpMk id="32" creationId="{0ED014C2-BD9C-48CA-9230-869B95F1C1B6}"/>
          </ac:cxnSpMkLst>
        </pc:cxnChg>
      </pc:sldChg>
      <pc:sldChg chg="addSp modSp mod">
        <pc:chgData name="Yang, Shengming - ARS" userId="37bd5b25-7571-49cb-bfc8-588a18706c35" providerId="ADAL" clId="{289504D4-974E-43B6-9BD4-CC07536E2F15}" dt="2022-03-14T20:21:03.125" v="1466"/>
        <pc:sldMkLst>
          <pc:docMk/>
          <pc:sldMk cId="2943728638" sldId="280"/>
        </pc:sldMkLst>
        <pc:graphicFrameChg chg="add mod">
          <ac:chgData name="Yang, Shengming - ARS" userId="37bd5b25-7571-49cb-bfc8-588a18706c35" providerId="ADAL" clId="{289504D4-974E-43B6-9BD4-CC07536E2F15}" dt="2022-03-14T20:21:03.125" v="1466"/>
          <ac:graphicFrameMkLst>
            <pc:docMk/>
            <pc:sldMk cId="2943728638" sldId="280"/>
            <ac:graphicFrameMk id="4" creationId="{960B72F8-A520-4409-90DD-5C5A356D878C}"/>
          </ac:graphicFrameMkLst>
        </pc:graphicFrameChg>
        <pc:graphicFrameChg chg="add mod">
          <ac:chgData name="Yang, Shengming - ARS" userId="37bd5b25-7571-49cb-bfc8-588a18706c35" providerId="ADAL" clId="{289504D4-974E-43B6-9BD4-CC07536E2F15}" dt="2022-03-08T22:42:11.732" v="1095" actId="14100"/>
          <ac:graphicFrameMkLst>
            <pc:docMk/>
            <pc:sldMk cId="2943728638" sldId="280"/>
            <ac:graphicFrameMk id="5" creationId="{A6BECD3C-A5FE-45BD-B54B-E0305306921F}"/>
          </ac:graphicFrameMkLst>
        </pc:graphicFrameChg>
      </pc:sldChg>
      <pc:sldChg chg="addSp delSp modSp mod modNotesTx">
        <pc:chgData name="Yang, Shengming - ARS" userId="37bd5b25-7571-49cb-bfc8-588a18706c35" providerId="ADAL" clId="{289504D4-974E-43B6-9BD4-CC07536E2F15}" dt="2022-03-15T14:18:58.774" v="1468" actId="1076"/>
        <pc:sldMkLst>
          <pc:docMk/>
          <pc:sldMk cId="2625937353" sldId="284"/>
        </pc:sldMkLst>
        <pc:spChg chg="mod">
          <ac:chgData name="Yang, Shengming - ARS" userId="37bd5b25-7571-49cb-bfc8-588a18706c35" providerId="ADAL" clId="{289504D4-974E-43B6-9BD4-CC07536E2F15}" dt="2022-03-07T21:11:04.579" v="931" actId="1035"/>
          <ac:spMkLst>
            <pc:docMk/>
            <pc:sldMk cId="2625937353" sldId="284"/>
            <ac:spMk id="19" creationId="{0F7A8E18-9C7A-4C86-B619-6CCC77F46459}"/>
          </ac:spMkLst>
        </pc:spChg>
        <pc:spChg chg="mod">
          <ac:chgData name="Yang, Shengming - ARS" userId="37bd5b25-7571-49cb-bfc8-588a18706c35" providerId="ADAL" clId="{289504D4-974E-43B6-9BD4-CC07536E2F15}" dt="2022-03-15T13:58:15.435" v="1467" actId="1076"/>
          <ac:spMkLst>
            <pc:docMk/>
            <pc:sldMk cId="2625937353" sldId="284"/>
            <ac:spMk id="56" creationId="{00540A4C-C19C-4E64-AB2E-B2E1D10D227C}"/>
          </ac:spMkLst>
        </pc:spChg>
        <pc:spChg chg="mod">
          <ac:chgData name="Yang, Shengming - ARS" userId="37bd5b25-7571-49cb-bfc8-588a18706c35" providerId="ADAL" clId="{289504D4-974E-43B6-9BD4-CC07536E2F15}" dt="2022-03-15T14:18:58.774" v="1468" actId="1076"/>
          <ac:spMkLst>
            <pc:docMk/>
            <pc:sldMk cId="2625937353" sldId="284"/>
            <ac:spMk id="58" creationId="{E35FD13C-0112-48E9-A639-5752462E9D4B}"/>
          </ac:spMkLst>
        </pc:spChg>
        <pc:spChg chg="add mod">
          <ac:chgData name="Yang, Shengming - ARS" userId="37bd5b25-7571-49cb-bfc8-588a18706c35" providerId="ADAL" clId="{289504D4-974E-43B6-9BD4-CC07536E2F15}" dt="2022-02-25T20:26:22.530" v="75" actId="1076"/>
          <ac:spMkLst>
            <pc:docMk/>
            <pc:sldMk cId="2625937353" sldId="284"/>
            <ac:spMk id="60" creationId="{0DB11815-8202-4994-85EF-4706FA09510A}"/>
          </ac:spMkLst>
        </pc:spChg>
        <pc:spChg chg="add mod">
          <ac:chgData name="Yang, Shengming - ARS" userId="37bd5b25-7571-49cb-bfc8-588a18706c35" providerId="ADAL" clId="{289504D4-974E-43B6-9BD4-CC07536E2F15}" dt="2022-02-25T20:27:18.498" v="92" actId="1076"/>
          <ac:spMkLst>
            <pc:docMk/>
            <pc:sldMk cId="2625937353" sldId="284"/>
            <ac:spMk id="61" creationId="{454345CC-B2D1-4E4D-BCF9-CF14117A7BE8}"/>
          </ac:spMkLst>
        </pc:spChg>
        <pc:picChg chg="add del mod modCrop">
          <ac:chgData name="Yang, Shengming - ARS" userId="37bd5b25-7571-49cb-bfc8-588a18706c35" providerId="ADAL" clId="{289504D4-974E-43B6-9BD4-CC07536E2F15}" dt="2022-02-25T20:25:31.897" v="58" actId="478"/>
          <ac:picMkLst>
            <pc:docMk/>
            <pc:sldMk cId="2625937353" sldId="284"/>
            <ac:picMk id="8" creationId="{FA48A28C-2E82-4932-8BE4-5374AB3D1EDD}"/>
          </ac:picMkLst>
        </pc:picChg>
        <pc:picChg chg="add mod">
          <ac:chgData name="Yang, Shengming - ARS" userId="37bd5b25-7571-49cb-bfc8-588a18706c35" providerId="ADAL" clId="{289504D4-974E-43B6-9BD4-CC07536E2F15}" dt="2022-02-25T20:25:44.795" v="62" actId="14100"/>
          <ac:picMkLst>
            <pc:docMk/>
            <pc:sldMk cId="2625937353" sldId="284"/>
            <ac:picMk id="10" creationId="{E2E97180-D489-4853-AC1F-78DB9CF14B40}"/>
          </ac:picMkLst>
        </pc:picChg>
        <pc:picChg chg="del">
          <ac:chgData name="Yang, Shengming - ARS" userId="37bd5b25-7571-49cb-bfc8-588a18706c35" providerId="ADAL" clId="{289504D4-974E-43B6-9BD4-CC07536E2F15}" dt="2022-02-25T20:25:35.875" v="59" actId="478"/>
          <ac:picMkLst>
            <pc:docMk/>
            <pc:sldMk cId="2625937353" sldId="284"/>
            <ac:picMk id="57" creationId="{43355438-3992-4775-9C8D-31AC12E5A819}"/>
          </ac:picMkLst>
        </pc:picChg>
        <pc:picChg chg="add del mod">
          <ac:chgData name="Yang, Shengming - ARS" userId="37bd5b25-7571-49cb-bfc8-588a18706c35" providerId="ADAL" clId="{289504D4-974E-43B6-9BD4-CC07536E2F15}" dt="2022-02-25T20:25:28.066" v="56" actId="478"/>
          <ac:picMkLst>
            <pc:docMk/>
            <pc:sldMk cId="2625937353" sldId="284"/>
            <ac:picMk id="59" creationId="{294D3E28-10DF-462C-8243-4E3C2ABB8E35}"/>
          </ac:picMkLst>
        </pc:picChg>
      </pc:sldChg>
      <pc:sldChg chg="modSp mod">
        <pc:chgData name="Yang, Shengming - ARS" userId="37bd5b25-7571-49cb-bfc8-588a18706c35" providerId="ADAL" clId="{289504D4-974E-43B6-9BD4-CC07536E2F15}" dt="2022-03-08T21:00:10.441" v="969" actId="1076"/>
        <pc:sldMkLst>
          <pc:docMk/>
          <pc:sldMk cId="2301416017" sldId="285"/>
        </pc:sldMkLst>
        <pc:picChg chg="mod">
          <ac:chgData name="Yang, Shengming - ARS" userId="37bd5b25-7571-49cb-bfc8-588a18706c35" providerId="ADAL" clId="{289504D4-974E-43B6-9BD4-CC07536E2F15}" dt="2022-03-08T21:00:10.441" v="969" actId="1076"/>
          <ac:picMkLst>
            <pc:docMk/>
            <pc:sldMk cId="2301416017" sldId="285"/>
            <ac:picMk id="5" creationId="{3381DD81-F4CB-4116-AB31-33C2B9C41158}"/>
          </ac:picMkLst>
        </pc:picChg>
        <pc:picChg chg="mod">
          <ac:chgData name="Yang, Shengming - ARS" userId="37bd5b25-7571-49cb-bfc8-588a18706c35" providerId="ADAL" clId="{289504D4-974E-43B6-9BD4-CC07536E2F15}" dt="2022-03-08T21:00:10.441" v="969" actId="1076"/>
          <ac:picMkLst>
            <pc:docMk/>
            <pc:sldMk cId="2301416017" sldId="285"/>
            <ac:picMk id="9" creationId="{D2106145-624E-4A03-AC6D-2880EE6214C5}"/>
          </ac:picMkLst>
        </pc:picChg>
        <pc:picChg chg="mod">
          <ac:chgData name="Yang, Shengming - ARS" userId="37bd5b25-7571-49cb-bfc8-588a18706c35" providerId="ADAL" clId="{289504D4-974E-43B6-9BD4-CC07536E2F15}" dt="2022-03-08T21:00:10.441" v="969" actId="1076"/>
          <ac:picMkLst>
            <pc:docMk/>
            <pc:sldMk cId="2301416017" sldId="285"/>
            <ac:picMk id="10" creationId="{05A166F1-4B35-440B-8A66-9471844B2815}"/>
          </ac:picMkLst>
        </pc:picChg>
      </pc:sldChg>
      <pc:sldChg chg="modSp mod">
        <pc:chgData name="Yang, Shengming - ARS" userId="37bd5b25-7571-49cb-bfc8-588a18706c35" providerId="ADAL" clId="{289504D4-974E-43B6-9BD4-CC07536E2F15}" dt="2022-03-01T23:41:44.333" v="913" actId="1037"/>
        <pc:sldMkLst>
          <pc:docMk/>
          <pc:sldMk cId="2028917921" sldId="286"/>
        </pc:sldMkLst>
        <pc:picChg chg="mod">
          <ac:chgData name="Yang, Shengming - ARS" userId="37bd5b25-7571-49cb-bfc8-588a18706c35" providerId="ADAL" clId="{289504D4-974E-43B6-9BD4-CC07536E2F15}" dt="2022-03-01T23:41:44.333" v="913" actId="1037"/>
          <ac:picMkLst>
            <pc:docMk/>
            <pc:sldMk cId="2028917921" sldId="286"/>
            <ac:picMk id="3" creationId="{47515810-1A32-4C86-A72B-3D11768C8C9D}"/>
          </ac:picMkLst>
        </pc:picChg>
      </pc:sldChg>
      <pc:sldChg chg="addSp delSp modSp mod modNotesTx">
        <pc:chgData name="Yang, Shengming - ARS" userId="37bd5b25-7571-49cb-bfc8-588a18706c35" providerId="ADAL" clId="{289504D4-974E-43B6-9BD4-CC07536E2F15}" dt="2022-03-08T22:43:10.767" v="1101" actId="1037"/>
        <pc:sldMkLst>
          <pc:docMk/>
          <pc:sldMk cId="4208113970" sldId="288"/>
        </pc:sldMkLst>
        <pc:spChg chg="add mod">
          <ac:chgData name="Yang, Shengming - ARS" userId="37bd5b25-7571-49cb-bfc8-588a18706c35" providerId="ADAL" clId="{289504D4-974E-43B6-9BD4-CC07536E2F15}" dt="2022-03-08T22:39:35.700" v="1087" actId="20577"/>
          <ac:spMkLst>
            <pc:docMk/>
            <pc:sldMk cId="4208113970" sldId="288"/>
            <ac:spMk id="18" creationId="{3AF29D4B-F9E8-4DC8-9D02-E37CA61EADD7}"/>
          </ac:spMkLst>
        </pc:spChg>
        <pc:picChg chg="add mod modCrop">
          <ac:chgData name="Yang, Shengming - ARS" userId="37bd5b25-7571-49cb-bfc8-588a18706c35" providerId="ADAL" clId="{289504D4-974E-43B6-9BD4-CC07536E2F15}" dt="2022-03-08T22:03:34.597" v="1019" actId="732"/>
          <ac:picMkLst>
            <pc:docMk/>
            <pc:sldMk cId="4208113970" sldId="288"/>
            <ac:picMk id="3" creationId="{66F4523C-2859-48DE-99E1-CB7C8576EDF8}"/>
          </ac:picMkLst>
        </pc:picChg>
        <pc:picChg chg="add mod modCrop">
          <ac:chgData name="Yang, Shengming - ARS" userId="37bd5b25-7571-49cb-bfc8-588a18706c35" providerId="ADAL" clId="{289504D4-974E-43B6-9BD4-CC07536E2F15}" dt="2022-03-08T17:23:58.677" v="963" actId="1076"/>
          <ac:picMkLst>
            <pc:docMk/>
            <pc:sldMk cId="4208113970" sldId="288"/>
            <ac:picMk id="5" creationId="{EF3B4D23-3ECD-4D6E-9A9C-EFC5B37D9611}"/>
          </ac:picMkLst>
        </pc:picChg>
        <pc:picChg chg="add mod modCrop">
          <ac:chgData name="Yang, Shengming - ARS" userId="37bd5b25-7571-49cb-bfc8-588a18706c35" providerId="ADAL" clId="{289504D4-974E-43B6-9BD4-CC07536E2F15}" dt="2022-03-08T17:23:43.060" v="960" actId="14100"/>
          <ac:picMkLst>
            <pc:docMk/>
            <pc:sldMk cId="4208113970" sldId="288"/>
            <ac:picMk id="7" creationId="{3909BBB6-BA7D-42FF-A43C-5940B8AC5FA8}"/>
          </ac:picMkLst>
        </pc:picChg>
        <pc:picChg chg="add del mod">
          <ac:chgData name="Yang, Shengming - ARS" userId="37bd5b25-7571-49cb-bfc8-588a18706c35" providerId="ADAL" clId="{289504D4-974E-43B6-9BD4-CC07536E2F15}" dt="2022-03-08T17:27:29.368" v="967" actId="478"/>
          <ac:picMkLst>
            <pc:docMk/>
            <pc:sldMk cId="4208113970" sldId="288"/>
            <ac:picMk id="9" creationId="{BB83AABB-0828-4151-ADED-68E9A38B452F}"/>
          </ac:picMkLst>
        </pc:picChg>
        <pc:picChg chg="del mod">
          <ac:chgData name="Yang, Shengming - ARS" userId="37bd5b25-7571-49cb-bfc8-588a18706c35" providerId="ADAL" clId="{289504D4-974E-43B6-9BD4-CC07536E2F15}" dt="2022-03-08T17:22:04.179" v="932" actId="478"/>
          <ac:picMkLst>
            <pc:docMk/>
            <pc:sldMk cId="4208113970" sldId="288"/>
            <ac:picMk id="11" creationId="{61543F96-5AEF-48F7-A896-6222CD062B93}"/>
          </ac:picMkLst>
        </pc:picChg>
        <pc:picChg chg="del">
          <ac:chgData name="Yang, Shengming - ARS" userId="37bd5b25-7571-49cb-bfc8-588a18706c35" providerId="ADAL" clId="{289504D4-974E-43B6-9BD4-CC07536E2F15}" dt="2022-03-08T17:22:04.179" v="932" actId="478"/>
          <ac:picMkLst>
            <pc:docMk/>
            <pc:sldMk cId="4208113970" sldId="288"/>
            <ac:picMk id="13" creationId="{7C857758-7BB1-4B2C-9389-B4776791175A}"/>
          </ac:picMkLst>
        </pc:picChg>
        <pc:picChg chg="del">
          <ac:chgData name="Yang, Shengming - ARS" userId="37bd5b25-7571-49cb-bfc8-588a18706c35" providerId="ADAL" clId="{289504D4-974E-43B6-9BD4-CC07536E2F15}" dt="2022-03-08T17:22:04.179" v="932" actId="478"/>
          <ac:picMkLst>
            <pc:docMk/>
            <pc:sldMk cId="4208113970" sldId="288"/>
            <ac:picMk id="14" creationId="{378C07F1-338D-484D-AC20-21B17222885B}"/>
          </ac:picMkLst>
        </pc:picChg>
        <pc:picChg chg="add del mod">
          <ac:chgData name="Yang, Shengming - ARS" userId="37bd5b25-7571-49cb-bfc8-588a18706c35" providerId="ADAL" clId="{289504D4-974E-43B6-9BD4-CC07536E2F15}" dt="2022-03-08T22:39:43.714" v="1088" actId="478"/>
          <ac:picMkLst>
            <pc:docMk/>
            <pc:sldMk cId="4208113970" sldId="288"/>
            <ac:picMk id="1026" creationId="{A3C49CAD-078E-4F46-8B6B-76DA48AF9441}"/>
          </ac:picMkLst>
        </pc:picChg>
        <pc:cxnChg chg="add mod">
          <ac:chgData name="Yang, Shengming - ARS" userId="37bd5b25-7571-49cb-bfc8-588a18706c35" providerId="ADAL" clId="{289504D4-974E-43B6-9BD4-CC07536E2F15}" dt="2022-03-08T22:43:10.767" v="1101" actId="1037"/>
          <ac:cxnSpMkLst>
            <pc:docMk/>
            <pc:sldMk cId="4208113970" sldId="288"/>
            <ac:cxnSpMk id="12" creationId="{B1465CC9-BB79-4062-B4D0-D09AED9F8095}"/>
          </ac:cxnSpMkLst>
        </pc:cxnChg>
        <pc:cxnChg chg="add mod">
          <ac:chgData name="Yang, Shengming - ARS" userId="37bd5b25-7571-49cb-bfc8-588a18706c35" providerId="ADAL" clId="{289504D4-974E-43B6-9BD4-CC07536E2F15}" dt="2022-03-08T22:42:53.119" v="1097" actId="1076"/>
          <ac:cxnSpMkLst>
            <pc:docMk/>
            <pc:sldMk cId="4208113970" sldId="288"/>
            <ac:cxnSpMk id="19" creationId="{437C8ECA-757C-455A-8F5D-C5C186043E13}"/>
          </ac:cxnSpMkLst>
        </pc:cxnChg>
        <pc:cxnChg chg="add mod">
          <ac:chgData name="Yang, Shengming - ARS" userId="37bd5b25-7571-49cb-bfc8-588a18706c35" providerId="ADAL" clId="{289504D4-974E-43B6-9BD4-CC07536E2F15}" dt="2022-03-08T22:43:03.544" v="1099" actId="1076"/>
          <ac:cxnSpMkLst>
            <pc:docMk/>
            <pc:sldMk cId="4208113970" sldId="288"/>
            <ac:cxnSpMk id="20" creationId="{39A73C54-12D3-4DB5-9D5A-6BA5AAF5FD29}"/>
          </ac:cxnSpMkLst>
        </pc:cxnChg>
      </pc:sldChg>
      <pc:sldChg chg="modSp mod ord">
        <pc:chgData name="Yang, Shengming - ARS" userId="37bd5b25-7571-49cb-bfc8-588a18706c35" providerId="ADAL" clId="{289504D4-974E-43B6-9BD4-CC07536E2F15}" dt="2022-03-08T21:04:44.650" v="971"/>
        <pc:sldMkLst>
          <pc:docMk/>
          <pc:sldMk cId="3220999384" sldId="289"/>
        </pc:sldMkLst>
        <pc:picChg chg="mod">
          <ac:chgData name="Yang, Shengming - ARS" userId="37bd5b25-7571-49cb-bfc8-588a18706c35" providerId="ADAL" clId="{289504D4-974E-43B6-9BD4-CC07536E2F15}" dt="2022-03-03T19:30:24.296" v="918" actId="1038"/>
          <ac:picMkLst>
            <pc:docMk/>
            <pc:sldMk cId="3220999384" sldId="289"/>
            <ac:picMk id="7" creationId="{4130D544-0AFF-4C09-8DFD-EEDB9373AD51}"/>
          </ac:picMkLst>
        </pc:picChg>
        <pc:picChg chg="mod">
          <ac:chgData name="Yang, Shengming - ARS" userId="37bd5b25-7571-49cb-bfc8-588a18706c35" providerId="ADAL" clId="{289504D4-974E-43B6-9BD4-CC07536E2F15}" dt="2022-03-03T19:30:28.616" v="926" actId="1038"/>
          <ac:picMkLst>
            <pc:docMk/>
            <pc:sldMk cId="3220999384" sldId="289"/>
            <ac:picMk id="9" creationId="{C5B88DC7-B98B-477C-B267-D0F84E4D58E2}"/>
          </ac:picMkLst>
        </pc:picChg>
        <pc:picChg chg="mod">
          <ac:chgData name="Yang, Shengming - ARS" userId="37bd5b25-7571-49cb-bfc8-588a18706c35" providerId="ADAL" clId="{289504D4-974E-43B6-9BD4-CC07536E2F15}" dt="2022-03-03T19:30:11.676" v="914" actId="1076"/>
          <ac:picMkLst>
            <pc:docMk/>
            <pc:sldMk cId="3220999384" sldId="289"/>
            <ac:picMk id="10" creationId="{21D12051-BEF0-4E1F-8275-3E630826FCA4}"/>
          </ac:picMkLst>
        </pc:picChg>
      </pc:sldChg>
      <pc:sldChg chg="addSp delSp modSp mod ord">
        <pc:chgData name="Yang, Shengming - ARS" userId="37bd5b25-7571-49cb-bfc8-588a18706c35" providerId="ADAL" clId="{289504D4-974E-43B6-9BD4-CC07536E2F15}" dt="2022-03-08T21:25:56.963" v="978" actId="1036"/>
        <pc:sldMkLst>
          <pc:docMk/>
          <pc:sldMk cId="2200906561" sldId="290"/>
        </pc:sldMkLst>
        <pc:spChg chg="add mod">
          <ac:chgData name="Yang, Shengming - ARS" userId="37bd5b25-7571-49cb-bfc8-588a18706c35" providerId="ADAL" clId="{289504D4-974E-43B6-9BD4-CC07536E2F15}" dt="2022-03-01T23:34:12.445" v="806" actId="14100"/>
          <ac:spMkLst>
            <pc:docMk/>
            <pc:sldMk cId="2200906561" sldId="290"/>
            <ac:spMk id="2" creationId="{A2F7D376-CEC0-4D66-B142-AEEB489FFC22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4" creationId="{946EAD36-829D-4435-8EF5-838177F33C5A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8" creationId="{36DC9297-1576-4510-ADFC-BA715607ECFF}"/>
          </ac:spMkLst>
        </pc:spChg>
        <pc:spChg chg="del mod">
          <ac:chgData name="Yang, Shengming - ARS" userId="37bd5b25-7571-49cb-bfc8-588a18706c35" providerId="ADAL" clId="{289504D4-974E-43B6-9BD4-CC07536E2F15}" dt="2022-03-01T23:31:56.604" v="745" actId="478"/>
          <ac:spMkLst>
            <pc:docMk/>
            <pc:sldMk cId="2200906561" sldId="290"/>
            <ac:spMk id="9" creationId="{326B85DA-5FEB-49AA-9B1D-779F6E66A986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0" creationId="{7577A3C2-6B22-48DB-89A8-C899A30379FD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1" creationId="{6DF76095-3890-4934-B864-6AB8F0D85EEF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2" creationId="{E5827669-7030-4353-B4CC-725E09EEFE08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3" creationId="{8112C84C-854D-4441-B88D-98E52681B89E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4" creationId="{CF673D4A-1F3B-427A-9185-5D9A4B8C25E1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5" creationId="{CFB31429-3063-48DA-88D9-23E75DB9A022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6" creationId="{48BD50A8-49FF-42A1-BDB1-8C2573F79500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7" creationId="{1EC31783-90F6-467C-8121-E38373278FCF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8" creationId="{BA11BEFD-3271-4E11-ACEF-D831709EDAEA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19" creationId="{1128A898-0A6B-4CAE-BD68-DCE3F7A825B3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0" creationId="{14870B67-087F-4D69-B242-8E11FF755D47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1" creationId="{7876C165-0C4C-455D-880A-30131CBDAA61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2" creationId="{0B214CA8-4C71-480A-BB1B-6D6D9E5F1C87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3" creationId="{1240F30C-4674-4C01-8826-F1FD0915D997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4" creationId="{B813E31A-A06D-48CF-98D4-5B1F8FFBB3CA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5" creationId="{3BBD6B91-7B8F-4F4E-8AC8-E8DF9B00A6D7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6" creationId="{CCFFA158-CE20-44CB-A116-E63DB440439E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7" creationId="{501719DD-DE10-48AB-9913-6DB8693F41B5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8" creationId="{60712AB3-9316-40E4-AE3A-0DFBC08DEBB5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29" creationId="{7A4DE73A-2EB8-45B0-A9E5-7F7B4F25B69A}"/>
          </ac:spMkLst>
        </pc:spChg>
        <pc:spChg chg="mod">
          <ac:chgData name="Yang, Shengming - ARS" userId="37bd5b25-7571-49cb-bfc8-588a18706c35" providerId="ADAL" clId="{289504D4-974E-43B6-9BD4-CC07536E2F15}" dt="2022-03-01T17:27:16.508" v="105"/>
          <ac:spMkLst>
            <pc:docMk/>
            <pc:sldMk cId="2200906561" sldId="290"/>
            <ac:spMk id="30" creationId="{28A40EE9-1728-4EB0-BE8D-68F65172E0EB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3" creationId="{77A24B76-A729-4DC5-8F5A-2DB0F984B97A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4" creationId="{89A6CE6C-E56F-4061-9F1A-069127A5E4C0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5" creationId="{2D895EAE-B738-4D0C-82F6-46E78806A5F4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6" creationId="{DBF3A838-897B-412E-AD15-4C8FB837AFF4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7" creationId="{21A3EEC1-D831-4CEA-BE58-3F6F6C54B6C2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8" creationId="{0944D13C-54FA-43B8-BBC3-29B5FFE75A46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39" creationId="{95CF3898-BB6B-412C-B065-75BFC472289E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53" creationId="{472A017D-0015-4852-A108-99DB3C7D9201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54" creationId="{256A1F56-CBCA-453A-916A-82BDD8E4766A}"/>
          </ac:spMkLst>
        </pc:spChg>
        <pc:spChg chg="add mod">
          <ac:chgData name="Yang, Shengming - ARS" userId="37bd5b25-7571-49cb-bfc8-588a18706c35" providerId="ADAL" clId="{289504D4-974E-43B6-9BD4-CC07536E2F15}" dt="2022-03-01T23:33:38.250" v="802" actId="1035"/>
          <ac:spMkLst>
            <pc:docMk/>
            <pc:sldMk cId="2200906561" sldId="290"/>
            <ac:spMk id="55" creationId="{6AC55977-2C63-42C9-B5E1-0F8350EF00A9}"/>
          </ac:spMkLst>
        </pc:spChg>
        <pc:spChg chg="add mod">
          <ac:chgData name="Yang, Shengming - ARS" userId="37bd5b25-7571-49cb-bfc8-588a18706c35" providerId="ADAL" clId="{289504D4-974E-43B6-9BD4-CC07536E2F15}" dt="2022-03-01T23:39:18.159" v="898" actId="1076"/>
          <ac:spMkLst>
            <pc:docMk/>
            <pc:sldMk cId="2200906561" sldId="290"/>
            <ac:spMk id="58" creationId="{127FACC4-AEA3-45C6-A512-B76CA41EF55B}"/>
          </ac:spMkLst>
        </pc:spChg>
        <pc:spChg chg="add mod">
          <ac:chgData name="Yang, Shengming - ARS" userId="37bd5b25-7571-49cb-bfc8-588a18706c35" providerId="ADAL" clId="{289504D4-974E-43B6-9BD4-CC07536E2F15}" dt="2022-03-01T23:34:17.187" v="809" actId="1035"/>
          <ac:spMkLst>
            <pc:docMk/>
            <pc:sldMk cId="2200906561" sldId="290"/>
            <ac:spMk id="60" creationId="{DD355DBD-69B4-4C1F-A384-0380D48C32B0}"/>
          </ac:spMkLst>
        </pc:spChg>
        <pc:grpChg chg="add del mod">
          <ac:chgData name="Yang, Shengming - ARS" userId="37bd5b25-7571-49cb-bfc8-588a18706c35" providerId="ADAL" clId="{289504D4-974E-43B6-9BD4-CC07536E2F15}" dt="2022-03-01T23:14:10.911" v="642" actId="478"/>
          <ac:grpSpMkLst>
            <pc:docMk/>
            <pc:sldMk cId="2200906561" sldId="290"/>
            <ac:grpSpMk id="3" creationId="{4081E69B-73AC-43EF-BCC1-391DE6A2E7B6}"/>
          </ac:grpSpMkLst>
        </pc:grpChg>
        <pc:picChg chg="mod">
          <ac:chgData name="Yang, Shengming - ARS" userId="37bd5b25-7571-49cb-bfc8-588a18706c35" providerId="ADAL" clId="{289504D4-974E-43B6-9BD4-CC07536E2F15}" dt="2022-03-01T17:27:16.508" v="105"/>
          <ac:picMkLst>
            <pc:docMk/>
            <pc:sldMk cId="2200906561" sldId="290"/>
            <ac:picMk id="5" creationId="{3BAFD58E-D957-4E0D-81C7-5238AEDA6B5E}"/>
          </ac:picMkLst>
        </pc:picChg>
        <pc:picChg chg="mod">
          <ac:chgData name="Yang, Shengming - ARS" userId="37bd5b25-7571-49cb-bfc8-588a18706c35" providerId="ADAL" clId="{289504D4-974E-43B6-9BD4-CC07536E2F15}" dt="2022-03-01T17:27:16.508" v="105"/>
          <ac:picMkLst>
            <pc:docMk/>
            <pc:sldMk cId="2200906561" sldId="290"/>
            <ac:picMk id="6" creationId="{929ECBF2-E638-4F2F-B072-9478FC4B239E}"/>
          </ac:picMkLst>
        </pc:picChg>
        <pc:picChg chg="mod">
          <ac:chgData name="Yang, Shengming - ARS" userId="37bd5b25-7571-49cb-bfc8-588a18706c35" providerId="ADAL" clId="{289504D4-974E-43B6-9BD4-CC07536E2F15}" dt="2022-03-01T17:27:16.508" v="105"/>
          <ac:picMkLst>
            <pc:docMk/>
            <pc:sldMk cId="2200906561" sldId="290"/>
            <ac:picMk id="7" creationId="{6D222787-D72D-48FD-AD19-42ECC769C878}"/>
          </ac:picMkLst>
        </pc:picChg>
        <pc:picChg chg="add mod">
          <ac:chgData name="Yang, Shengming - ARS" userId="37bd5b25-7571-49cb-bfc8-588a18706c35" providerId="ADAL" clId="{289504D4-974E-43B6-9BD4-CC07536E2F15}" dt="2022-03-01T23:33:38.250" v="802" actId="1035"/>
          <ac:picMkLst>
            <pc:docMk/>
            <pc:sldMk cId="2200906561" sldId="290"/>
            <ac:picMk id="32" creationId="{9B5FC26D-2091-4B11-8195-3875F8DFCCEA}"/>
          </ac:picMkLst>
        </pc:picChg>
        <pc:cxnChg chg="mod">
          <ac:chgData name="Yang, Shengming - ARS" userId="37bd5b25-7571-49cb-bfc8-588a18706c35" providerId="ADAL" clId="{289504D4-974E-43B6-9BD4-CC07536E2F15}" dt="2022-03-01T17:27:16.508" v="105"/>
          <ac:cxnSpMkLst>
            <pc:docMk/>
            <pc:sldMk cId="2200906561" sldId="290"/>
            <ac:cxnSpMk id="31" creationId="{5E253C47-8A83-4DB1-AB8F-C21EA6B09A54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0" creationId="{AB1CABE9-60A7-4332-A43E-6D328985B38F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1" creationId="{AA870F86-3D05-46BA-B90E-A85661962AB5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2" creationId="{3AB0FFAE-9AFA-4E18-86B1-FE88A43BFE6B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3" creationId="{6512070E-123F-49F2-B5B8-951CB03E962D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4" creationId="{62BA9983-333A-45F0-94A5-1E94EDB9ADF9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5" creationId="{8742B4A1-04A3-44F0-B4CE-ABE220043032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6" creationId="{97C8592F-5FA8-4CCF-8703-6485971FAAF1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7" creationId="{BF23A8AF-112E-4468-BE99-E8A45BDDB97A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8" creationId="{FF3CFF44-B4BF-4F86-8BD5-DED17FFC3FCD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49" creationId="{83764279-2293-4094-89A5-86D090512CB5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50" creationId="{27EB8523-F95C-4106-BF4D-405564A2E44A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51" creationId="{2D9853D5-9625-4B43-88CF-B313DDC91569}"/>
          </ac:cxnSpMkLst>
        </pc:cxnChg>
        <pc:cxnChg chg="add mod">
          <ac:chgData name="Yang, Shengming - ARS" userId="37bd5b25-7571-49cb-bfc8-588a18706c35" providerId="ADAL" clId="{289504D4-974E-43B6-9BD4-CC07536E2F15}" dt="2022-03-01T23:33:38.250" v="802" actId="1035"/>
          <ac:cxnSpMkLst>
            <pc:docMk/>
            <pc:sldMk cId="2200906561" sldId="290"/>
            <ac:cxnSpMk id="52" creationId="{4297ACDF-85C0-4987-AF58-299FE3ECD858}"/>
          </ac:cxnSpMkLst>
        </pc:cxnChg>
        <pc:cxnChg chg="add mod">
          <ac:chgData name="Yang, Shengming - ARS" userId="37bd5b25-7571-49cb-bfc8-588a18706c35" providerId="ADAL" clId="{289504D4-974E-43B6-9BD4-CC07536E2F15}" dt="2022-03-08T21:25:56.963" v="978" actId="1036"/>
          <ac:cxnSpMkLst>
            <pc:docMk/>
            <pc:sldMk cId="2200906561" sldId="290"/>
            <ac:cxnSpMk id="57" creationId="{08E779B1-90CA-4359-BC50-8CBA26A4F260}"/>
          </ac:cxnSpMkLst>
        </pc:cxnChg>
      </pc:sldChg>
      <pc:sldChg chg="addSp delSp modSp new del mod modNotesTx">
        <pc:chgData name="Yang, Shengming - ARS" userId="37bd5b25-7571-49cb-bfc8-588a18706c35" providerId="ADAL" clId="{289504D4-974E-43B6-9BD4-CC07536E2F15}" dt="2022-03-03T19:38:25.002" v="930" actId="47"/>
        <pc:sldMkLst>
          <pc:docMk/>
          <pc:sldMk cId="752224780" sldId="291"/>
        </pc:sldMkLst>
        <pc:spChg chg="del">
          <ac:chgData name="Yang, Shengming - ARS" userId="37bd5b25-7571-49cb-bfc8-588a18706c35" providerId="ADAL" clId="{289504D4-974E-43B6-9BD4-CC07536E2F15}" dt="2022-03-01T22:43:50.050" v="112" actId="478"/>
          <ac:spMkLst>
            <pc:docMk/>
            <pc:sldMk cId="752224780" sldId="291"/>
            <ac:spMk id="2" creationId="{99ECE07D-F662-4D66-A533-ACE8DF5511B2}"/>
          </ac:spMkLst>
        </pc:spChg>
        <pc:spChg chg="del">
          <ac:chgData name="Yang, Shengming - ARS" userId="37bd5b25-7571-49cb-bfc8-588a18706c35" providerId="ADAL" clId="{289504D4-974E-43B6-9BD4-CC07536E2F15}" dt="2022-03-01T22:43:50.050" v="112" actId="478"/>
          <ac:spMkLst>
            <pc:docMk/>
            <pc:sldMk cId="752224780" sldId="291"/>
            <ac:spMk id="3" creationId="{8D5C4AD2-606C-406E-BE1F-089C29F6B6B8}"/>
          </ac:spMkLst>
        </pc:spChg>
        <pc:spChg chg="add mod">
          <ac:chgData name="Yang, Shengming - ARS" userId="37bd5b25-7571-49cb-bfc8-588a18706c35" providerId="ADAL" clId="{289504D4-974E-43B6-9BD4-CC07536E2F15}" dt="2022-03-01T22:46:57.231" v="184" actId="20577"/>
          <ac:spMkLst>
            <pc:docMk/>
            <pc:sldMk cId="752224780" sldId="291"/>
            <ac:spMk id="7" creationId="{3373AF5B-45AB-4915-9291-B9A733430EFF}"/>
          </ac:spMkLst>
        </pc:spChg>
        <pc:spChg chg="add mod">
          <ac:chgData name="Yang, Shengming - ARS" userId="37bd5b25-7571-49cb-bfc8-588a18706c35" providerId="ADAL" clId="{289504D4-974E-43B6-9BD4-CC07536E2F15}" dt="2022-03-01T22:47:03.735" v="188" actId="20577"/>
          <ac:spMkLst>
            <pc:docMk/>
            <pc:sldMk cId="752224780" sldId="291"/>
            <ac:spMk id="8" creationId="{5925FBB2-C043-4E60-AF92-0E9FA1F030F7}"/>
          </ac:spMkLst>
        </pc:spChg>
        <pc:spChg chg="add mod">
          <ac:chgData name="Yang, Shengming - ARS" userId="37bd5b25-7571-49cb-bfc8-588a18706c35" providerId="ADAL" clId="{289504D4-974E-43B6-9BD4-CC07536E2F15}" dt="2022-03-01T22:46:23.167" v="172" actId="1037"/>
          <ac:spMkLst>
            <pc:docMk/>
            <pc:sldMk cId="752224780" sldId="291"/>
            <ac:spMk id="9" creationId="{2A1139A0-AEE6-4DE4-A9FF-CA77AF49E8D7}"/>
          </ac:spMkLst>
        </pc:spChg>
        <pc:spChg chg="add mod">
          <ac:chgData name="Yang, Shengming - ARS" userId="37bd5b25-7571-49cb-bfc8-588a18706c35" providerId="ADAL" clId="{289504D4-974E-43B6-9BD4-CC07536E2F15}" dt="2022-03-01T22:46:29.284" v="176" actId="1037"/>
          <ac:spMkLst>
            <pc:docMk/>
            <pc:sldMk cId="752224780" sldId="291"/>
            <ac:spMk id="10" creationId="{10CAC8F9-1C66-48A7-8AD7-4AFEA71CF1AB}"/>
          </ac:spMkLst>
        </pc:spChg>
        <pc:spChg chg="add mod">
          <ac:chgData name="Yang, Shengming - ARS" userId="37bd5b25-7571-49cb-bfc8-588a18706c35" providerId="ADAL" clId="{289504D4-974E-43B6-9BD4-CC07536E2F15}" dt="2022-03-01T22:46:35.266" v="182" actId="1038"/>
          <ac:spMkLst>
            <pc:docMk/>
            <pc:sldMk cId="752224780" sldId="291"/>
            <ac:spMk id="11" creationId="{440A343F-5FE6-41BC-B26F-D96A6698DF3D}"/>
          </ac:spMkLst>
        </pc:spChg>
        <pc:spChg chg="add mod">
          <ac:chgData name="Yang, Shengming - ARS" userId="37bd5b25-7571-49cb-bfc8-588a18706c35" providerId="ADAL" clId="{289504D4-974E-43B6-9BD4-CC07536E2F15}" dt="2022-03-01T22:51:53.546" v="192" actId="207"/>
          <ac:spMkLst>
            <pc:docMk/>
            <pc:sldMk cId="752224780" sldId="291"/>
            <ac:spMk id="12" creationId="{DD0A8EB0-E1BD-4AC9-907E-DC869E858B59}"/>
          </ac:spMkLst>
        </pc:spChg>
        <pc:spChg chg="add mod">
          <ac:chgData name="Yang, Shengming - ARS" userId="37bd5b25-7571-49cb-bfc8-588a18706c35" providerId="ADAL" clId="{289504D4-974E-43B6-9BD4-CC07536E2F15}" dt="2022-03-01T22:52:35.807" v="212" actId="1076"/>
          <ac:spMkLst>
            <pc:docMk/>
            <pc:sldMk cId="752224780" sldId="291"/>
            <ac:spMk id="13" creationId="{C63D76E0-620D-401C-AE31-DF0D127ADA21}"/>
          </ac:spMkLst>
        </pc:spChg>
        <pc:spChg chg="add mod">
          <ac:chgData name="Yang, Shengming - ARS" userId="37bd5b25-7571-49cb-bfc8-588a18706c35" providerId="ADAL" clId="{289504D4-974E-43B6-9BD4-CC07536E2F15}" dt="2022-03-01T23:02:41.617" v="522" actId="113"/>
          <ac:spMkLst>
            <pc:docMk/>
            <pc:sldMk cId="752224780" sldId="291"/>
            <ac:spMk id="42" creationId="{2796FECB-39D9-4D83-A048-5B94318B3E31}"/>
          </ac:spMkLst>
        </pc:spChg>
        <pc:spChg chg="add mod">
          <ac:chgData name="Yang, Shengming - ARS" userId="37bd5b25-7571-49cb-bfc8-588a18706c35" providerId="ADAL" clId="{289504D4-974E-43B6-9BD4-CC07536E2F15}" dt="2022-03-01T23:02:51.315" v="526" actId="1076"/>
          <ac:spMkLst>
            <pc:docMk/>
            <pc:sldMk cId="752224780" sldId="291"/>
            <ac:spMk id="43" creationId="{097713F8-6D8A-4EEA-B56E-A01E74738801}"/>
          </ac:spMkLst>
        </pc:spChg>
        <pc:spChg chg="add mod">
          <ac:chgData name="Yang, Shengming - ARS" userId="37bd5b25-7571-49cb-bfc8-588a18706c35" providerId="ADAL" clId="{289504D4-974E-43B6-9BD4-CC07536E2F15}" dt="2022-03-01T23:03:24.155" v="537" actId="20577"/>
          <ac:spMkLst>
            <pc:docMk/>
            <pc:sldMk cId="752224780" sldId="291"/>
            <ac:spMk id="44" creationId="{A658A146-F3B7-4DF6-AB8E-22076BB9FE2C}"/>
          </ac:spMkLst>
        </pc:spChg>
        <pc:spChg chg="add mod">
          <ac:chgData name="Yang, Shengming - ARS" userId="37bd5b25-7571-49cb-bfc8-588a18706c35" providerId="ADAL" clId="{289504D4-974E-43B6-9BD4-CC07536E2F15}" dt="2022-03-01T23:13:12.234" v="636" actId="20577"/>
          <ac:spMkLst>
            <pc:docMk/>
            <pc:sldMk cId="752224780" sldId="291"/>
            <ac:spMk id="46" creationId="{41DBE3C0-4D2C-45F7-82E0-0EAFF0E4F071}"/>
          </ac:spMkLst>
        </pc:spChg>
        <pc:picChg chg="add mod">
          <ac:chgData name="Yang, Shengming - ARS" userId="37bd5b25-7571-49cb-bfc8-588a18706c35" providerId="ADAL" clId="{289504D4-974E-43B6-9BD4-CC07536E2F15}" dt="2022-03-01T22:43:55.665" v="114" actId="1076"/>
          <ac:picMkLst>
            <pc:docMk/>
            <pc:sldMk cId="752224780" sldId="291"/>
            <ac:picMk id="5" creationId="{04003696-5478-483F-8618-150F75332112}"/>
          </ac:picMkLst>
        </pc:picChg>
        <pc:cxnChg chg="add mod">
          <ac:chgData name="Yang, Shengming - ARS" userId="37bd5b25-7571-49cb-bfc8-588a18706c35" providerId="ADAL" clId="{289504D4-974E-43B6-9BD4-CC07536E2F15}" dt="2022-03-01T23:07:25.143" v="540" actId="1037"/>
          <ac:cxnSpMkLst>
            <pc:docMk/>
            <pc:sldMk cId="752224780" sldId="291"/>
            <ac:cxnSpMk id="15" creationId="{685B4171-5FF2-42B5-A601-B9DB5F42870A}"/>
          </ac:cxnSpMkLst>
        </pc:cxnChg>
        <pc:cxnChg chg="add mod">
          <ac:chgData name="Yang, Shengming - ARS" userId="37bd5b25-7571-49cb-bfc8-588a18706c35" providerId="ADAL" clId="{289504D4-974E-43B6-9BD4-CC07536E2F15}" dt="2022-03-01T22:54:52.251" v="284" actId="1035"/>
          <ac:cxnSpMkLst>
            <pc:docMk/>
            <pc:sldMk cId="752224780" sldId="291"/>
            <ac:cxnSpMk id="16" creationId="{157063A4-94B2-4A7A-A206-7F4A2E36E9B5}"/>
          </ac:cxnSpMkLst>
        </pc:cxnChg>
        <pc:cxnChg chg="add mod">
          <ac:chgData name="Yang, Shengming - ARS" userId="37bd5b25-7571-49cb-bfc8-588a18706c35" providerId="ADAL" clId="{289504D4-974E-43B6-9BD4-CC07536E2F15}" dt="2022-03-01T22:55:09.697" v="286" actId="1076"/>
          <ac:cxnSpMkLst>
            <pc:docMk/>
            <pc:sldMk cId="752224780" sldId="291"/>
            <ac:cxnSpMk id="19" creationId="{21BF23F0-AFB5-4A4E-89BF-3B858EE548DC}"/>
          </ac:cxnSpMkLst>
        </pc:cxnChg>
        <pc:cxnChg chg="add mod">
          <ac:chgData name="Yang, Shengming - ARS" userId="37bd5b25-7571-49cb-bfc8-588a18706c35" providerId="ADAL" clId="{289504D4-974E-43B6-9BD4-CC07536E2F15}" dt="2022-03-01T22:55:28.182" v="289" actId="1076"/>
          <ac:cxnSpMkLst>
            <pc:docMk/>
            <pc:sldMk cId="752224780" sldId="291"/>
            <ac:cxnSpMk id="20" creationId="{21C1874D-A47B-4FB5-8489-CF144980CE1D}"/>
          </ac:cxnSpMkLst>
        </pc:cxnChg>
        <pc:cxnChg chg="add mod">
          <ac:chgData name="Yang, Shengming - ARS" userId="37bd5b25-7571-49cb-bfc8-588a18706c35" providerId="ADAL" clId="{289504D4-974E-43B6-9BD4-CC07536E2F15}" dt="2022-03-01T23:07:31.592" v="541" actId="1076"/>
          <ac:cxnSpMkLst>
            <pc:docMk/>
            <pc:sldMk cId="752224780" sldId="291"/>
            <ac:cxnSpMk id="22" creationId="{F021EBB7-CA00-45E4-B5AA-077E9E4EEE6D}"/>
          </ac:cxnSpMkLst>
        </pc:cxnChg>
        <pc:cxnChg chg="add mod">
          <ac:chgData name="Yang, Shengming - ARS" userId="37bd5b25-7571-49cb-bfc8-588a18706c35" providerId="ADAL" clId="{289504D4-974E-43B6-9BD4-CC07536E2F15}" dt="2022-03-01T22:59:32.948" v="440" actId="1037"/>
          <ac:cxnSpMkLst>
            <pc:docMk/>
            <pc:sldMk cId="752224780" sldId="291"/>
            <ac:cxnSpMk id="24" creationId="{47C947F4-D92A-4580-89F9-2F886F85CD63}"/>
          </ac:cxnSpMkLst>
        </pc:cxnChg>
        <pc:cxnChg chg="add mod">
          <ac:chgData name="Yang, Shengming - ARS" userId="37bd5b25-7571-49cb-bfc8-588a18706c35" providerId="ADAL" clId="{289504D4-974E-43B6-9BD4-CC07536E2F15}" dt="2022-03-01T22:57:09.454" v="298" actId="1076"/>
          <ac:cxnSpMkLst>
            <pc:docMk/>
            <pc:sldMk cId="752224780" sldId="291"/>
            <ac:cxnSpMk id="25" creationId="{6965931D-D7AE-4756-8E09-40E23470929D}"/>
          </ac:cxnSpMkLst>
        </pc:cxnChg>
        <pc:cxnChg chg="add mod">
          <ac:chgData name="Yang, Shengming - ARS" userId="37bd5b25-7571-49cb-bfc8-588a18706c35" providerId="ADAL" clId="{289504D4-974E-43B6-9BD4-CC07536E2F15}" dt="2022-03-01T22:57:59.512" v="398" actId="1038"/>
          <ac:cxnSpMkLst>
            <pc:docMk/>
            <pc:sldMk cId="752224780" sldId="291"/>
            <ac:cxnSpMk id="26" creationId="{C51D1643-5AE1-4C21-B51D-95C5720025F9}"/>
          </ac:cxnSpMkLst>
        </pc:cxnChg>
        <pc:cxnChg chg="add mod">
          <ac:chgData name="Yang, Shengming - ARS" userId="37bd5b25-7571-49cb-bfc8-588a18706c35" providerId="ADAL" clId="{289504D4-974E-43B6-9BD4-CC07536E2F15}" dt="2022-03-01T22:57:48.834" v="377" actId="1038"/>
          <ac:cxnSpMkLst>
            <pc:docMk/>
            <pc:sldMk cId="752224780" sldId="291"/>
            <ac:cxnSpMk id="27" creationId="{6E952C3F-1270-48CD-94FF-FBA408A969A4}"/>
          </ac:cxnSpMkLst>
        </pc:cxnChg>
        <pc:cxnChg chg="add mod">
          <ac:chgData name="Yang, Shengming - ARS" userId="37bd5b25-7571-49cb-bfc8-588a18706c35" providerId="ADAL" clId="{289504D4-974E-43B6-9BD4-CC07536E2F15}" dt="2022-03-01T22:59:03.414" v="433" actId="1037"/>
          <ac:cxnSpMkLst>
            <pc:docMk/>
            <pc:sldMk cId="752224780" sldId="291"/>
            <ac:cxnSpMk id="28" creationId="{0276FE8F-23C5-46AC-9FD5-2F866915D0BE}"/>
          </ac:cxnSpMkLst>
        </pc:cxnChg>
        <pc:cxnChg chg="add mod">
          <ac:chgData name="Yang, Shengming - ARS" userId="37bd5b25-7571-49cb-bfc8-588a18706c35" providerId="ADAL" clId="{289504D4-974E-43B6-9BD4-CC07536E2F15}" dt="2022-03-01T23:01:48.513" v="511" actId="1038"/>
          <ac:cxnSpMkLst>
            <pc:docMk/>
            <pc:sldMk cId="752224780" sldId="291"/>
            <ac:cxnSpMk id="35" creationId="{79C4BDF4-43CA-4724-B4A2-AC302DDC8B4C}"/>
          </ac:cxnSpMkLst>
        </pc:cxnChg>
        <pc:cxnChg chg="add mod">
          <ac:chgData name="Yang, Shengming - ARS" userId="37bd5b25-7571-49cb-bfc8-588a18706c35" providerId="ADAL" clId="{289504D4-974E-43B6-9BD4-CC07536E2F15}" dt="2022-03-01T23:00:56.948" v="468" actId="1035"/>
          <ac:cxnSpMkLst>
            <pc:docMk/>
            <pc:sldMk cId="752224780" sldId="291"/>
            <ac:cxnSpMk id="36" creationId="{BED439FD-D78D-435C-BCBE-FE47D8A83EF5}"/>
          </ac:cxnSpMkLst>
        </pc:cxnChg>
        <pc:cxnChg chg="add del mod">
          <ac:chgData name="Yang, Shengming - ARS" userId="37bd5b25-7571-49cb-bfc8-588a18706c35" providerId="ADAL" clId="{289504D4-974E-43B6-9BD4-CC07536E2F15}" dt="2022-03-01T23:01:53.036" v="512" actId="478"/>
          <ac:cxnSpMkLst>
            <pc:docMk/>
            <pc:sldMk cId="752224780" sldId="291"/>
            <ac:cxnSpMk id="37" creationId="{A16D3BC8-ABCA-432F-A75B-32448E4C0758}"/>
          </ac:cxnSpMkLst>
        </pc:cxnChg>
        <pc:cxnChg chg="add del mod">
          <ac:chgData name="Yang, Shengming - ARS" userId="37bd5b25-7571-49cb-bfc8-588a18706c35" providerId="ADAL" clId="{289504D4-974E-43B6-9BD4-CC07536E2F15}" dt="2022-03-01T23:01:54.514" v="513" actId="478"/>
          <ac:cxnSpMkLst>
            <pc:docMk/>
            <pc:sldMk cId="752224780" sldId="291"/>
            <ac:cxnSpMk id="38" creationId="{C6690468-BF96-411F-8F04-329702E5B38B}"/>
          </ac:cxnSpMkLst>
        </pc:cxnChg>
        <pc:cxnChg chg="add mod">
          <ac:chgData name="Yang, Shengming - ARS" userId="37bd5b25-7571-49cb-bfc8-588a18706c35" providerId="ADAL" clId="{289504D4-974E-43B6-9BD4-CC07536E2F15}" dt="2022-03-01T23:01:26.572" v="494" actId="1037"/>
          <ac:cxnSpMkLst>
            <pc:docMk/>
            <pc:sldMk cId="752224780" sldId="291"/>
            <ac:cxnSpMk id="39" creationId="{BA6AFE08-AB95-400F-AB5C-11AF2C6B7E52}"/>
          </ac:cxnSpMkLst>
        </pc:cxnChg>
      </pc:sldChg>
      <pc:sldChg chg="addSp delSp modSp new mod">
        <pc:chgData name="Yang, Shengming - ARS" userId="37bd5b25-7571-49cb-bfc8-588a18706c35" providerId="ADAL" clId="{289504D4-974E-43B6-9BD4-CC07536E2F15}" dt="2022-03-14T20:08:32.400" v="1460"/>
        <pc:sldMkLst>
          <pc:docMk/>
          <pc:sldMk cId="2612662908" sldId="291"/>
        </pc:sldMkLst>
        <pc:spChg chg="del">
          <ac:chgData name="Yang, Shengming - ARS" userId="37bd5b25-7571-49cb-bfc8-588a18706c35" providerId="ADAL" clId="{289504D4-974E-43B6-9BD4-CC07536E2F15}" dt="2022-03-08T22:04:05.882" v="1035" actId="478"/>
          <ac:spMkLst>
            <pc:docMk/>
            <pc:sldMk cId="2612662908" sldId="291"/>
            <ac:spMk id="2" creationId="{D208C11A-4ADB-422B-8592-8AC0B6A8C0E4}"/>
          </ac:spMkLst>
        </pc:spChg>
        <pc:spChg chg="del">
          <ac:chgData name="Yang, Shengming - ARS" userId="37bd5b25-7571-49cb-bfc8-588a18706c35" providerId="ADAL" clId="{289504D4-974E-43B6-9BD4-CC07536E2F15}" dt="2022-03-08T22:04:05.882" v="1035" actId="478"/>
          <ac:spMkLst>
            <pc:docMk/>
            <pc:sldMk cId="2612662908" sldId="291"/>
            <ac:spMk id="3" creationId="{C5B994D7-2548-45E0-82E9-24B4E45090F0}"/>
          </ac:spMkLst>
        </pc:spChg>
        <pc:graphicFrameChg chg="add mod">
          <ac:chgData name="Yang, Shengming - ARS" userId="37bd5b25-7571-49cb-bfc8-588a18706c35" providerId="ADAL" clId="{289504D4-974E-43B6-9BD4-CC07536E2F15}" dt="2022-03-14T20:06:36.881" v="1423" actId="692"/>
          <ac:graphicFrameMkLst>
            <pc:docMk/>
            <pc:sldMk cId="2612662908" sldId="291"/>
            <ac:graphicFrameMk id="3" creationId="{A23EADC5-C859-42E3-8F1E-4CBC938FAC24}"/>
          </ac:graphicFrameMkLst>
        </pc:graphicFrameChg>
        <pc:graphicFrameChg chg="add mod">
          <ac:chgData name="Yang, Shengming - ARS" userId="37bd5b25-7571-49cb-bfc8-588a18706c35" providerId="ADAL" clId="{289504D4-974E-43B6-9BD4-CC07536E2F15}" dt="2022-03-14T20:08:32.400" v="1460"/>
          <ac:graphicFrameMkLst>
            <pc:docMk/>
            <pc:sldMk cId="2612662908" sldId="291"/>
            <ac:graphicFrameMk id="4" creationId="{AF0C9DC2-7F75-4392-8AD8-30F8C704BE39}"/>
          </ac:graphicFrameMkLst>
        </pc:graphicFrameChg>
        <pc:graphicFrameChg chg="add mod">
          <ac:chgData name="Yang, Shengming - ARS" userId="37bd5b25-7571-49cb-bfc8-588a18706c35" providerId="ADAL" clId="{289504D4-974E-43B6-9BD4-CC07536E2F15}" dt="2022-03-14T20:07:28.100" v="1433" actId="1076"/>
          <ac:graphicFrameMkLst>
            <pc:docMk/>
            <pc:sldMk cId="2612662908" sldId="291"/>
            <ac:graphicFrameMk id="5" creationId="{25B94C1A-E3B8-474E-AE3E-021E8785827F}"/>
          </ac:graphicFrameMkLst>
        </pc:graphicFrameChg>
        <pc:graphicFrameChg chg="add mod">
          <ac:chgData name="Yang, Shengming - ARS" userId="37bd5b25-7571-49cb-bfc8-588a18706c35" providerId="ADAL" clId="{289504D4-974E-43B6-9BD4-CC07536E2F15}" dt="2022-03-14T20:07:15.339" v="1430" actId="1076"/>
          <ac:graphicFrameMkLst>
            <pc:docMk/>
            <pc:sldMk cId="2612662908" sldId="291"/>
            <ac:graphicFrameMk id="6" creationId="{E5F88FCE-25A4-4CB8-AACA-95B26C014EB8}"/>
          </ac:graphicFrameMkLst>
        </pc:graphicFrameChg>
        <pc:graphicFrameChg chg="add del mod">
          <ac:chgData name="Yang, Shengming - ARS" userId="37bd5b25-7571-49cb-bfc8-588a18706c35" providerId="ADAL" clId="{289504D4-974E-43B6-9BD4-CC07536E2F15}" dt="2022-03-14T19:43:03.182" v="1245" actId="478"/>
          <ac:graphicFrameMkLst>
            <pc:docMk/>
            <pc:sldMk cId="2612662908" sldId="291"/>
            <ac:graphicFrameMk id="7" creationId="{A28CAF90-053E-4B4C-A35E-3334C509E48A}"/>
          </ac:graphicFrameMkLst>
        </pc:graphicFrameChg>
        <pc:graphicFrameChg chg="add del mod">
          <ac:chgData name="Yang, Shengming - ARS" userId="37bd5b25-7571-49cb-bfc8-588a18706c35" providerId="ADAL" clId="{289504D4-974E-43B6-9BD4-CC07536E2F15}" dt="2022-03-14T20:01:16.935" v="1384" actId="478"/>
          <ac:graphicFrameMkLst>
            <pc:docMk/>
            <pc:sldMk cId="2612662908" sldId="291"/>
            <ac:graphicFrameMk id="8" creationId="{29FD3362-6470-4A56-8F3E-06509F399B90}"/>
          </ac:graphicFrameMkLst>
        </pc:graphicFrameChg>
        <pc:graphicFrameChg chg="add mod">
          <ac:chgData name="Yang, Shengming - ARS" userId="37bd5b25-7571-49cb-bfc8-588a18706c35" providerId="ADAL" clId="{289504D4-974E-43B6-9BD4-CC07536E2F15}" dt="2022-03-14T20:07:41.228" v="1438" actId="1076"/>
          <ac:graphicFrameMkLst>
            <pc:docMk/>
            <pc:sldMk cId="2612662908" sldId="291"/>
            <ac:graphicFrameMk id="9" creationId="{A28CAF90-053E-4B4C-A35E-3334C509E48A}"/>
          </ac:graphicFrameMkLst>
        </pc:graphicFrameChg>
      </pc:sldChg>
      <pc:sldChg chg="addSp delSp modSp new mod">
        <pc:chgData name="Yang, Shengming - ARS" userId="37bd5b25-7571-49cb-bfc8-588a18706c35" providerId="ADAL" clId="{289504D4-974E-43B6-9BD4-CC07536E2F15}" dt="2022-03-10T20:51:47.144" v="1208" actId="1035"/>
        <pc:sldMkLst>
          <pc:docMk/>
          <pc:sldMk cId="3303732898" sldId="292"/>
        </pc:sldMkLst>
        <pc:spChg chg="del">
          <ac:chgData name="Yang, Shengming - ARS" userId="37bd5b25-7571-49cb-bfc8-588a18706c35" providerId="ADAL" clId="{289504D4-974E-43B6-9BD4-CC07536E2F15}" dt="2022-03-10T17:50:40.001" v="1103" actId="478"/>
          <ac:spMkLst>
            <pc:docMk/>
            <pc:sldMk cId="3303732898" sldId="292"/>
            <ac:spMk id="2" creationId="{BC42EFD7-2C7B-4589-A595-F4724D1C62FE}"/>
          </ac:spMkLst>
        </pc:spChg>
        <pc:spChg chg="del">
          <ac:chgData name="Yang, Shengming - ARS" userId="37bd5b25-7571-49cb-bfc8-588a18706c35" providerId="ADAL" clId="{289504D4-974E-43B6-9BD4-CC07536E2F15}" dt="2022-03-10T17:50:40.001" v="1103" actId="478"/>
          <ac:spMkLst>
            <pc:docMk/>
            <pc:sldMk cId="3303732898" sldId="292"/>
            <ac:spMk id="3" creationId="{0B052E09-9238-4476-8889-E6018B560862}"/>
          </ac:spMkLst>
        </pc:spChg>
        <pc:spChg chg="add mod">
          <ac:chgData name="Yang, Shengming - ARS" userId="37bd5b25-7571-49cb-bfc8-588a18706c35" providerId="ADAL" clId="{289504D4-974E-43B6-9BD4-CC07536E2F15}" dt="2022-03-10T20:51:18.880" v="1205" actId="164"/>
          <ac:spMkLst>
            <pc:docMk/>
            <pc:sldMk cId="3303732898" sldId="292"/>
            <ac:spMk id="22" creationId="{00F6C502-272F-49AD-BECC-933B11469C1D}"/>
          </ac:spMkLst>
        </pc:spChg>
        <pc:spChg chg="add mod">
          <ac:chgData name="Yang, Shengming - ARS" userId="37bd5b25-7571-49cb-bfc8-588a18706c35" providerId="ADAL" clId="{289504D4-974E-43B6-9BD4-CC07536E2F15}" dt="2022-03-10T20:51:31.347" v="1206" actId="164"/>
          <ac:spMkLst>
            <pc:docMk/>
            <pc:sldMk cId="3303732898" sldId="292"/>
            <ac:spMk id="23" creationId="{658E2519-E077-4E67-9FD6-2AAA3E10AF0A}"/>
          </ac:spMkLst>
        </pc:spChg>
        <pc:spChg chg="add mod">
          <ac:chgData name="Yang, Shengming - ARS" userId="37bd5b25-7571-49cb-bfc8-588a18706c35" providerId="ADAL" clId="{289504D4-974E-43B6-9BD4-CC07536E2F15}" dt="2022-03-10T20:51:47.144" v="1208" actId="1035"/>
          <ac:spMkLst>
            <pc:docMk/>
            <pc:sldMk cId="3303732898" sldId="292"/>
            <ac:spMk id="24" creationId="{F5230C90-8B03-497A-A7D3-46ABAC7EDC6C}"/>
          </ac:spMkLst>
        </pc:spChg>
        <pc:spChg chg="add mod">
          <ac:chgData name="Yang, Shengming - ARS" userId="37bd5b25-7571-49cb-bfc8-588a18706c35" providerId="ADAL" clId="{289504D4-974E-43B6-9BD4-CC07536E2F15}" dt="2022-03-10T18:29:48.979" v="1203" actId="20577"/>
          <ac:spMkLst>
            <pc:docMk/>
            <pc:sldMk cId="3303732898" sldId="292"/>
            <ac:spMk id="25" creationId="{4EACCFF3-F2BD-4277-9A0E-BEB8DE9A5800}"/>
          </ac:spMkLst>
        </pc:spChg>
        <pc:grpChg chg="add mod">
          <ac:chgData name="Yang, Shengming - ARS" userId="37bd5b25-7571-49cb-bfc8-588a18706c35" providerId="ADAL" clId="{289504D4-974E-43B6-9BD4-CC07536E2F15}" dt="2022-03-10T20:51:18.880" v="1205" actId="164"/>
          <ac:grpSpMkLst>
            <pc:docMk/>
            <pc:sldMk cId="3303732898" sldId="292"/>
            <ac:grpSpMk id="26" creationId="{A3D0ACD7-2E5A-42E4-BB0A-71709D99F326}"/>
          </ac:grpSpMkLst>
        </pc:grpChg>
        <pc:grpChg chg="add mod">
          <ac:chgData name="Yang, Shengming - ARS" userId="37bd5b25-7571-49cb-bfc8-588a18706c35" providerId="ADAL" clId="{289504D4-974E-43B6-9BD4-CC07536E2F15}" dt="2022-03-10T20:51:31.347" v="1206" actId="164"/>
          <ac:grpSpMkLst>
            <pc:docMk/>
            <pc:sldMk cId="3303732898" sldId="292"/>
            <ac:grpSpMk id="27" creationId="{2BA56E12-C47D-466D-BFD5-D4B4BE312DBF}"/>
          </ac:grpSpMkLst>
        </pc:grpChg>
        <pc:grpChg chg="add mod">
          <ac:chgData name="Yang, Shengming - ARS" userId="37bd5b25-7571-49cb-bfc8-588a18706c35" providerId="ADAL" clId="{289504D4-974E-43B6-9BD4-CC07536E2F15}" dt="2022-03-10T20:51:39.846" v="1207" actId="164"/>
          <ac:grpSpMkLst>
            <pc:docMk/>
            <pc:sldMk cId="3303732898" sldId="292"/>
            <ac:grpSpMk id="28" creationId="{529E0546-3289-4E40-A50D-18026BCE5512}"/>
          </ac:grpSpMkLst>
        </pc:grpChg>
        <pc:picChg chg="add del mod">
          <ac:chgData name="Yang, Shengming - ARS" userId="37bd5b25-7571-49cb-bfc8-588a18706c35" providerId="ADAL" clId="{289504D4-974E-43B6-9BD4-CC07536E2F15}" dt="2022-03-10T18:25:00.738" v="1138"/>
          <ac:picMkLst>
            <pc:docMk/>
            <pc:sldMk cId="3303732898" sldId="292"/>
            <ac:picMk id="3" creationId="{E3156843-C5D4-430C-85F0-22E98612FD12}"/>
          </ac:picMkLst>
        </pc:picChg>
        <pc:picChg chg="add mod">
          <ac:chgData name="Yang, Shengming - ARS" userId="37bd5b25-7571-49cb-bfc8-588a18706c35" providerId="ADAL" clId="{289504D4-974E-43B6-9BD4-CC07536E2F15}" dt="2022-03-10T20:51:18.880" v="1205" actId="164"/>
          <ac:picMkLst>
            <pc:docMk/>
            <pc:sldMk cId="3303732898" sldId="292"/>
            <ac:picMk id="5" creationId="{A8C64EAA-B587-4899-9C77-160403AAA9AE}"/>
          </ac:picMkLst>
        </pc:picChg>
        <pc:picChg chg="add del mod">
          <ac:chgData name="Yang, Shengming - ARS" userId="37bd5b25-7571-49cb-bfc8-588a18706c35" providerId="ADAL" clId="{289504D4-974E-43B6-9BD4-CC07536E2F15}" dt="2022-03-10T18:25:00.738" v="1138"/>
          <ac:picMkLst>
            <pc:docMk/>
            <pc:sldMk cId="3303732898" sldId="292"/>
            <ac:picMk id="6" creationId="{A33815B7-F926-4CF2-A2F5-1B00A706B24F}"/>
          </ac:picMkLst>
        </pc:picChg>
        <pc:picChg chg="add mod">
          <ac:chgData name="Yang, Shengming - ARS" userId="37bd5b25-7571-49cb-bfc8-588a18706c35" providerId="ADAL" clId="{289504D4-974E-43B6-9BD4-CC07536E2F15}" dt="2022-03-10T20:51:31.347" v="1206" actId="164"/>
          <ac:picMkLst>
            <pc:docMk/>
            <pc:sldMk cId="3303732898" sldId="292"/>
            <ac:picMk id="7" creationId="{CC16B74A-60E8-4BCC-AEB5-6A8944624F4D}"/>
          </ac:picMkLst>
        </pc:picChg>
        <pc:picChg chg="add mod">
          <ac:chgData name="Yang, Shengming - ARS" userId="37bd5b25-7571-49cb-bfc8-588a18706c35" providerId="ADAL" clId="{289504D4-974E-43B6-9BD4-CC07536E2F15}" dt="2022-03-10T20:51:39.846" v="1207" actId="164"/>
          <ac:picMkLst>
            <pc:docMk/>
            <pc:sldMk cId="3303732898" sldId="292"/>
            <ac:picMk id="9" creationId="{D7AD336E-62A3-40D7-99D4-C9914B4C4C2C}"/>
          </ac:picMkLst>
        </pc:picChg>
        <pc:picChg chg="add del mod">
          <ac:chgData name="Yang, Shengming - ARS" userId="37bd5b25-7571-49cb-bfc8-588a18706c35" providerId="ADAL" clId="{289504D4-974E-43B6-9BD4-CC07536E2F15}" dt="2022-03-10T18:25:00.738" v="1138"/>
          <ac:picMkLst>
            <pc:docMk/>
            <pc:sldMk cId="3303732898" sldId="292"/>
            <ac:picMk id="10" creationId="{5FCB94F3-9897-4CB8-B47C-3D428D23B5A4}"/>
          </ac:picMkLst>
        </pc:picChg>
        <pc:picChg chg="add mod">
          <ac:chgData name="Yang, Shengming - ARS" userId="37bd5b25-7571-49cb-bfc8-588a18706c35" providerId="ADAL" clId="{289504D4-974E-43B6-9BD4-CC07536E2F15}" dt="2022-03-10T18:24:45.330" v="1126" actId="571"/>
          <ac:picMkLst>
            <pc:docMk/>
            <pc:sldMk cId="3303732898" sldId="292"/>
            <ac:picMk id="11" creationId="{4BD553C8-288F-4D35-8C61-DBB9F2358125}"/>
          </ac:picMkLst>
        </pc:picChg>
        <pc:picChg chg="add mod">
          <ac:chgData name="Yang, Shengming - ARS" userId="37bd5b25-7571-49cb-bfc8-588a18706c35" providerId="ADAL" clId="{289504D4-974E-43B6-9BD4-CC07536E2F15}" dt="2022-03-10T18:24:45.330" v="1126" actId="571"/>
          <ac:picMkLst>
            <pc:docMk/>
            <pc:sldMk cId="3303732898" sldId="292"/>
            <ac:picMk id="12" creationId="{A196987A-DFF7-47DA-9ECD-427CA41C3BCD}"/>
          </ac:picMkLst>
        </pc:picChg>
        <pc:picChg chg="add mod">
          <ac:chgData name="Yang, Shengming - ARS" userId="37bd5b25-7571-49cb-bfc8-588a18706c35" providerId="ADAL" clId="{289504D4-974E-43B6-9BD4-CC07536E2F15}" dt="2022-03-10T18:24:45.330" v="1126" actId="571"/>
          <ac:picMkLst>
            <pc:docMk/>
            <pc:sldMk cId="3303732898" sldId="292"/>
            <ac:picMk id="13" creationId="{FFE12D57-BCA3-4D6D-9467-7032971BB99E}"/>
          </ac:picMkLst>
        </pc:picChg>
        <pc:picChg chg="add mod">
          <ac:chgData name="Yang, Shengming - ARS" userId="37bd5b25-7571-49cb-bfc8-588a18706c35" providerId="ADAL" clId="{289504D4-974E-43B6-9BD4-CC07536E2F15}" dt="2022-03-10T18:24:58.011" v="1134" actId="571"/>
          <ac:picMkLst>
            <pc:docMk/>
            <pc:sldMk cId="3303732898" sldId="292"/>
            <ac:picMk id="14" creationId="{9762DD45-BEA7-455E-AE79-5877541EDED9}"/>
          </ac:picMkLst>
        </pc:picChg>
        <pc:picChg chg="add mod">
          <ac:chgData name="Yang, Shengming - ARS" userId="37bd5b25-7571-49cb-bfc8-588a18706c35" providerId="ADAL" clId="{289504D4-974E-43B6-9BD4-CC07536E2F15}" dt="2022-03-10T18:24:58.011" v="1134" actId="571"/>
          <ac:picMkLst>
            <pc:docMk/>
            <pc:sldMk cId="3303732898" sldId="292"/>
            <ac:picMk id="15" creationId="{F556D223-89B6-43BD-A3B3-C2D1EACEF258}"/>
          </ac:picMkLst>
        </pc:picChg>
        <pc:picChg chg="add del mod">
          <ac:chgData name="Yang, Shengming - ARS" userId="37bd5b25-7571-49cb-bfc8-588a18706c35" providerId="ADAL" clId="{289504D4-974E-43B6-9BD4-CC07536E2F15}" dt="2022-03-10T20:50:54.683" v="1204" actId="478"/>
          <ac:picMkLst>
            <pc:docMk/>
            <pc:sldMk cId="3303732898" sldId="292"/>
            <ac:picMk id="17" creationId="{FDE7A0DF-73FF-4DCF-AEE9-D1F66D0684CE}"/>
          </ac:picMkLst>
        </pc:picChg>
        <pc:picChg chg="add del mod">
          <ac:chgData name="Yang, Shengming - ARS" userId="37bd5b25-7571-49cb-bfc8-588a18706c35" providerId="ADAL" clId="{289504D4-974E-43B6-9BD4-CC07536E2F15}" dt="2022-03-10T20:50:54.683" v="1204" actId="478"/>
          <ac:picMkLst>
            <pc:docMk/>
            <pc:sldMk cId="3303732898" sldId="292"/>
            <ac:picMk id="19" creationId="{DE99F9FF-C4D4-4404-AAB8-365488781162}"/>
          </ac:picMkLst>
        </pc:picChg>
        <pc:picChg chg="add del mod">
          <ac:chgData name="Yang, Shengming - ARS" userId="37bd5b25-7571-49cb-bfc8-588a18706c35" providerId="ADAL" clId="{289504D4-974E-43B6-9BD4-CC07536E2F15}" dt="2022-03-10T20:50:54.683" v="1204" actId="478"/>
          <ac:picMkLst>
            <pc:docMk/>
            <pc:sldMk cId="3303732898" sldId="292"/>
            <ac:picMk id="21" creationId="{D9DA51B5-5123-40AF-BB79-5039F293F7BC}"/>
          </ac:picMkLst>
        </pc:picChg>
      </pc:sldChg>
    </pc:docChg>
  </pc:docChgLst>
  <pc:docChgLst>
    <pc:chgData name="Yang, Shengming - ARS" userId="37bd5b25-7571-49cb-bfc8-588a18706c35" providerId="ADAL" clId="{7637BB5A-ED5B-4387-B28B-FAFFBA30BBF6}"/>
    <pc:docChg chg="custSel modSld">
      <pc:chgData name="Yang, Shengming - ARS" userId="37bd5b25-7571-49cb-bfc8-588a18706c35" providerId="ADAL" clId="{7637BB5A-ED5B-4387-B28B-FAFFBA30BBF6}" dt="2022-03-16T19:42:28.263" v="22"/>
      <pc:docMkLst>
        <pc:docMk/>
      </pc:docMkLst>
      <pc:sldChg chg="addSp delSp modSp mod">
        <pc:chgData name="Yang, Shengming - ARS" userId="37bd5b25-7571-49cb-bfc8-588a18706c35" providerId="ADAL" clId="{7637BB5A-ED5B-4387-B28B-FAFFBA30BBF6}" dt="2022-03-16T19:41:33.677" v="21"/>
        <pc:sldMkLst>
          <pc:docMk/>
          <pc:sldMk cId="887383785" sldId="278"/>
        </pc:sldMkLst>
        <pc:graphicFrameChg chg="add mod">
          <ac:chgData name="Yang, Shengming - ARS" userId="37bd5b25-7571-49cb-bfc8-588a18706c35" providerId="ADAL" clId="{7637BB5A-ED5B-4387-B28B-FAFFBA30BBF6}" dt="2022-03-16T19:41:33.677" v="21"/>
          <ac:graphicFrameMkLst>
            <pc:docMk/>
            <pc:sldMk cId="887383785" sldId="278"/>
            <ac:graphicFrameMk id="4" creationId="{DBB4A3FC-3A9C-4B93-8C50-F59C3749F655}"/>
          </ac:graphicFrameMkLst>
        </pc:graphicFrameChg>
        <pc:graphicFrameChg chg="del">
          <ac:chgData name="Yang, Shengming - ARS" userId="37bd5b25-7571-49cb-bfc8-588a18706c35" providerId="ADAL" clId="{7637BB5A-ED5B-4387-B28B-FAFFBA30BBF6}" dt="2022-03-16T19:41:32.301" v="20" actId="478"/>
          <ac:graphicFrameMkLst>
            <pc:docMk/>
            <pc:sldMk cId="887383785" sldId="278"/>
            <ac:graphicFrameMk id="6" creationId="{53E596D7-AB3A-4633-8D47-4B095118AE5E}"/>
          </ac:graphicFrameMkLst>
        </pc:graphicFrameChg>
      </pc:sldChg>
      <pc:sldChg chg="addSp delSp modSp mod">
        <pc:chgData name="Yang, Shengming - ARS" userId="37bd5b25-7571-49cb-bfc8-588a18706c35" providerId="ADAL" clId="{7637BB5A-ED5B-4387-B28B-FAFFBA30BBF6}" dt="2022-03-16T19:42:28.263" v="22"/>
        <pc:sldMkLst>
          <pc:docMk/>
          <pc:sldMk cId="530921904" sldId="291"/>
        </pc:sldMkLst>
        <pc:graphicFrameChg chg="add del mod">
          <ac:chgData name="Yang, Shengming - ARS" userId="37bd5b25-7571-49cb-bfc8-588a18706c35" providerId="ADAL" clId="{7637BB5A-ED5B-4387-B28B-FAFFBA30BBF6}" dt="2022-03-16T19:35:38.120" v="4" actId="478"/>
          <ac:graphicFrameMkLst>
            <pc:docMk/>
            <pc:sldMk cId="530921904" sldId="291"/>
            <ac:graphicFrameMk id="2" creationId="{181EAB28-D8BB-40DC-8AEF-2589EAE725EC}"/>
          </ac:graphicFrameMkLst>
        </pc:graphicFrameChg>
        <pc:graphicFrameChg chg="add del mod modGraphic">
          <ac:chgData name="Yang, Shengming - ARS" userId="37bd5b25-7571-49cb-bfc8-588a18706c35" providerId="ADAL" clId="{7637BB5A-ED5B-4387-B28B-FAFFBA30BBF6}" dt="2022-03-16T19:41:28.388" v="19" actId="21"/>
          <ac:graphicFrameMkLst>
            <pc:docMk/>
            <pc:sldMk cId="530921904" sldId="291"/>
            <ac:graphicFrameMk id="3" creationId="{8CF60E5A-1FA7-4B18-A554-FBDBD2EA4D03}"/>
          </ac:graphicFrameMkLst>
        </pc:graphicFrameChg>
        <pc:graphicFrameChg chg="del">
          <ac:chgData name="Yang, Shengming - ARS" userId="37bd5b25-7571-49cb-bfc8-588a18706c35" providerId="ADAL" clId="{7637BB5A-ED5B-4387-B28B-FAFFBA30BBF6}" dt="2022-03-16T19:35:17.397" v="0" actId="21"/>
          <ac:graphicFrameMkLst>
            <pc:docMk/>
            <pc:sldMk cId="530921904" sldId="291"/>
            <ac:graphicFrameMk id="4" creationId="{12240337-9653-4844-83C7-8964481C8519}"/>
          </ac:graphicFrameMkLst>
        </pc:graphicFrameChg>
        <pc:graphicFrameChg chg="add mod">
          <ac:chgData name="Yang, Shengming - ARS" userId="37bd5b25-7571-49cb-bfc8-588a18706c35" providerId="ADAL" clId="{7637BB5A-ED5B-4387-B28B-FAFFBA30BBF6}" dt="2022-03-16T19:42:28.263" v="22"/>
          <ac:graphicFrameMkLst>
            <pc:docMk/>
            <pc:sldMk cId="530921904" sldId="291"/>
            <ac:graphicFrameMk id="6" creationId="{A479B854-DC3A-4862-ACED-4ACF47A4B61F}"/>
          </ac:graphicFrameMkLst>
        </pc:graphicFrameChg>
      </pc:sldChg>
      <pc:sldChg chg="addSp delSp modSp mod">
        <pc:chgData name="Yang, Shengming - ARS" userId="37bd5b25-7571-49cb-bfc8-588a18706c35" providerId="ADAL" clId="{7637BB5A-ED5B-4387-B28B-FAFFBA30BBF6}" dt="2022-03-16T19:40:56.992" v="18" actId="1076"/>
        <pc:sldMkLst>
          <pc:docMk/>
          <pc:sldMk cId="2282065266" sldId="292"/>
        </pc:sldMkLst>
        <pc:graphicFrameChg chg="add del mod">
          <ac:chgData name="Yang, Shengming - ARS" userId="37bd5b25-7571-49cb-bfc8-588a18706c35" providerId="ADAL" clId="{7637BB5A-ED5B-4387-B28B-FAFFBA30BBF6}" dt="2022-03-16T19:40:53.168" v="17" actId="478"/>
          <ac:graphicFrameMkLst>
            <pc:docMk/>
            <pc:sldMk cId="2282065266" sldId="292"/>
            <ac:graphicFrameMk id="2" creationId="{54A3EF5E-D12C-43CB-B973-F592CA7CF4C6}"/>
          </ac:graphicFrameMkLst>
        </pc:graphicFrameChg>
        <pc:graphicFrameChg chg="add mod">
          <ac:chgData name="Yang, Shengming - ARS" userId="37bd5b25-7571-49cb-bfc8-588a18706c35" providerId="ADAL" clId="{7637BB5A-ED5B-4387-B28B-FAFFBA30BBF6}" dt="2022-03-16T19:40:56.992" v="18" actId="1076"/>
          <ac:graphicFrameMkLst>
            <pc:docMk/>
            <pc:sldMk cId="2282065266" sldId="292"/>
            <ac:graphicFrameMk id="3" creationId="{A0F8C46D-3CFE-4677-A518-154587BE828B}"/>
          </ac:graphicFrameMkLst>
        </pc:graphicFrameChg>
        <pc:graphicFrameChg chg="del">
          <ac:chgData name="Yang, Shengming - ARS" userId="37bd5b25-7571-49cb-bfc8-588a18706c35" providerId="ADAL" clId="{7637BB5A-ED5B-4387-B28B-FAFFBA30BBF6}" dt="2022-03-16T19:40:43.630" v="13" actId="478"/>
          <ac:graphicFrameMkLst>
            <pc:docMk/>
            <pc:sldMk cId="2282065266" sldId="292"/>
            <ac:graphicFrameMk id="4" creationId="{12240337-9653-4844-83C7-8964481C8519}"/>
          </ac:graphicFrameMkLst>
        </pc:graphicFrameChg>
      </pc:sldChg>
    </pc:docChg>
  </pc:docChgLst>
  <pc:docChgLst>
    <pc:chgData name="Yang, Shengming - ARS" userId="37bd5b25-7571-49cb-bfc8-588a18706c35" providerId="ADAL" clId="{4FA1546C-AAE4-4B89-86A7-C130A0B04C58}"/>
    <pc:docChg chg="undo custSel addSld delSld modSld sldOrd">
      <pc:chgData name="Yang, Shengming - ARS" userId="37bd5b25-7571-49cb-bfc8-588a18706c35" providerId="ADAL" clId="{4FA1546C-AAE4-4B89-86A7-C130A0B04C58}" dt="2022-06-22T20:33:04.980" v="3296" actId="20577"/>
      <pc:docMkLst>
        <pc:docMk/>
      </pc:docMkLst>
      <pc:sldChg chg="modSp mod">
        <pc:chgData name="Yang, Shengming - ARS" userId="37bd5b25-7571-49cb-bfc8-588a18706c35" providerId="ADAL" clId="{4FA1546C-AAE4-4B89-86A7-C130A0B04C58}" dt="2022-06-15T21:13:21.362" v="2972" actId="20577"/>
        <pc:sldMkLst>
          <pc:docMk/>
          <pc:sldMk cId="1525299809" sldId="275"/>
        </pc:sldMkLst>
        <pc:spChg chg="mod">
          <ac:chgData name="Yang, Shengming - ARS" userId="37bd5b25-7571-49cb-bfc8-588a18706c35" providerId="ADAL" clId="{4FA1546C-AAE4-4B89-86A7-C130A0B04C58}" dt="2022-06-15T21:13:21.362" v="2972" actId="20577"/>
          <ac:spMkLst>
            <pc:docMk/>
            <pc:sldMk cId="1525299809" sldId="275"/>
            <ac:spMk id="25" creationId="{A876130B-ED92-4416-90CA-563FA5FCBC5F}"/>
          </ac:spMkLst>
        </pc:spChg>
      </pc:sldChg>
      <pc:sldChg chg="ord">
        <pc:chgData name="Yang, Shengming - ARS" userId="37bd5b25-7571-49cb-bfc8-588a18706c35" providerId="ADAL" clId="{4FA1546C-AAE4-4B89-86A7-C130A0B04C58}" dt="2022-06-16T14:21:03.557" v="3155" actId="20578"/>
        <pc:sldMkLst>
          <pc:docMk/>
          <pc:sldMk cId="887383785" sldId="278"/>
        </pc:sldMkLst>
      </pc:sldChg>
      <pc:sldChg chg="modSp mod">
        <pc:chgData name="Yang, Shengming - ARS" userId="37bd5b25-7571-49cb-bfc8-588a18706c35" providerId="ADAL" clId="{4FA1546C-AAE4-4B89-86A7-C130A0B04C58}" dt="2022-06-15T21:26:28.024" v="3001" actId="20577"/>
        <pc:sldMkLst>
          <pc:docMk/>
          <pc:sldMk cId="2200906561" sldId="290"/>
        </pc:sldMkLst>
        <pc:spChg chg="mod">
          <ac:chgData name="Yang, Shengming - ARS" userId="37bd5b25-7571-49cb-bfc8-588a18706c35" providerId="ADAL" clId="{4FA1546C-AAE4-4B89-86A7-C130A0B04C58}" dt="2022-06-15T21:26:28.024" v="3001" actId="20577"/>
          <ac:spMkLst>
            <pc:docMk/>
            <pc:sldMk cId="2200906561" sldId="290"/>
            <ac:spMk id="58" creationId="{127FACC4-AEA3-45C6-A512-B76CA41EF55B}"/>
          </ac:spMkLst>
        </pc:spChg>
      </pc:sldChg>
      <pc:sldChg chg="ord">
        <pc:chgData name="Yang, Shengming - ARS" userId="37bd5b25-7571-49cb-bfc8-588a18706c35" providerId="ADAL" clId="{4FA1546C-AAE4-4B89-86A7-C130A0B04C58}" dt="2022-06-15T21:10:09.614" v="2965"/>
        <pc:sldMkLst>
          <pc:docMk/>
          <pc:sldMk cId="530921904" sldId="291"/>
        </pc:sldMkLst>
      </pc:sldChg>
      <pc:sldChg chg="modSp mod ord">
        <pc:chgData name="Yang, Shengming - ARS" userId="37bd5b25-7571-49cb-bfc8-588a18706c35" providerId="ADAL" clId="{4FA1546C-AAE4-4B89-86A7-C130A0B04C58}" dt="2022-06-16T15:26:26.877" v="3217" actId="114"/>
        <pc:sldMkLst>
          <pc:docMk/>
          <pc:sldMk cId="2282065266" sldId="292"/>
        </pc:sldMkLst>
        <pc:spChg chg="mod">
          <ac:chgData name="Yang, Shengming - ARS" userId="37bd5b25-7571-49cb-bfc8-588a18706c35" providerId="ADAL" clId="{4FA1546C-AAE4-4B89-86A7-C130A0B04C58}" dt="2022-06-16T14:21:35.623" v="3159" actId="20577"/>
          <ac:spMkLst>
            <pc:docMk/>
            <pc:sldMk cId="2282065266" sldId="292"/>
            <ac:spMk id="5" creationId="{22CABD5C-E7F8-4D30-AF77-D1DF38BD1326}"/>
          </ac:spMkLst>
        </pc:spChg>
        <pc:graphicFrameChg chg="mod modGraphic">
          <ac:chgData name="Yang, Shengming - ARS" userId="37bd5b25-7571-49cb-bfc8-588a18706c35" providerId="ADAL" clId="{4FA1546C-AAE4-4B89-86A7-C130A0B04C58}" dt="2022-06-16T15:26:26.877" v="3217" actId="114"/>
          <ac:graphicFrameMkLst>
            <pc:docMk/>
            <pc:sldMk cId="2282065266" sldId="292"/>
            <ac:graphicFrameMk id="3" creationId="{A0F8C46D-3CFE-4677-A518-154587BE828B}"/>
          </ac:graphicFrameMkLst>
        </pc:graphicFrameChg>
      </pc:sldChg>
      <pc:sldChg chg="addSp delSp modSp new mod">
        <pc:chgData name="Yang, Shengming - ARS" userId="37bd5b25-7571-49cb-bfc8-588a18706c35" providerId="ADAL" clId="{4FA1546C-AAE4-4B89-86A7-C130A0B04C58}" dt="2022-06-16T15:36:01.484" v="3219" actId="14100"/>
        <pc:sldMkLst>
          <pc:docMk/>
          <pc:sldMk cId="2589227480" sldId="293"/>
        </pc:sldMkLst>
        <pc:spChg chg="del">
          <ac:chgData name="Yang, Shengming - ARS" userId="37bd5b25-7571-49cb-bfc8-588a18706c35" providerId="ADAL" clId="{4FA1546C-AAE4-4B89-86A7-C130A0B04C58}" dt="2022-06-15T16:01:41.714" v="1" actId="478"/>
          <ac:spMkLst>
            <pc:docMk/>
            <pc:sldMk cId="2589227480" sldId="293"/>
            <ac:spMk id="2" creationId="{FFE1FA07-83BC-4F18-87BF-849389D4A786}"/>
          </ac:spMkLst>
        </pc:spChg>
        <pc:spChg chg="del">
          <ac:chgData name="Yang, Shengming - ARS" userId="37bd5b25-7571-49cb-bfc8-588a18706c35" providerId="ADAL" clId="{4FA1546C-AAE4-4B89-86A7-C130A0B04C58}" dt="2022-06-15T16:01:41.714" v="1" actId="478"/>
          <ac:spMkLst>
            <pc:docMk/>
            <pc:sldMk cId="2589227480" sldId="293"/>
            <ac:spMk id="3" creationId="{E22CE041-B8AE-4AA8-BE44-12ADA9B39DA9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6" creationId="{EBABDFAB-9059-4DE4-9E1E-ACE8458AAE51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7" creationId="{E8ACE48E-D164-4B9D-B329-565028B27A2C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8" creationId="{C5C55104-D522-41DB-93F6-DF80B525D13B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9" creationId="{4B135AEC-B398-4ACF-BBE7-8743B5D02C41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0" creationId="{173A45CE-7FAA-4927-AF0B-23A32A8CA548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1" creationId="{18F8A3AF-FAE9-4577-817B-6D511413DA65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2" creationId="{3F0DCC11-D4CB-4F1C-B9FB-E1394721C0E0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3" creationId="{DB5A4933-CF11-4AB5-932B-84BDCBFFB809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4" creationId="{C77BFB50-48AD-469A-94BB-E0CA2135C184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5" creationId="{A018B8A4-9BE6-43F5-8604-A76D00BD4949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6" creationId="{6A338B3F-3120-4AD4-AB0F-C8525465A3A2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7" creationId="{7BCB8FE6-3364-4258-ABBC-830200CB5BB0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8" creationId="{1A2AD85E-926D-46FD-9F1A-397E8FF2CC67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19" creationId="{9D59066D-222A-4B6F-A461-683A2AEB6E10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0" creationId="{B1D598EA-1B00-444B-AA63-AC9937D782A8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1" creationId="{410C12DF-EA62-45B1-9E8A-24F8D153CF43}"/>
          </ac:spMkLst>
        </pc:spChg>
        <pc:spChg chg="add mod">
          <ac:chgData name="Yang, Shengming - ARS" userId="37bd5b25-7571-49cb-bfc8-588a18706c35" providerId="ADAL" clId="{4FA1546C-AAE4-4B89-86A7-C130A0B04C58}" dt="2022-06-16T15:36:01.484" v="3219" actId="14100"/>
          <ac:spMkLst>
            <pc:docMk/>
            <pc:sldMk cId="2589227480" sldId="293"/>
            <ac:spMk id="23" creationId="{9678172C-DAD8-4225-9157-C796BB2BC932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4" creationId="{30A92E5A-3B0A-45E8-A9B1-0684CA5E8505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5" creationId="{33189B57-48A5-495B-811D-D7C2493F6F2B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6" creationId="{1A43C643-0F66-4159-A9FF-576F7C92EB0F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7" creationId="{C82DD6B3-F159-4D6E-81A5-56DACAF95DBB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8" creationId="{B8F9A9AD-D20B-4ECE-A76A-B06BE19A842B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29" creationId="{7D89E1B4-6E06-4C13-9033-BCDF3E17E564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0" creationId="{D007F2F9-319D-4AF3-955D-5D3B27AAE9EF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1" creationId="{B1FDB1A6-C213-4CDC-B31C-F8DD408350DA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2" creationId="{D14C0B03-C416-4ED3-B464-9E3EBEAB8294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3" creationId="{D0E52C7A-6757-4980-8B46-372CD1CD4922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4" creationId="{4B337127-33B7-4A08-B01E-1709799B4B4D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5" creationId="{9B228087-01B6-4450-99BA-7CF7156843B0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6" creationId="{9F9DEE46-B13D-483F-8142-17B2A68B52B4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7" creationId="{DA0D0419-8F45-4529-9F96-8162059FE972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8" creationId="{5E58AC31-5DBD-4880-BA0C-EA97556CF8A2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39" creationId="{690D6783-9C68-4BF2-AF07-CB877EE3853C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40" creationId="{3DC32442-42EC-49EB-AACE-5BCCB0E37654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41" creationId="{73931615-BECF-40E4-9D21-9F7B79F4DCC0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42" creationId="{957A5AE3-8874-49BC-B4F8-2D8741B36734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48" creationId="{86FC69F3-CE86-4970-8149-5F9FCBF09565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49" creationId="{8A41AD58-439F-4E6E-98C6-D2BA1577B61F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0" creationId="{ADFFE4B3-B7EF-4A46-8B82-41F4372C54E9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1" creationId="{31372DFE-5F66-475D-93B2-320195D28869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2" creationId="{92E955FC-CB3B-4BD9-9B14-86A68C61CDB6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3" creationId="{F114F5FE-8C1A-4DE8-A834-8ECFE4BF1295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4" creationId="{93702F0C-C1EA-44A1-BC76-1259F1BC1D8A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5" creationId="{14171844-E816-49CD-8978-CF6ACC0FB495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6" creationId="{CA752959-9631-4259-9F27-46B34C1D0B4E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7" creationId="{5C2FB1B6-99BF-461E-BD70-B46ACB0003B0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8" creationId="{397D35FC-E9B0-4F8C-8FEE-E2BEA6AEA2B3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59" creationId="{77772138-1AA4-4807-822C-0E635B08C6E4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0" creationId="{FD222D82-BD6C-4D11-8467-B8B55B57C8CD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1" creationId="{EBC5CF5C-DF2D-4D08-AACA-323CF150E046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2" creationId="{2472AA52-ADFA-4D0A-A1E5-4CDA2170412A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3" creationId="{DC9CBBFA-C7D6-4E3F-9128-AF67187F54FC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5" creationId="{2227E432-AB81-4802-841A-7AFA4F00BFB5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6" creationId="{75761403-6550-453C-94DB-25A2C7DBEEC7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7" creationId="{03A8CBDD-1AB5-4E91-B908-1E43A419E858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8" creationId="{AF30F94E-8A0A-4A60-A5DA-F874BF41D5E0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69" creationId="{D00021FA-06C8-41E0-B921-34DE585F056D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0" creationId="{9A1E74CC-12DC-471F-871D-E2C45D95FE5B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1" creationId="{1A7F613B-8A38-4B7D-8DA5-B5C812789E62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2" creationId="{9D0041F1-1089-46DA-BB85-4A571F96FD24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3" creationId="{906159A5-0E52-4D5D-B30E-6DDB2D2250DE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4" creationId="{BCFBD326-A244-46BE-9D8E-89A5AA070A07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5" creationId="{34A065B6-C47B-467B-9C15-59AE17D1376C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6" creationId="{47B10823-C113-457C-9CE3-0F1B9AD8891C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7" creationId="{5B7B8372-0F93-4EBD-B9AC-F1DE93ACAAB5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8" creationId="{F0CA6205-6F0B-4B12-B8B4-3AA5797346FE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79" creationId="{9270A7C4-0CE7-40CB-B54C-D9A4062D1738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80" creationId="{5C76013D-6D40-4F4D-9D91-B3A63F308F12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81" creationId="{B2F896F9-82D8-46CD-9354-84F4F1DA1E2E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82" creationId="{49727D5A-6C8E-46F4-A0A0-6B41FC095FD9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83" creationId="{10C8632E-0F19-4F92-AE47-DB4166399B9B}"/>
          </ac:spMkLst>
        </pc:spChg>
        <pc:spChg chg="add del mod">
          <ac:chgData name="Yang, Shengming - ARS" userId="37bd5b25-7571-49cb-bfc8-588a18706c35" providerId="ADAL" clId="{4FA1546C-AAE4-4B89-86A7-C130A0B04C58}" dt="2022-06-15T16:01:52.419" v="4" actId="478"/>
          <ac:spMkLst>
            <pc:docMk/>
            <pc:sldMk cId="2589227480" sldId="293"/>
            <ac:spMk id="84" creationId="{F9B7301C-4F6B-42DF-A4C1-34D07224D51B}"/>
          </ac:spMkLst>
        </pc:spChg>
        <pc:spChg chg="add mod">
          <ac:chgData name="Yang, Shengming - ARS" userId="37bd5b25-7571-49cb-bfc8-588a18706c35" providerId="ADAL" clId="{4FA1546C-AAE4-4B89-86A7-C130A0B04C58}" dt="2022-06-15T18:46:04.811" v="1832" actId="1036"/>
          <ac:spMkLst>
            <pc:docMk/>
            <pc:sldMk cId="2589227480" sldId="293"/>
            <ac:spMk id="94" creationId="{5A2AA21E-FE5D-476C-8E51-F3BFE7ABB020}"/>
          </ac:spMkLst>
        </pc:spChg>
        <pc:spChg chg="add mod">
          <ac:chgData name="Yang, Shengming - ARS" userId="37bd5b25-7571-49cb-bfc8-588a18706c35" providerId="ADAL" clId="{4FA1546C-AAE4-4B89-86A7-C130A0B04C58}" dt="2022-06-15T19:39:53.163" v="2571" actId="20577"/>
          <ac:spMkLst>
            <pc:docMk/>
            <pc:sldMk cId="2589227480" sldId="293"/>
            <ac:spMk id="95" creationId="{E0628C6F-7A08-4A08-BFEC-6B6405268387}"/>
          </ac:spMkLst>
        </pc:sp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4" creationId="{4D125AA6-BA27-490B-882C-B9EA0E1E05CD}"/>
          </ac:cxnSpMkLst>
        </pc:cxn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5" creationId="{F9A1E287-8B50-4D93-9955-9708520C546D}"/>
          </ac:cxnSpMkLst>
        </pc:cxn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22" creationId="{B9569366-2062-4C0E-9A57-9DFBDDFB9384}"/>
          </ac:cxnSpMkLst>
        </pc:cxn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43" creationId="{95A2589F-2A7F-4DB5-A175-05F46218F674}"/>
          </ac:cxnSpMkLst>
        </pc:cxn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44" creationId="{7DD600D4-68B3-48BF-B410-127EA5BAC6AE}"/>
          </ac:cxnSpMkLst>
        </pc:cxnChg>
        <pc:cxnChg chg="add mod">
          <ac:chgData name="Yang, Shengming - ARS" userId="37bd5b25-7571-49cb-bfc8-588a18706c35" providerId="ADAL" clId="{4FA1546C-AAE4-4B89-86A7-C130A0B04C58}" dt="2022-06-15T18:46:04.811" v="1832" actId="1036"/>
          <ac:cxnSpMkLst>
            <pc:docMk/>
            <pc:sldMk cId="2589227480" sldId="293"/>
            <ac:cxnSpMk id="45" creationId="{06967838-11B7-4882-9EBF-EA9919F60218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46" creationId="{9BC78013-82C4-4C4B-86C3-1863A9A7A8CD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47" creationId="{6FED00B0-8DE9-4382-9CC5-D89FB48B7358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64" creationId="{B3E0BB8F-A4BC-45BD-ACC0-C62DAD9D79C9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85" creationId="{C0FC974A-1168-46FA-99BD-E3D94E2E9E4C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86" creationId="{D4340759-3E87-44F7-A798-CBAE84A676A7}"/>
          </ac:cxnSpMkLst>
        </pc:cxnChg>
        <pc:cxnChg chg="add del mod">
          <ac:chgData name="Yang, Shengming - ARS" userId="37bd5b25-7571-49cb-bfc8-588a18706c35" providerId="ADAL" clId="{4FA1546C-AAE4-4B89-86A7-C130A0B04C58}" dt="2022-06-15T16:01:52.419" v="4" actId="478"/>
          <ac:cxnSpMkLst>
            <pc:docMk/>
            <pc:sldMk cId="2589227480" sldId="293"/>
            <ac:cxnSpMk id="87" creationId="{BDC0E411-130A-4584-9D52-F2DDCC505B61}"/>
          </ac:cxnSpMkLst>
        </pc:cxnChg>
      </pc:sldChg>
      <pc:sldChg chg="addSp delSp modSp new mod modNotesTx">
        <pc:chgData name="Yang, Shengming - ARS" userId="37bd5b25-7571-49cb-bfc8-588a18706c35" providerId="ADAL" clId="{4FA1546C-AAE4-4B89-86A7-C130A0B04C58}" dt="2022-06-15T20:35:37.457" v="2963" actId="1076"/>
        <pc:sldMkLst>
          <pc:docMk/>
          <pc:sldMk cId="3317137651" sldId="294"/>
        </pc:sldMkLst>
        <pc:spChg chg="del">
          <ac:chgData name="Yang, Shengming - ARS" userId="37bd5b25-7571-49cb-bfc8-588a18706c35" providerId="ADAL" clId="{4FA1546C-AAE4-4B89-86A7-C130A0B04C58}" dt="2022-06-15T18:59:28.233" v="1834" actId="478"/>
          <ac:spMkLst>
            <pc:docMk/>
            <pc:sldMk cId="3317137651" sldId="294"/>
            <ac:spMk id="2" creationId="{D93DD3FC-218A-4D80-BF85-1B776F2F1D37}"/>
          </ac:spMkLst>
        </pc:spChg>
        <pc:spChg chg="del">
          <ac:chgData name="Yang, Shengming - ARS" userId="37bd5b25-7571-49cb-bfc8-588a18706c35" providerId="ADAL" clId="{4FA1546C-AAE4-4B89-86A7-C130A0B04C58}" dt="2022-06-15T18:59:28.233" v="1834" actId="478"/>
          <ac:spMkLst>
            <pc:docMk/>
            <pc:sldMk cId="3317137651" sldId="294"/>
            <ac:spMk id="3" creationId="{D6409E35-13EF-414A-A997-18D184EBA402}"/>
          </ac:spMkLst>
        </pc:spChg>
        <pc:spChg chg="add mod">
          <ac:chgData name="Yang, Shengming - ARS" userId="37bd5b25-7571-49cb-bfc8-588a18706c35" providerId="ADAL" clId="{4FA1546C-AAE4-4B89-86A7-C130A0B04C58}" dt="2022-06-15T20:35:37.457" v="2963" actId="1076"/>
          <ac:spMkLst>
            <pc:docMk/>
            <pc:sldMk cId="3317137651" sldId="294"/>
            <ac:spMk id="8" creationId="{E1C32CE9-6DE9-43B3-83FA-0B29EACDF6C5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0" creationId="{8FCFBE82-350D-4F58-8E39-EFDE2BA53F88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1" creationId="{34C67E29-790D-4845-A2EE-C9DBF6772E22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2" creationId="{E375B6E2-2A71-446E-ACF4-13C440C5CA17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3" creationId="{113CDD8D-230F-4321-86DD-AF3C302A5CF7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4" creationId="{25230A61-9A24-49F4-AD94-75699FAC69FE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5" creationId="{E2A3D281-D9B9-4359-AD99-7A12CFFC2469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6" creationId="{70EA226E-8A1D-4203-9757-3F9D004BBDDE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7" creationId="{EE699132-1107-4D9A-8C5F-AAABD6A677AC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19" creationId="{897F1763-2F2C-43BD-95B4-9F92881CFA6C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20" creationId="{790F631B-AFC4-4DFC-900C-1772E36890D0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21" creationId="{CC392E81-18E2-47BF-8982-80C86BA0D11A}"/>
          </ac:spMkLst>
        </pc:spChg>
        <pc:spChg chg="add mod">
          <ac:chgData name="Yang, Shengming - ARS" userId="37bd5b25-7571-49cb-bfc8-588a18706c35" providerId="ADAL" clId="{4FA1546C-AAE4-4B89-86A7-C130A0B04C58}" dt="2022-06-15T20:34:58.986" v="2962" actId="1076"/>
          <ac:spMkLst>
            <pc:docMk/>
            <pc:sldMk cId="3317137651" sldId="294"/>
            <ac:spMk id="22" creationId="{6E84DDA2-F23D-4E5E-B300-40E72399F14F}"/>
          </ac:spMkLst>
        </pc:spChg>
        <pc:graphicFrameChg chg="add mod">
          <ac:chgData name="Yang, Shengming - ARS" userId="37bd5b25-7571-49cb-bfc8-588a18706c35" providerId="ADAL" clId="{4FA1546C-AAE4-4B89-86A7-C130A0B04C58}" dt="2022-06-15T20:34:58.986" v="2962" actId="1076"/>
          <ac:graphicFrameMkLst>
            <pc:docMk/>
            <pc:sldMk cId="3317137651" sldId="294"/>
            <ac:graphicFrameMk id="4" creationId="{1126EB88-28CD-4B9E-99FD-9095D9E1C2DD}"/>
          </ac:graphicFrameMkLst>
        </pc:graphicFrameChg>
        <pc:graphicFrameChg chg="add mod">
          <ac:chgData name="Yang, Shengming - ARS" userId="37bd5b25-7571-49cb-bfc8-588a18706c35" providerId="ADAL" clId="{4FA1546C-AAE4-4B89-86A7-C130A0B04C58}" dt="2022-06-15T20:34:58.986" v="2962" actId="1076"/>
          <ac:graphicFrameMkLst>
            <pc:docMk/>
            <pc:sldMk cId="3317137651" sldId="294"/>
            <ac:graphicFrameMk id="5" creationId="{8461EFB3-125F-4A8C-9BB9-15E525D07071}"/>
          </ac:graphicFrameMkLst>
        </pc:graphicFrameChg>
        <pc:graphicFrameChg chg="add mod">
          <ac:chgData name="Yang, Shengming - ARS" userId="37bd5b25-7571-49cb-bfc8-588a18706c35" providerId="ADAL" clId="{4FA1546C-AAE4-4B89-86A7-C130A0B04C58}" dt="2022-06-15T20:34:58.986" v="2962" actId="1076"/>
          <ac:graphicFrameMkLst>
            <pc:docMk/>
            <pc:sldMk cId="3317137651" sldId="294"/>
            <ac:graphicFrameMk id="6" creationId="{B8BF5A40-FB34-4E4C-AF2E-4E34FBB6C309}"/>
          </ac:graphicFrameMkLst>
        </pc:graphicFrameChg>
        <pc:graphicFrameChg chg="add mod">
          <ac:chgData name="Yang, Shengming - ARS" userId="37bd5b25-7571-49cb-bfc8-588a18706c35" providerId="ADAL" clId="{4FA1546C-AAE4-4B89-86A7-C130A0B04C58}" dt="2022-06-15T20:34:58.986" v="2962" actId="1076"/>
          <ac:graphicFrameMkLst>
            <pc:docMk/>
            <pc:sldMk cId="3317137651" sldId="294"/>
            <ac:graphicFrameMk id="7" creationId="{8DFE45D0-B106-467B-B65C-E3F13AEB97D3}"/>
          </ac:graphicFrameMkLst>
        </pc:graphicFrameChg>
      </pc:sldChg>
      <pc:sldChg chg="addSp delSp modSp new mod modNotesTx">
        <pc:chgData name="Yang, Shengming - ARS" userId="37bd5b25-7571-49cb-bfc8-588a18706c35" providerId="ADAL" clId="{4FA1546C-AAE4-4B89-86A7-C130A0B04C58}" dt="2022-06-15T21:14:07.239" v="2976" actId="20577"/>
        <pc:sldMkLst>
          <pc:docMk/>
          <pc:sldMk cId="2983717248" sldId="295"/>
        </pc:sldMkLst>
        <pc:spChg chg="del">
          <ac:chgData name="Yang, Shengming - ARS" userId="37bd5b25-7571-49cb-bfc8-588a18706c35" providerId="ADAL" clId="{4FA1546C-AAE4-4B89-86A7-C130A0B04C58}" dt="2022-06-15T19:42:42.502" v="2574" actId="478"/>
          <ac:spMkLst>
            <pc:docMk/>
            <pc:sldMk cId="2983717248" sldId="295"/>
            <ac:spMk id="2" creationId="{5780D539-2B87-4F4F-BF7B-16FFB57F00B4}"/>
          </ac:spMkLst>
        </pc:spChg>
        <pc:spChg chg="del">
          <ac:chgData name="Yang, Shengming - ARS" userId="37bd5b25-7571-49cb-bfc8-588a18706c35" providerId="ADAL" clId="{4FA1546C-AAE4-4B89-86A7-C130A0B04C58}" dt="2022-06-15T19:42:42.502" v="2574" actId="478"/>
          <ac:spMkLst>
            <pc:docMk/>
            <pc:sldMk cId="2983717248" sldId="295"/>
            <ac:spMk id="3" creationId="{CFF4D411-69F9-4ED2-8143-7A1C1F7FB297}"/>
          </ac:spMkLst>
        </pc:spChg>
        <pc:spChg chg="add mod">
          <ac:chgData name="Yang, Shengming - ARS" userId="37bd5b25-7571-49cb-bfc8-588a18706c35" providerId="ADAL" clId="{4FA1546C-AAE4-4B89-86A7-C130A0B04C58}" dt="2022-06-15T21:14:07.239" v="2976" actId="20577"/>
          <ac:spMkLst>
            <pc:docMk/>
            <pc:sldMk cId="2983717248" sldId="295"/>
            <ac:spMk id="8" creationId="{EAE2D391-4525-4372-A2DB-B7DCCFC896CD}"/>
          </ac:spMkLst>
        </pc:spChg>
        <pc:spChg chg="add mod">
          <ac:chgData name="Yang, Shengming - ARS" userId="37bd5b25-7571-49cb-bfc8-588a18706c35" providerId="ADAL" clId="{4FA1546C-AAE4-4B89-86A7-C130A0B04C58}" dt="2022-06-15T20:21:51.525" v="2769" actId="164"/>
          <ac:spMkLst>
            <pc:docMk/>
            <pc:sldMk cId="2983717248" sldId="295"/>
            <ac:spMk id="10" creationId="{AC6F6A05-AB6E-43CD-A419-5C94D22CF921}"/>
          </ac:spMkLst>
        </pc:spChg>
        <pc:spChg chg="add mod">
          <ac:chgData name="Yang, Shengming - ARS" userId="37bd5b25-7571-49cb-bfc8-588a18706c35" providerId="ADAL" clId="{4FA1546C-AAE4-4B89-86A7-C130A0B04C58}" dt="2022-06-15T20:21:51.525" v="2769" actId="164"/>
          <ac:spMkLst>
            <pc:docMk/>
            <pc:sldMk cId="2983717248" sldId="295"/>
            <ac:spMk id="11" creationId="{D557658E-A638-46AF-9998-1F07470E23B1}"/>
          </ac:spMkLst>
        </pc:spChg>
        <pc:grpChg chg="add mod">
          <ac:chgData name="Yang, Shengming - ARS" userId="37bd5b25-7571-49cb-bfc8-588a18706c35" providerId="ADAL" clId="{4FA1546C-AAE4-4B89-86A7-C130A0B04C58}" dt="2022-06-15T20:21:55.652" v="2770" actId="1076"/>
          <ac:grpSpMkLst>
            <pc:docMk/>
            <pc:sldMk cId="2983717248" sldId="295"/>
            <ac:grpSpMk id="12" creationId="{31125B33-9867-4133-B845-71DC7469E4EC}"/>
          </ac:grpSpMkLst>
        </pc:grpChg>
        <pc:graphicFrameChg chg="add del mod">
          <ac:chgData name="Yang, Shengming - ARS" userId="37bd5b25-7571-49cb-bfc8-588a18706c35" providerId="ADAL" clId="{4FA1546C-AAE4-4B89-86A7-C130A0B04C58}" dt="2022-06-15T20:03:31.781" v="2582" actId="478"/>
          <ac:graphicFrameMkLst>
            <pc:docMk/>
            <pc:sldMk cId="2983717248" sldId="295"/>
            <ac:graphicFrameMk id="4" creationId="{3E4F9A22-9E32-41EE-AC1C-9F3F836EAD2D}"/>
          </ac:graphicFrameMkLst>
        </pc:graphicFrameChg>
        <pc:graphicFrameChg chg="add del mod">
          <ac:chgData name="Yang, Shengming - ARS" userId="37bd5b25-7571-49cb-bfc8-588a18706c35" providerId="ADAL" clId="{4FA1546C-AAE4-4B89-86A7-C130A0B04C58}" dt="2022-06-15T20:11:38.622" v="2628" actId="478"/>
          <ac:graphicFrameMkLst>
            <pc:docMk/>
            <pc:sldMk cId="2983717248" sldId="295"/>
            <ac:graphicFrameMk id="5" creationId="{BE73D9EB-B6BB-4B6D-9030-1B07B6922158}"/>
          </ac:graphicFrameMkLst>
        </pc:graphicFrameChg>
        <pc:graphicFrameChg chg="add del mod">
          <ac:chgData name="Yang, Shengming - ARS" userId="37bd5b25-7571-49cb-bfc8-588a18706c35" providerId="ADAL" clId="{4FA1546C-AAE4-4B89-86A7-C130A0B04C58}" dt="2022-06-15T20:12:45.391" v="2644" actId="478"/>
          <ac:graphicFrameMkLst>
            <pc:docMk/>
            <pc:sldMk cId="2983717248" sldId="295"/>
            <ac:graphicFrameMk id="6" creationId="{BE73D9EB-B6BB-4B6D-9030-1B07B6922158}"/>
          </ac:graphicFrameMkLst>
        </pc:graphicFrameChg>
        <pc:graphicFrameChg chg="add mod">
          <ac:chgData name="Yang, Shengming - ARS" userId="37bd5b25-7571-49cb-bfc8-588a18706c35" providerId="ADAL" clId="{4FA1546C-AAE4-4B89-86A7-C130A0B04C58}" dt="2022-06-15T20:21:51.525" v="2769" actId="164"/>
          <ac:graphicFrameMkLst>
            <pc:docMk/>
            <pc:sldMk cId="2983717248" sldId="295"/>
            <ac:graphicFrameMk id="7" creationId="{BB04B508-E7BB-433F-9BFE-53401031126B}"/>
          </ac:graphicFrameMkLst>
        </pc:graphicFrameChg>
      </pc:sldChg>
      <pc:sldChg chg="addSp delSp modSp new mod ord">
        <pc:chgData name="Yang, Shengming - ARS" userId="37bd5b25-7571-49cb-bfc8-588a18706c35" providerId="ADAL" clId="{4FA1546C-AAE4-4B89-86A7-C130A0B04C58}" dt="2022-06-16T14:19:07.013" v="3148" actId="478"/>
        <pc:sldMkLst>
          <pc:docMk/>
          <pc:sldMk cId="2009276644" sldId="296"/>
        </pc:sldMkLst>
        <pc:spChg chg="del">
          <ac:chgData name="Yang, Shengming - ARS" userId="37bd5b25-7571-49cb-bfc8-588a18706c35" providerId="ADAL" clId="{4FA1546C-AAE4-4B89-86A7-C130A0B04C58}" dt="2022-06-15T22:37:56.405" v="3003" actId="478"/>
          <ac:spMkLst>
            <pc:docMk/>
            <pc:sldMk cId="2009276644" sldId="296"/>
            <ac:spMk id="2" creationId="{EF0C1127-90F7-48B3-996B-E8D208C74F65}"/>
          </ac:spMkLst>
        </pc:spChg>
        <pc:spChg chg="del">
          <ac:chgData name="Yang, Shengming - ARS" userId="37bd5b25-7571-49cb-bfc8-588a18706c35" providerId="ADAL" clId="{4FA1546C-AAE4-4B89-86A7-C130A0B04C58}" dt="2022-06-15T22:37:56.405" v="3003" actId="478"/>
          <ac:spMkLst>
            <pc:docMk/>
            <pc:sldMk cId="2009276644" sldId="296"/>
            <ac:spMk id="3" creationId="{B7953804-8B8E-47B2-A128-60DBAF42BB99}"/>
          </ac:spMkLst>
        </pc:spChg>
        <pc:spChg chg="add mod">
          <ac:chgData name="Yang, Shengming - ARS" userId="37bd5b25-7571-49cb-bfc8-588a18706c35" providerId="ADAL" clId="{4FA1546C-AAE4-4B89-86A7-C130A0B04C58}" dt="2022-06-15T22:54:22.203" v="3134" actId="20577"/>
          <ac:spMkLst>
            <pc:docMk/>
            <pc:sldMk cId="2009276644" sldId="296"/>
            <ac:spMk id="6" creationId="{C3E6BED6-1EE8-48E5-86AA-B75C468E9D4C}"/>
          </ac:spMkLst>
        </pc:spChg>
        <pc:graphicFrameChg chg="add mod">
          <ac:chgData name="Yang, Shengming - ARS" userId="37bd5b25-7571-49cb-bfc8-588a18706c35" providerId="ADAL" clId="{4FA1546C-AAE4-4B89-86A7-C130A0B04C58}" dt="2022-06-15T22:41:42.695" v="3114"/>
          <ac:graphicFrameMkLst>
            <pc:docMk/>
            <pc:sldMk cId="2009276644" sldId="296"/>
            <ac:graphicFrameMk id="4" creationId="{0EEFB574-2781-4201-8BBC-87AB4FE082CF}"/>
          </ac:graphicFrameMkLst>
        </pc:graphicFrameChg>
        <pc:graphicFrameChg chg="add del mod">
          <ac:chgData name="Yang, Shengming - ARS" userId="37bd5b25-7571-49cb-bfc8-588a18706c35" providerId="ADAL" clId="{4FA1546C-AAE4-4B89-86A7-C130A0B04C58}" dt="2022-06-16T14:19:07.013" v="3148" actId="478"/>
          <ac:graphicFrameMkLst>
            <pc:docMk/>
            <pc:sldMk cId="2009276644" sldId="296"/>
            <ac:graphicFrameMk id="5" creationId="{D7136499-5921-4611-BF85-BDCE33D8E00D}"/>
          </ac:graphicFrameMkLst>
        </pc:graphicFrameChg>
      </pc:sldChg>
      <pc:sldChg chg="new del">
        <pc:chgData name="Yang, Shengming - ARS" userId="37bd5b25-7571-49cb-bfc8-588a18706c35" providerId="ADAL" clId="{4FA1546C-AAE4-4B89-86A7-C130A0B04C58}" dt="2022-06-16T14:14:54.323" v="3136" actId="47"/>
        <pc:sldMkLst>
          <pc:docMk/>
          <pc:sldMk cId="768961359" sldId="297"/>
        </pc:sldMkLst>
      </pc:sldChg>
      <pc:sldChg chg="modSp mod ord">
        <pc:chgData name="Yang, Shengming - ARS" userId="37bd5b25-7571-49cb-bfc8-588a18706c35" providerId="ADAL" clId="{4FA1546C-AAE4-4B89-86A7-C130A0B04C58}" dt="2022-06-22T20:33:04.980" v="3296" actId="20577"/>
        <pc:sldMkLst>
          <pc:docMk/>
          <pc:sldMk cId="4290271837" sldId="298"/>
        </pc:sldMkLst>
        <pc:spChg chg="mod">
          <ac:chgData name="Yang, Shengming - ARS" userId="37bd5b25-7571-49cb-bfc8-588a18706c35" providerId="ADAL" clId="{4FA1546C-AAE4-4B89-86A7-C130A0B04C58}" dt="2022-06-16T14:23:40.102" v="3160" actId="20577"/>
          <ac:spMkLst>
            <pc:docMk/>
            <pc:sldMk cId="4290271837" sldId="298"/>
            <ac:spMk id="8" creationId="{5515DB95-FBE6-4796-B2FD-611D25C9C78D}"/>
          </ac:spMkLst>
        </pc:spChg>
        <pc:graphicFrameChg chg="mod modGraphic">
          <ac:chgData name="Yang, Shengming - ARS" userId="37bd5b25-7571-49cb-bfc8-588a18706c35" providerId="ADAL" clId="{4FA1546C-AAE4-4B89-86A7-C130A0B04C58}" dt="2022-06-22T20:33:04.980" v="3296" actId="20577"/>
          <ac:graphicFrameMkLst>
            <pc:docMk/>
            <pc:sldMk cId="4290271837" sldId="298"/>
            <ac:graphicFrameMk id="3" creationId="{598A6666-D6A3-47EA-A96B-593FCF83FFB3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EDADCB-2055-4B10-8B09-177121045534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663C3E-7718-42B7-A92C-FE5D3647C4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483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1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663C3E-7718-42B7-A92C-FE5D3647C41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7993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1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663C3E-7718-42B7-A92C-FE5D3647C41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427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E37C09-13B2-4F2F-927D-6FC09CE67B0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5838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Table 1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8663C3E-7718-42B7-A92C-FE5D3647C41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37869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D8AFFE-3BB4-4A63-893C-90E060212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D4F3BF4-D4AA-44CF-BD0A-410050889D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4F6540-9B4D-4336-8BEC-9265A9449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FB35D2-D9B1-4D3D-9C62-D49A9B55D1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B7ECF-DC79-4591-BA38-D06C0220F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6891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C7652-E38C-4CBF-B81F-849A53BF6F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FD65A56-1791-4C18-93E9-1EFEA9432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EBF1BB-219E-4CE5-9AF5-CD158E9BE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ADE685-AE43-499E-BA33-3DA8EC2BBF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95353F-3A6F-4B13-AB0B-F5ACD6EF8E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791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7EA0FA7-5F41-4DC7-BD80-725FA15023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2F7F3C-FB57-4313-B68D-1D6F0AAE6B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EDD121-2162-464B-A1C0-BFCB1B6D81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D25492-1EEB-485A-B4DA-65029CF92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C1AE3D-5ADD-451B-B32F-4C0DB7F4E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842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A44BD5-A29E-404E-BFBB-A41AF50247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4C44AD-7D61-4EAE-BE8E-DC3FF86A3F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410413-C98D-4F16-88DA-8BA0A2FDF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B4063-5E45-4421-8280-7146067D8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BB2AD8-195F-432C-A4E2-2C2588914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616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C3D42A-288B-4892-9C25-7955A3B3C4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68557C-CA44-46C0-AD45-1631F3AFAA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EBE2DE-02A7-43F6-86A4-C4BCC3A22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FA1C66-AD1E-4935-9955-F737D727C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85966D-3006-4449-AF40-C081E8F9E6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908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15D8C-5C8B-4CEF-8A43-24FC9795E2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AF47C8-8AFF-4493-9A9C-31719EE7CA9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D21D5F7-9959-4CF1-A6F2-6D3C49AAE7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4DEAC0-DD7B-4A44-B626-47B01C0A5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E5B6C1-00F6-4EFB-A64C-7863787BE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2B9009-CDD9-4460-86C3-D2CB99861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960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C0FEA7-6347-41CA-9F84-1298091AE9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838EDFA-E22A-4D2C-9811-E2204888CC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57A361-F96B-412D-B87B-0FE907C0F1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353661D-0E4F-4EC0-B5C9-4C42F0924C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BAA766E-77D9-4F45-B245-2A731FEC0B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E513FBF-C0CA-46BF-8090-4DA46CB4F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9643B2-7645-4DCE-A591-A9F6D4D14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64107D-3951-4E2D-908E-134D7ED03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398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527A0-E1AB-4272-B2FE-359B8D23BF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00B065-02FC-4081-B4B9-9821D774C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E1D5D9-01DA-4E34-ACFA-C19C241AE4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C5452-0891-4BFD-B0D8-C493B3AEE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8233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F12F57-80C0-47EA-8B84-78C942648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F2CB78-53E2-4837-B94D-50D612A302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9F51BE-BC9C-41E1-907A-BFC5F39B0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432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84B522-A851-4D57-B142-9FECE77280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CB39E6-3A83-488A-B188-CC65CDCCF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7FD0F6-3ABC-4C86-989A-E1198C90E3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A90661-9297-46A4-8BDB-CA02C2EBD5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EC710-2D83-425F-BE2A-CF87C7244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7B3AF-622E-4339-AE36-392A214D6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14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F92AF-E3C8-473D-9CA1-2568BF55B8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CA4258-0AAA-4DB5-BE99-3DDA3C9391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CC700D-4D60-44A8-87E1-9CF153B9F2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1ACC71-B9FE-427B-AC1D-B4A8FE74A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98FBA2-F4ED-41AB-99D6-A036EC9F3E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0C6789-B69A-45AF-A1E7-FE3A8895F5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304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CA8EF8C-4393-43A4-AA5B-B704B1EEB0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CCC278-F71A-4325-A11E-F739F33E35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C69ADD-66BF-4C55-84DF-90C7614EEB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2BDB7-3DAB-42FE-83A0-93EB32AC6B1E}" type="datetimeFigureOut">
              <a:rPr lang="en-US" smtClean="0"/>
              <a:t>6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6A2B51-D530-4908-9455-0A496F7E40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C442F3-77E0-4234-8FF8-32A551A18E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C74C4-F0D1-421E-8479-1098B74C29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8990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CABD5C-E7F8-4D30-AF77-D1DF38BD1326}"/>
              </a:ext>
            </a:extLst>
          </p:cNvPr>
          <p:cNvSpPr txBox="1"/>
          <p:nvPr/>
        </p:nvSpPr>
        <p:spPr>
          <a:xfrm>
            <a:off x="729342" y="769648"/>
            <a:ext cx="925285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 sequences </a:t>
            </a:r>
            <a:r>
              <a:rPr lang="en-US" sz="1600" b="0" i="0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sed for genetic mappin</a:t>
            </a:r>
            <a:r>
              <a:rPr lang="en-US" sz="160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 and mutation analysis of the </a:t>
            </a:r>
            <a:r>
              <a:rPr lang="en-US" sz="1600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1</a:t>
            </a:r>
            <a:r>
              <a:rPr lang="en-US" sz="160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ene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DBB4A3FC-3A9C-4B93-8C50-F59C3749F6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241681"/>
              </p:ext>
            </p:extLst>
          </p:nvPr>
        </p:nvGraphicFramePr>
        <p:xfrm>
          <a:off x="701750" y="1489584"/>
          <a:ext cx="10940902" cy="2965460"/>
        </p:xfrm>
        <a:graphic>
          <a:graphicData uri="http://schemas.openxmlformats.org/drawingml/2006/table">
            <a:tbl>
              <a:tblPr/>
              <a:tblGrid>
                <a:gridCol w="809825">
                  <a:extLst>
                    <a:ext uri="{9D8B030D-6E8A-4147-A177-3AD203B41FA5}">
                      <a16:colId xmlns:a16="http://schemas.microsoft.com/office/drawing/2014/main" val="3836219008"/>
                    </a:ext>
                  </a:extLst>
                </a:gridCol>
                <a:gridCol w="1437853">
                  <a:extLst>
                    <a:ext uri="{9D8B030D-6E8A-4147-A177-3AD203B41FA5}">
                      <a16:colId xmlns:a16="http://schemas.microsoft.com/office/drawing/2014/main" val="4091063078"/>
                    </a:ext>
                  </a:extLst>
                </a:gridCol>
                <a:gridCol w="3470678">
                  <a:extLst>
                    <a:ext uri="{9D8B030D-6E8A-4147-A177-3AD203B41FA5}">
                      <a16:colId xmlns:a16="http://schemas.microsoft.com/office/drawing/2014/main" val="1978609065"/>
                    </a:ext>
                  </a:extLst>
                </a:gridCol>
                <a:gridCol w="3487206">
                  <a:extLst>
                    <a:ext uri="{9D8B030D-6E8A-4147-A177-3AD203B41FA5}">
                      <a16:colId xmlns:a16="http://schemas.microsoft.com/office/drawing/2014/main" val="2087616940"/>
                    </a:ext>
                  </a:extLst>
                </a:gridCol>
                <a:gridCol w="1735340">
                  <a:extLst>
                    <a:ext uri="{9D8B030D-6E8A-4147-A177-3AD203B41FA5}">
                      <a16:colId xmlns:a16="http://schemas.microsoft.com/office/drawing/2014/main" val="204423477"/>
                    </a:ext>
                  </a:extLst>
                </a:gridCol>
              </a:tblGrid>
              <a:tr h="2449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ke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loymorphism source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ward primer 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ward primer 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2883959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32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GGCATCACCACTTCAATG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GGCATCACCACTTCCGTA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TCACTGCTGCGACACATTCT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44336098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2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3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GGCAAGGTACAAAAGATTCTAC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GGCAAGGTACAAAAGATTTCA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ACGGTGAAACTCCGAATCC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87911647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3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6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TTGAGCCACACTTCTTTC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TTGAGCCACACTTCTCCC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GCATTCGCCCAAGGGGAT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079470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4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64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TTTTTGGTAAAGAGAATTGGTTAAT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TTTTTGGTAAAGAGAATTGGTTCGT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GCATTCGCCCAAGGGGAT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8081882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5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66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AGATGTCCATGACTTCAAAAGC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AGATGTCCATGACTTCAAAGAG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TGCGGCTAAATTGCTTGGG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8239985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6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673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GAATTAATCCCCTAAACCAAGCTC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GAATTAATCCCCTAAACCAAAAT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GGGTATGTGATTCGCTCGC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4334999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7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JHI-Hv50k-2016-127717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CAGTGCCAAGATCCGGAGCCAC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CAGTGCCAAGATCCGGAGATACC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CCCAGGTCGTAGTTCTCTGC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6296959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8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NP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2H: 629779071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GCAAAGATGGGCCTCTGA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GCAAAGATGGGCCTTCGG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ATGGCAAATCATTCGTCTGG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3026192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9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PA 11_10383</a:t>
                      </a: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AGCAGCTACCGTGAGTTT</a:t>
                      </a:r>
                    </a:p>
                  </a:txBody>
                  <a:tcPr marL="5443" marR="5443" marT="5443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AGCAGCTACCGTGAACTC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AGCCATCAGGAAAGTGCGTT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4883299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10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PA 11_10376</a:t>
                      </a: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CGCAAGTGAGCAGTATGACATGATAATTCTACGGTGTACCA </a:t>
                      </a:r>
                    </a:p>
                  </a:txBody>
                  <a:tcPr marL="5443" marR="5443" marT="5443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CAACAGGAACCAGCTATGACATGATAATTCTACGGTGTCACG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222222"/>
                          </a:solidFill>
                          <a:effectLst/>
                          <a:latin typeface="Calibri" panose="020F0502020204030204" pitchFamily="34" charset="0"/>
                        </a:rPr>
                        <a:t>ACTTAATGAACGAGGCTGCC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9761371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Lig1_F1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GCTTCCATTCCTAACCCCTTT 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612627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Lig1_R2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AAGCTCGCCATGTTCTCCT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222222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222222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6298582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Lig1_R3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CAACACGGCTCTACAAG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419024"/>
                  </a:ext>
                </a:extLst>
              </a:tr>
              <a:tr h="181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Lig1_R1 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CCCAACACGGCTCTACAAG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2512582"/>
                  </a:ext>
                </a:extLst>
              </a:tr>
              <a:tr h="1860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Lig1_F2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CGATGGCAACAGTTTGGGA 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5443" marR="5443" marT="544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155383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873837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CABD5C-E7F8-4D30-AF77-D1DF38BD1326}"/>
              </a:ext>
            </a:extLst>
          </p:cNvPr>
          <p:cNvSpPr txBox="1"/>
          <p:nvPr/>
        </p:nvSpPr>
        <p:spPr>
          <a:xfrm>
            <a:off x="957943" y="566448"/>
            <a:ext cx="609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0" i="0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dicted genes in the </a:t>
            </a:r>
            <a:r>
              <a:rPr lang="en-US" sz="1600" b="0" i="1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g1</a:t>
            </a:r>
            <a:r>
              <a:rPr lang="en-US" sz="1600" b="0" i="0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egion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479B854-DC3A-4862-ACED-4ACF47A4B61F}"/>
              </a:ext>
            </a:extLst>
          </p:cNvPr>
          <p:cNvGraphicFramePr>
            <a:graphicFrameLocks noGrp="1"/>
          </p:cNvGraphicFramePr>
          <p:nvPr/>
        </p:nvGraphicFramePr>
        <p:xfrm>
          <a:off x="870858" y="1447801"/>
          <a:ext cx="8643256" cy="1852080"/>
        </p:xfrm>
        <a:graphic>
          <a:graphicData uri="http://schemas.openxmlformats.org/drawingml/2006/table">
            <a:tbl>
              <a:tblPr/>
              <a:tblGrid>
                <a:gridCol w="685799">
                  <a:extLst>
                    <a:ext uri="{9D8B030D-6E8A-4147-A177-3AD203B41FA5}">
                      <a16:colId xmlns:a16="http://schemas.microsoft.com/office/drawing/2014/main" val="1079837090"/>
                    </a:ext>
                  </a:extLst>
                </a:gridCol>
                <a:gridCol w="2841172">
                  <a:extLst>
                    <a:ext uri="{9D8B030D-6E8A-4147-A177-3AD203B41FA5}">
                      <a16:colId xmlns:a16="http://schemas.microsoft.com/office/drawing/2014/main" val="3894070662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840924865"/>
                    </a:ext>
                  </a:extLst>
                </a:gridCol>
                <a:gridCol w="979714">
                  <a:extLst>
                    <a:ext uri="{9D8B030D-6E8A-4147-A177-3AD203B41FA5}">
                      <a16:colId xmlns:a16="http://schemas.microsoft.com/office/drawing/2014/main" val="1692211297"/>
                    </a:ext>
                  </a:extLst>
                </a:gridCol>
                <a:gridCol w="3069771">
                  <a:extLst>
                    <a:ext uri="{9D8B030D-6E8A-4147-A177-3AD203B41FA5}">
                      <a16:colId xmlns:a16="http://schemas.microsoft.com/office/drawing/2014/main" val="3212408457"/>
                    </a:ext>
                  </a:extLst>
                </a:gridCol>
              </a:tblGrid>
              <a:tr h="51753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models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 codon posi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p codon posi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tative coding product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7886152"/>
                  </a:ext>
                </a:extLst>
              </a:tr>
              <a:tr h="3328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VU.MOREX.r3.2HG020262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60958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61321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oxidas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0568528"/>
                  </a:ext>
                </a:extLst>
              </a:tr>
              <a:tr h="3328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VU.MOREX.r3.2HG020264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73741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73954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versal stress family protei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5358889"/>
                  </a:ext>
                </a:extLst>
              </a:tr>
              <a:tr h="3359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VU.MOREX.r3.2HG020265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75494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75856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quamosa promoter-binding-like protei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8662862"/>
                  </a:ext>
                </a:extLst>
              </a:tr>
              <a:tr h="3328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1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ORVU.MOREX.r3.2HG0202670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002818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003449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lasma membrane ATPas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822761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309219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598A6666-D6A3-47EA-A96B-593FCF83FF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5478304"/>
              </p:ext>
            </p:extLst>
          </p:nvPr>
        </p:nvGraphicFramePr>
        <p:xfrm>
          <a:off x="2700196" y="1253327"/>
          <a:ext cx="4596715" cy="4351345"/>
        </p:xfrm>
        <a:graphic>
          <a:graphicData uri="http://schemas.openxmlformats.org/drawingml/2006/table">
            <a:tbl>
              <a:tblPr/>
              <a:tblGrid>
                <a:gridCol w="1802903">
                  <a:extLst>
                    <a:ext uri="{9D8B030D-6E8A-4147-A177-3AD203B41FA5}">
                      <a16:colId xmlns:a16="http://schemas.microsoft.com/office/drawing/2014/main" val="2636687382"/>
                    </a:ext>
                  </a:extLst>
                </a:gridCol>
                <a:gridCol w="2793812">
                  <a:extLst>
                    <a:ext uri="{9D8B030D-6E8A-4147-A177-3AD203B41FA5}">
                      <a16:colId xmlns:a16="http://schemas.microsoft.com/office/drawing/2014/main" val="1821863847"/>
                    </a:ext>
                  </a:extLst>
                </a:gridCol>
              </a:tblGrid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ssue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evelopmental stage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0882613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pidermis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-week seeding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1504490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tiolated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-day seedling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7570651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rminating embryo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erminating embryo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644328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in 1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Day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5724643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rain 2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 Day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1768485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lorescence 1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cm inflorescence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728514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florescence 2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-1.5 cm inflorescence (50-day old main tiller)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5576883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mma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week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135457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dicule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week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747705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lea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 week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11643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chis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 weeks after anthesi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6829105"/>
                  </a:ext>
                </a:extLst>
              </a:tr>
              <a:tr h="40968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1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 parts of the plants reached about 10 cm (17 days after planting)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3997937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oot 2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-week seedling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0244193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nescing leaf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months old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8415946"/>
                  </a:ext>
                </a:extLst>
              </a:tr>
              <a:tr h="40347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oung leaf 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Upper parts of the plants reached about 10 cm (17 days after planting)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830005"/>
                  </a:ext>
                </a:extLst>
              </a:tr>
              <a:tr h="2358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nternode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  <a:r>
                        <a:rPr lang="en-US" sz="11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d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ternode from 42 days old plants</a:t>
                      </a:r>
                    </a:p>
                  </a:txBody>
                  <a:tcPr marL="6207" marR="6207" marT="620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231562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5515DB95-FBE6-4796-B2FD-611D25C9C78D}"/>
              </a:ext>
            </a:extLst>
          </p:cNvPr>
          <p:cNvSpPr txBox="1"/>
          <p:nvPr/>
        </p:nvSpPr>
        <p:spPr>
          <a:xfrm>
            <a:off x="958932" y="420976"/>
            <a:ext cx="956581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Table</a:t>
            </a:r>
            <a:r>
              <a:rPr lang="en-US" dirty="0"/>
              <a:t> </a:t>
            </a:r>
            <a:r>
              <a:rPr lang="en-US" b="1" dirty="0"/>
              <a:t>S3. </a:t>
            </a:r>
            <a:r>
              <a:rPr lang="en-US" dirty="0"/>
              <a:t>Tissue sampling for Barley Reference Transcript (BaRTv1.0) Dataset (</a:t>
            </a:r>
            <a:r>
              <a:rPr lang="en-US" dirty="0" err="1"/>
              <a:t>Jayakodi</a:t>
            </a:r>
            <a:r>
              <a:rPr lang="en-US" dirty="0"/>
              <a:t> et al., 2020). </a:t>
            </a:r>
          </a:p>
        </p:txBody>
      </p:sp>
    </p:spTree>
    <p:extLst>
      <p:ext uri="{BB962C8B-B14F-4D97-AF65-F5344CB8AC3E}">
        <p14:creationId xmlns:p14="http://schemas.microsoft.com/office/powerpoint/2010/main" val="42902718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2CABD5C-E7F8-4D30-AF77-D1DF38BD1326}"/>
              </a:ext>
            </a:extLst>
          </p:cNvPr>
          <p:cNvSpPr txBox="1"/>
          <p:nvPr/>
        </p:nvSpPr>
        <p:spPr>
          <a:xfrm>
            <a:off x="772086" y="612168"/>
            <a:ext cx="609600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4.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0" i="0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er sequences used for </a:t>
            </a:r>
            <a:r>
              <a:rPr lang="en-US" sz="1600" b="0" i="0" u="none" strike="noStrike" baseline="0" dirty="0" err="1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600" b="0" i="0" u="none" strike="noStrike" baseline="0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0F8C46D-3CFE-4677-A518-154587BE828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1083398"/>
              </p:ext>
            </p:extLst>
          </p:nvPr>
        </p:nvGraphicFramePr>
        <p:xfrm>
          <a:off x="1187050" y="1447325"/>
          <a:ext cx="7052381" cy="2016751"/>
        </p:xfrm>
        <a:graphic>
          <a:graphicData uri="http://schemas.openxmlformats.org/drawingml/2006/table">
            <a:tbl>
              <a:tblPr/>
              <a:tblGrid>
                <a:gridCol w="2509879">
                  <a:extLst>
                    <a:ext uri="{9D8B030D-6E8A-4147-A177-3AD203B41FA5}">
                      <a16:colId xmlns:a16="http://schemas.microsoft.com/office/drawing/2014/main" val="2018210889"/>
                    </a:ext>
                  </a:extLst>
                </a:gridCol>
                <a:gridCol w="2448232">
                  <a:extLst>
                    <a:ext uri="{9D8B030D-6E8A-4147-A177-3AD203B41FA5}">
                      <a16:colId xmlns:a16="http://schemas.microsoft.com/office/drawing/2014/main" val="2318698723"/>
                    </a:ext>
                  </a:extLst>
                </a:gridCol>
                <a:gridCol w="2094270">
                  <a:extLst>
                    <a:ext uri="{9D8B030D-6E8A-4147-A177-3AD203B41FA5}">
                      <a16:colId xmlns:a16="http://schemas.microsoft.com/office/drawing/2014/main" val="1556452200"/>
                    </a:ext>
                  </a:extLst>
                </a:gridCol>
              </a:tblGrid>
              <a:tr h="347983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Gene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ward prime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verse Primer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6884049"/>
                  </a:ext>
                </a:extLst>
              </a:tr>
              <a:tr h="3669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g1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AGCAAGTACCAAAGGCAAA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GGTTTCGTCCTGATCTTTG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4496891"/>
                  </a:ext>
                </a:extLst>
              </a:tr>
              <a:tr h="36698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vARF6a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RVU.MOREX.r3.7HG0735280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GAACCCCTGACAACTTTC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TATCTCGAAGCCACATGAGC 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7978703"/>
                  </a:ext>
                </a:extLst>
              </a:tr>
              <a:tr h="34034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vARF6b</a:t>
                      </a:r>
                    </a:p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ORVU.MOREX.r3.5HG0428100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TGTCTCAACTCGGAGCTAT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GCAGTGTCATTTGGGCATAAA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2306919"/>
                  </a:ext>
                </a:extLst>
              </a:tr>
              <a:tr h="35039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vD2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CTTGTCATTCACGCAACAT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ACCGGAAGTACATGAACAC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8616033"/>
                  </a:ext>
                </a:extLst>
              </a:tr>
              <a:tr h="20898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vActin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GACAATGGAACCGGAATG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CCCTTGGCGCATCATCTC</a:t>
                      </a:r>
                    </a:p>
                  </a:txBody>
                  <a:tcPr marL="5443" marR="5443" marT="544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80754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82065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862</TotalTime>
  <Words>368</Words>
  <Application>Microsoft Office PowerPoint</Application>
  <PresentationFormat>Widescreen</PresentationFormat>
  <Paragraphs>159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 Shengming - ARS</dc:creator>
  <cp:lastModifiedBy>Yang, Shengming - ARS</cp:lastModifiedBy>
  <cp:revision>12</cp:revision>
  <dcterms:created xsi:type="dcterms:W3CDTF">2021-11-10T21:34:09Z</dcterms:created>
  <dcterms:modified xsi:type="dcterms:W3CDTF">2022-06-23T00:29:53Z</dcterms:modified>
</cp:coreProperties>
</file>